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2727"/>
    <a:srgbClr val="FFE699"/>
    <a:srgbClr val="BDD7EE"/>
    <a:srgbClr val="D9D9D9"/>
    <a:srgbClr val="636363"/>
    <a:srgbClr val="264478"/>
    <a:srgbClr val="5B9BD5"/>
    <a:srgbClr val="A5A5A5"/>
    <a:srgbClr val="4472C4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225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userId="eb5dffc691174328" providerId="LiveId" clId="{3E1744C1-DA9D-4223-BF2B-31AF50EBB046}"/>
    <pc:docChg chg="delSld">
      <pc:chgData name="" userId="eb5dffc691174328" providerId="LiveId" clId="{3E1744C1-DA9D-4223-BF2B-31AF50EBB046}" dt="2022-04-26T04:30:27.523" v="0" actId="2696"/>
      <pc:docMkLst>
        <pc:docMk/>
      </pc:docMkLst>
      <pc:sldChg chg="del">
        <pc:chgData name="" userId="eb5dffc691174328" providerId="LiveId" clId="{3E1744C1-DA9D-4223-BF2B-31AF50EBB046}" dt="2022-04-26T04:30:27.523" v="0" actId="2696"/>
        <pc:sldMkLst>
          <pc:docMk/>
          <pc:sldMk cId="1934085538" sldId="3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477D5-58E1-429B-A2EC-141678FB378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2152-292C-49B2-B848-3B0FB305AD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0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4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61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45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19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2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66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62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1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9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79D30-AB66-4040-93F4-2E9380BBE1D5}" type="datetimeFigureOut">
              <a:rPr kumimoji="1" lang="ja-JP" altLang="en-US" smtClean="0"/>
              <a:t>2022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0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gif"/><Relationship Id="rId5" Type="http://schemas.microsoft.com/office/2007/relationships/hdphoto" Target="../media/hdphoto1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1" name="グループ化 170">
            <a:extLst>
              <a:ext uri="{FF2B5EF4-FFF2-40B4-BE49-F238E27FC236}">
                <a16:creationId xmlns:a16="http://schemas.microsoft.com/office/drawing/2014/main" id="{768C41F6-5A38-46FF-B899-FC54D354E497}"/>
              </a:ext>
            </a:extLst>
          </p:cNvPr>
          <p:cNvGrpSpPr>
            <a:grpSpLocks noChangeAspect="1"/>
          </p:cNvGrpSpPr>
          <p:nvPr/>
        </p:nvGrpSpPr>
        <p:grpSpPr>
          <a:xfrm>
            <a:off x="3282036" y="6728344"/>
            <a:ext cx="1415655" cy="2002801"/>
            <a:chOff x="-3180388" y="5442898"/>
            <a:chExt cx="2555068" cy="3315646"/>
          </a:xfrm>
        </p:grpSpPr>
        <p:pic>
          <p:nvPicPr>
            <p:cNvPr id="172" name="図 171" descr="グラフ, ヒストグラム&#10;&#10;自動的に生成された説明">
              <a:extLst>
                <a:ext uri="{FF2B5EF4-FFF2-40B4-BE49-F238E27FC236}">
                  <a16:creationId xmlns:a16="http://schemas.microsoft.com/office/drawing/2014/main" id="{3E246801-0D23-48EB-BB33-2F84BE9F5E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9490"/>
            <a:stretch/>
          </p:blipFill>
          <p:spPr>
            <a:xfrm>
              <a:off x="-3178020" y="5442898"/>
              <a:ext cx="2552700" cy="3190114"/>
            </a:xfrm>
            <a:prstGeom prst="rect">
              <a:avLst/>
            </a:prstGeom>
          </p:spPr>
        </p:pic>
        <p:pic>
          <p:nvPicPr>
            <p:cNvPr id="174" name="図 173" descr="グラフ, ヒストグラム&#10;&#10;自動的に生成された説明">
              <a:extLst>
                <a:ext uri="{FF2B5EF4-FFF2-40B4-BE49-F238E27FC236}">
                  <a16:creationId xmlns:a16="http://schemas.microsoft.com/office/drawing/2014/main" id="{5CE0BDB9-9B96-4CDC-AAD2-E7715281D7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675" b="724"/>
            <a:stretch/>
          </p:blipFill>
          <p:spPr>
            <a:xfrm>
              <a:off x="-3180388" y="7030881"/>
              <a:ext cx="2552700" cy="1727663"/>
            </a:xfrm>
            <a:prstGeom prst="rect">
              <a:avLst/>
            </a:prstGeom>
          </p:spPr>
        </p:pic>
      </p:grpSp>
      <p:pic>
        <p:nvPicPr>
          <p:cNvPr id="267" name="Picture 3">
            <a:extLst>
              <a:ext uri="{FF2B5EF4-FFF2-40B4-BE49-F238E27FC236}">
                <a16:creationId xmlns:a16="http://schemas.microsoft.com/office/drawing/2014/main" id="{0CB38655-8B6F-4164-915F-6D9B317462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4468174" y="4712214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8" name="Picture 3">
            <a:extLst>
              <a:ext uri="{FF2B5EF4-FFF2-40B4-BE49-F238E27FC236}">
                <a16:creationId xmlns:a16="http://schemas.microsoft.com/office/drawing/2014/main" id="{6C98E34B-69AA-40F1-AD99-D47B69AA93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1277117" y="5161357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6" name="Picture 3">
            <a:extLst>
              <a:ext uri="{FF2B5EF4-FFF2-40B4-BE49-F238E27FC236}">
                <a16:creationId xmlns:a16="http://schemas.microsoft.com/office/drawing/2014/main" id="{E19D4226-5816-438F-83D4-787510AD2F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4468839" y="4699287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5" name="Picture 3">
            <a:extLst>
              <a:ext uri="{FF2B5EF4-FFF2-40B4-BE49-F238E27FC236}">
                <a16:creationId xmlns:a16="http://schemas.microsoft.com/office/drawing/2014/main" id="{EF8EE1EA-50D9-4881-A7C1-39423608D8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5083534" y="4907559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4" name="Picture 3">
            <a:extLst>
              <a:ext uri="{FF2B5EF4-FFF2-40B4-BE49-F238E27FC236}">
                <a16:creationId xmlns:a16="http://schemas.microsoft.com/office/drawing/2014/main" id="{A12BB3F7-5AB3-45C0-822A-18CC8990DE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2647052">
            <a:off x="912779" y="4844045"/>
            <a:ext cx="225415" cy="331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四角形: 角を丸くする 42">
            <a:extLst>
              <a:ext uri="{FF2B5EF4-FFF2-40B4-BE49-F238E27FC236}">
                <a16:creationId xmlns:a16="http://schemas.microsoft.com/office/drawing/2014/main" id="{F4811CCA-D9F4-4C60-A6EF-63D3A16498D6}"/>
              </a:ext>
            </a:extLst>
          </p:cNvPr>
          <p:cNvSpPr/>
          <p:nvPr/>
        </p:nvSpPr>
        <p:spPr>
          <a:xfrm>
            <a:off x="131228" y="4361320"/>
            <a:ext cx="6594984" cy="1543454"/>
          </a:xfrm>
          <a:prstGeom prst="roundRect">
            <a:avLst>
              <a:gd name="adj" fmla="val 6609"/>
            </a:avLst>
          </a:prstGeom>
          <a:noFill/>
          <a:ln w="381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FE0BE59-84D1-45CC-84B9-9FF0E834931E}"/>
              </a:ext>
            </a:extLst>
          </p:cNvPr>
          <p:cNvSpPr txBox="1"/>
          <p:nvPr/>
        </p:nvSpPr>
        <p:spPr>
          <a:xfrm>
            <a:off x="2870655" y="4216997"/>
            <a:ext cx="1116139" cy="338554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600" b="1" dirty="0"/>
              <a:t>Proteolysis</a:t>
            </a:r>
            <a:endParaRPr lang="ja-JP" altLang="en-US" sz="1600" b="1" dirty="0"/>
          </a:p>
        </p:txBody>
      </p:sp>
      <p:sp>
        <p:nvSpPr>
          <p:cNvPr id="52" name="四角形: 角を丸くする 51">
            <a:extLst>
              <a:ext uri="{FF2B5EF4-FFF2-40B4-BE49-F238E27FC236}">
                <a16:creationId xmlns:a16="http://schemas.microsoft.com/office/drawing/2014/main" id="{78707ECE-2FFF-49FA-8E04-BF8E4D253059}"/>
              </a:ext>
            </a:extLst>
          </p:cNvPr>
          <p:cNvSpPr/>
          <p:nvPr/>
        </p:nvSpPr>
        <p:spPr>
          <a:xfrm>
            <a:off x="131228" y="6510813"/>
            <a:ext cx="6594984" cy="2373526"/>
          </a:xfrm>
          <a:prstGeom prst="roundRect">
            <a:avLst>
              <a:gd name="adj" fmla="val 6609"/>
            </a:avLst>
          </a:prstGeom>
          <a:noFill/>
          <a:ln w="381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189411F4-7AD7-44EE-A625-3932769DF574}"/>
              </a:ext>
            </a:extLst>
          </p:cNvPr>
          <p:cNvSpPr txBox="1"/>
          <p:nvPr/>
        </p:nvSpPr>
        <p:spPr>
          <a:xfrm>
            <a:off x="4255644" y="6700777"/>
            <a:ext cx="1209370" cy="27699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b="1" u="sng" dirty="0">
                <a:solidFill>
                  <a:schemeClr val="tx1"/>
                </a:solidFill>
              </a:rPr>
              <a:t>LC-SRM analysis</a:t>
            </a:r>
            <a:endParaRPr kumimoji="1" lang="ja-JP" altLang="en-US" sz="1200" b="1" u="sng" dirty="0">
              <a:solidFill>
                <a:schemeClr val="tx1"/>
              </a:solidFill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1CC8F02C-D570-47F9-91A7-5AE6B6F52262}"/>
              </a:ext>
            </a:extLst>
          </p:cNvPr>
          <p:cNvSpPr txBox="1"/>
          <p:nvPr/>
        </p:nvSpPr>
        <p:spPr>
          <a:xfrm>
            <a:off x="5471137" y="6973440"/>
            <a:ext cx="1196161" cy="17851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solidFill>
                  <a:srgbClr val="0070C0"/>
                </a:solidFill>
              </a:rPr>
              <a:t>LC</a:t>
            </a:r>
          </a:p>
          <a:p>
            <a:r>
              <a:rPr lang="en-US" altLang="ja-JP" sz="1000" dirty="0" err="1"/>
              <a:t>UltiMate</a:t>
            </a:r>
            <a:r>
              <a:rPr lang="en-US" altLang="ja-JP" sz="1000" dirty="0"/>
              <a:t> 3000  </a:t>
            </a:r>
          </a:p>
          <a:p>
            <a:r>
              <a:rPr lang="en-US" altLang="ja-JP" sz="1000" dirty="0"/>
              <a:t> (Thermo Scientific)</a:t>
            </a:r>
          </a:p>
          <a:p>
            <a:endParaRPr lang="en-US" altLang="ja-JP" sz="1000" dirty="0"/>
          </a:p>
          <a:p>
            <a:r>
              <a:rPr lang="en-US" altLang="ja-JP" sz="1000" b="1" dirty="0">
                <a:solidFill>
                  <a:srgbClr val="0070C0"/>
                </a:solidFill>
              </a:rPr>
              <a:t>MS/MS</a:t>
            </a:r>
          </a:p>
          <a:p>
            <a:r>
              <a:rPr lang="en-US" altLang="ja-JP" sz="1000" dirty="0"/>
              <a:t>TSQ Vantage </a:t>
            </a:r>
          </a:p>
          <a:p>
            <a:r>
              <a:rPr lang="en-US" altLang="ja-JP" sz="1000" dirty="0"/>
              <a:t> (Thermo Scientific)</a:t>
            </a:r>
          </a:p>
          <a:p>
            <a:endParaRPr lang="en-US" altLang="ja-JP" sz="1000" b="1" dirty="0">
              <a:solidFill>
                <a:srgbClr val="0070C0"/>
              </a:solidFill>
            </a:endParaRPr>
          </a:p>
          <a:p>
            <a:r>
              <a:rPr lang="en-US" altLang="ja-JP" sz="1000" b="1" dirty="0">
                <a:solidFill>
                  <a:srgbClr val="0070C0"/>
                </a:solidFill>
              </a:rPr>
              <a:t>Software</a:t>
            </a:r>
          </a:p>
          <a:p>
            <a:r>
              <a:rPr lang="en-US" altLang="ja-JP" sz="1000" dirty="0"/>
              <a:t>Skyline </a:t>
            </a:r>
          </a:p>
          <a:p>
            <a:r>
              <a:rPr lang="en-US" altLang="ja-JP" sz="1000" dirty="0"/>
              <a:t> (</a:t>
            </a:r>
            <a:r>
              <a:rPr lang="en-US" altLang="ja-JP" sz="1000" dirty="0" err="1"/>
              <a:t>MacCoss</a:t>
            </a:r>
            <a:r>
              <a:rPr lang="en-US" altLang="ja-JP" sz="1000" dirty="0"/>
              <a:t> Lab)</a:t>
            </a: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E190FA6C-176C-49F9-9B28-6DE87A5428A8}"/>
              </a:ext>
            </a:extLst>
          </p:cNvPr>
          <p:cNvSpPr txBox="1"/>
          <p:nvPr/>
        </p:nvSpPr>
        <p:spPr>
          <a:xfrm>
            <a:off x="2569760" y="4725262"/>
            <a:ext cx="1835759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TCEP (10 mM, 37</a:t>
            </a:r>
            <a:r>
              <a:rPr lang="ja-JP" altLang="en-US" sz="1000" dirty="0"/>
              <a:t>℃</a:t>
            </a:r>
            <a:r>
              <a:rPr lang="en-US" altLang="ja-JP" sz="1000" dirty="0"/>
              <a:t>, 30 min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IAA (20 mM, 37</a:t>
            </a:r>
            <a:r>
              <a:rPr lang="ja-JP" altLang="en-US" sz="1000" dirty="0"/>
              <a:t>℃</a:t>
            </a:r>
            <a:r>
              <a:rPr lang="en-US" altLang="ja-JP" sz="1000" dirty="0"/>
              <a:t>, 30 min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Lys-C/Trypsin digestion</a:t>
            </a:r>
            <a:endParaRPr lang="ja-JP" altLang="en-US" sz="1000" dirty="0"/>
          </a:p>
        </p:txBody>
      </p:sp>
      <p:sp>
        <p:nvSpPr>
          <p:cNvPr id="149" name="二等辺三角形 148">
            <a:extLst>
              <a:ext uri="{FF2B5EF4-FFF2-40B4-BE49-F238E27FC236}">
                <a16:creationId xmlns:a16="http://schemas.microsoft.com/office/drawing/2014/main" id="{390E7728-7CCE-4C1C-8815-7A08923A1539}"/>
              </a:ext>
            </a:extLst>
          </p:cNvPr>
          <p:cNvSpPr/>
          <p:nvPr/>
        </p:nvSpPr>
        <p:spPr>
          <a:xfrm rot="10800000" flipH="1">
            <a:off x="1031228" y="3982039"/>
            <a:ext cx="1440000" cy="216000"/>
          </a:xfrm>
          <a:prstGeom prst="triangl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 sz="2400"/>
          </a:p>
        </p:txBody>
      </p: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FA5C7164-3DB3-4390-B1D8-6754AEBC20D6}"/>
              </a:ext>
            </a:extLst>
          </p:cNvPr>
          <p:cNvGrpSpPr>
            <a:grpSpLocks noChangeAspect="1"/>
          </p:cNvGrpSpPr>
          <p:nvPr/>
        </p:nvGrpSpPr>
        <p:grpSpPr>
          <a:xfrm>
            <a:off x="2351615" y="7333745"/>
            <a:ext cx="162030" cy="396000"/>
            <a:chOff x="8955526" y="1089462"/>
            <a:chExt cx="586239" cy="1432768"/>
          </a:xfrm>
        </p:grpSpPr>
        <p:sp>
          <p:nvSpPr>
            <p:cNvPr id="56" name="フリーフォーム: 図形 55">
              <a:extLst>
                <a:ext uri="{FF2B5EF4-FFF2-40B4-BE49-F238E27FC236}">
                  <a16:creationId xmlns:a16="http://schemas.microsoft.com/office/drawing/2014/main" id="{08C329CB-6376-437F-B284-9E8C4766B344}"/>
                </a:ext>
              </a:extLst>
            </p:cNvPr>
            <p:cNvSpPr/>
            <p:nvPr/>
          </p:nvSpPr>
          <p:spPr>
            <a:xfrm>
              <a:off x="8955526" y="1253542"/>
              <a:ext cx="586239" cy="1268688"/>
            </a:xfrm>
            <a:custGeom>
              <a:avLst/>
              <a:gdLst>
                <a:gd name="connsiteX0" fmla="*/ 113708 w 947565"/>
                <a:gd name="connsiteY0" fmla="*/ 1430823 h 1440298"/>
                <a:gd name="connsiteX1" fmla="*/ 848071 w 947565"/>
                <a:gd name="connsiteY1" fmla="*/ 1440298 h 1440298"/>
                <a:gd name="connsiteX2" fmla="*/ 947565 w 947565"/>
                <a:gd name="connsiteY2" fmla="*/ 289007 h 1440298"/>
                <a:gd name="connsiteX3" fmla="*/ 947565 w 947565"/>
                <a:gd name="connsiteY3" fmla="*/ 289007 h 1440298"/>
                <a:gd name="connsiteX4" fmla="*/ 909663 w 947565"/>
                <a:gd name="connsiteY4" fmla="*/ 274794 h 1440298"/>
                <a:gd name="connsiteX5" fmla="*/ 881236 w 947565"/>
                <a:gd name="connsiteY5" fmla="*/ 265318 h 1440298"/>
                <a:gd name="connsiteX6" fmla="*/ 852809 w 947565"/>
                <a:gd name="connsiteY6" fmla="*/ 246367 h 1440298"/>
                <a:gd name="connsiteX7" fmla="*/ 838595 w 947565"/>
                <a:gd name="connsiteY7" fmla="*/ 236891 h 1440298"/>
                <a:gd name="connsiteX8" fmla="*/ 810168 w 947565"/>
                <a:gd name="connsiteY8" fmla="*/ 203726 h 1440298"/>
                <a:gd name="connsiteX9" fmla="*/ 800693 w 947565"/>
                <a:gd name="connsiteY9" fmla="*/ 189513 h 1440298"/>
                <a:gd name="connsiteX10" fmla="*/ 786479 w 947565"/>
                <a:gd name="connsiteY10" fmla="*/ 180037 h 1440298"/>
                <a:gd name="connsiteX11" fmla="*/ 781741 w 947565"/>
                <a:gd name="connsiteY11" fmla="*/ 165824 h 1440298"/>
                <a:gd name="connsiteX12" fmla="*/ 753314 w 947565"/>
                <a:gd name="connsiteY12" fmla="*/ 123183 h 1440298"/>
                <a:gd name="connsiteX13" fmla="*/ 743839 w 947565"/>
                <a:gd name="connsiteY13" fmla="*/ 108970 h 1440298"/>
                <a:gd name="connsiteX14" fmla="*/ 715412 w 947565"/>
                <a:gd name="connsiteY14" fmla="*/ 61591 h 1440298"/>
                <a:gd name="connsiteX15" fmla="*/ 705936 w 947565"/>
                <a:gd name="connsiteY15" fmla="*/ 47378 h 1440298"/>
                <a:gd name="connsiteX16" fmla="*/ 701198 w 947565"/>
                <a:gd name="connsiteY16" fmla="*/ 33165 h 1440298"/>
                <a:gd name="connsiteX17" fmla="*/ 691723 w 947565"/>
                <a:gd name="connsiteY17" fmla="*/ 18951 h 1440298"/>
                <a:gd name="connsiteX18" fmla="*/ 686985 w 947565"/>
                <a:gd name="connsiteY18" fmla="*/ 9475 h 1440298"/>
                <a:gd name="connsiteX19" fmla="*/ 246367 w 947565"/>
                <a:gd name="connsiteY19" fmla="*/ 0 h 1440298"/>
                <a:gd name="connsiteX20" fmla="*/ 246367 w 947565"/>
                <a:gd name="connsiteY20" fmla="*/ 0 h 1440298"/>
                <a:gd name="connsiteX21" fmla="*/ 232154 w 947565"/>
                <a:gd name="connsiteY21" fmla="*/ 37902 h 1440298"/>
                <a:gd name="connsiteX22" fmla="*/ 217940 w 947565"/>
                <a:gd name="connsiteY22" fmla="*/ 52116 h 1440298"/>
                <a:gd name="connsiteX23" fmla="*/ 198989 w 947565"/>
                <a:gd name="connsiteY23" fmla="*/ 80543 h 1440298"/>
                <a:gd name="connsiteX24" fmla="*/ 189513 w 947565"/>
                <a:gd name="connsiteY24" fmla="*/ 94756 h 1440298"/>
                <a:gd name="connsiteX25" fmla="*/ 180038 w 947565"/>
                <a:gd name="connsiteY25" fmla="*/ 108970 h 1440298"/>
                <a:gd name="connsiteX26" fmla="*/ 165824 w 947565"/>
                <a:gd name="connsiteY26" fmla="*/ 137397 h 1440298"/>
                <a:gd name="connsiteX27" fmla="*/ 146873 w 947565"/>
                <a:gd name="connsiteY27" fmla="*/ 165824 h 1440298"/>
                <a:gd name="connsiteX28" fmla="*/ 132659 w 947565"/>
                <a:gd name="connsiteY28" fmla="*/ 198988 h 1440298"/>
                <a:gd name="connsiteX29" fmla="*/ 127922 w 947565"/>
                <a:gd name="connsiteY29" fmla="*/ 213202 h 1440298"/>
                <a:gd name="connsiteX30" fmla="*/ 94757 w 947565"/>
                <a:gd name="connsiteY30" fmla="*/ 241629 h 1440298"/>
                <a:gd name="connsiteX31" fmla="*/ 80543 w 947565"/>
                <a:gd name="connsiteY31" fmla="*/ 246367 h 1440298"/>
                <a:gd name="connsiteX32" fmla="*/ 66330 w 947565"/>
                <a:gd name="connsiteY32" fmla="*/ 255842 h 1440298"/>
                <a:gd name="connsiteX33" fmla="*/ 33165 w 947565"/>
                <a:gd name="connsiteY33" fmla="*/ 265318 h 1440298"/>
                <a:gd name="connsiteX34" fmla="*/ 0 w 947565"/>
                <a:gd name="connsiteY34" fmla="*/ 270056 h 1440298"/>
                <a:gd name="connsiteX35" fmla="*/ 113708 w 947565"/>
                <a:gd name="connsiteY35" fmla="*/ 1430823 h 14402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947565" h="1440298">
                  <a:moveTo>
                    <a:pt x="113708" y="1430823"/>
                  </a:moveTo>
                  <a:lnTo>
                    <a:pt x="848071" y="1440298"/>
                  </a:lnTo>
                  <a:lnTo>
                    <a:pt x="947565" y="289007"/>
                  </a:lnTo>
                  <a:lnTo>
                    <a:pt x="947565" y="289007"/>
                  </a:lnTo>
                  <a:lnTo>
                    <a:pt x="909663" y="274794"/>
                  </a:lnTo>
                  <a:cubicBezTo>
                    <a:pt x="900257" y="271435"/>
                    <a:pt x="889547" y="270858"/>
                    <a:pt x="881236" y="265318"/>
                  </a:cubicBezTo>
                  <a:lnTo>
                    <a:pt x="852809" y="246367"/>
                  </a:lnTo>
                  <a:cubicBezTo>
                    <a:pt x="848071" y="243208"/>
                    <a:pt x="842622" y="240918"/>
                    <a:pt x="838595" y="236891"/>
                  </a:cubicBezTo>
                  <a:cubicBezTo>
                    <a:pt x="821377" y="219673"/>
                    <a:pt x="825362" y="224998"/>
                    <a:pt x="810168" y="203726"/>
                  </a:cubicBezTo>
                  <a:cubicBezTo>
                    <a:pt x="806859" y="199093"/>
                    <a:pt x="804719" y="193539"/>
                    <a:pt x="800693" y="189513"/>
                  </a:cubicBezTo>
                  <a:cubicBezTo>
                    <a:pt x="796666" y="185486"/>
                    <a:pt x="791217" y="183196"/>
                    <a:pt x="786479" y="180037"/>
                  </a:cubicBezTo>
                  <a:cubicBezTo>
                    <a:pt x="784900" y="175299"/>
                    <a:pt x="784166" y="170190"/>
                    <a:pt x="781741" y="165824"/>
                  </a:cubicBezTo>
                  <a:cubicBezTo>
                    <a:pt x="781738" y="165819"/>
                    <a:pt x="758053" y="130292"/>
                    <a:pt x="753314" y="123183"/>
                  </a:cubicBezTo>
                  <a:cubicBezTo>
                    <a:pt x="750156" y="118445"/>
                    <a:pt x="746385" y="114063"/>
                    <a:pt x="743839" y="108970"/>
                  </a:cubicBezTo>
                  <a:cubicBezTo>
                    <a:pt x="729271" y="79835"/>
                    <a:pt x="738279" y="95891"/>
                    <a:pt x="715412" y="61591"/>
                  </a:cubicBezTo>
                  <a:cubicBezTo>
                    <a:pt x="712253" y="56853"/>
                    <a:pt x="707737" y="52780"/>
                    <a:pt x="705936" y="47378"/>
                  </a:cubicBezTo>
                  <a:cubicBezTo>
                    <a:pt x="704357" y="42640"/>
                    <a:pt x="703431" y="37632"/>
                    <a:pt x="701198" y="33165"/>
                  </a:cubicBezTo>
                  <a:cubicBezTo>
                    <a:pt x="698652" y="28072"/>
                    <a:pt x="694652" y="23834"/>
                    <a:pt x="691723" y="18951"/>
                  </a:cubicBezTo>
                  <a:cubicBezTo>
                    <a:pt x="689906" y="15923"/>
                    <a:pt x="688564" y="12634"/>
                    <a:pt x="686985" y="9475"/>
                  </a:cubicBezTo>
                  <a:lnTo>
                    <a:pt x="246367" y="0"/>
                  </a:lnTo>
                  <a:lnTo>
                    <a:pt x="246367" y="0"/>
                  </a:lnTo>
                  <a:cubicBezTo>
                    <a:pt x="241629" y="12634"/>
                    <a:pt x="238615" y="26056"/>
                    <a:pt x="232154" y="37902"/>
                  </a:cubicBezTo>
                  <a:cubicBezTo>
                    <a:pt x="228945" y="43784"/>
                    <a:pt x="222054" y="46827"/>
                    <a:pt x="217940" y="52116"/>
                  </a:cubicBezTo>
                  <a:cubicBezTo>
                    <a:pt x="210948" y="61105"/>
                    <a:pt x="205306" y="71067"/>
                    <a:pt x="198989" y="80543"/>
                  </a:cubicBezTo>
                  <a:lnTo>
                    <a:pt x="189513" y="94756"/>
                  </a:lnTo>
                  <a:cubicBezTo>
                    <a:pt x="186354" y="99494"/>
                    <a:pt x="181839" y="103568"/>
                    <a:pt x="180038" y="108970"/>
                  </a:cubicBezTo>
                  <a:cubicBezTo>
                    <a:pt x="168129" y="144694"/>
                    <a:pt x="184193" y="100660"/>
                    <a:pt x="165824" y="137397"/>
                  </a:cubicBezTo>
                  <a:cubicBezTo>
                    <a:pt x="152110" y="164824"/>
                    <a:pt x="173817" y="138878"/>
                    <a:pt x="146873" y="165824"/>
                  </a:cubicBezTo>
                  <a:cubicBezTo>
                    <a:pt x="137010" y="205272"/>
                    <a:pt x="149021" y="166263"/>
                    <a:pt x="132659" y="198988"/>
                  </a:cubicBezTo>
                  <a:cubicBezTo>
                    <a:pt x="130426" y="203455"/>
                    <a:pt x="130692" y="209047"/>
                    <a:pt x="127922" y="213202"/>
                  </a:cubicBezTo>
                  <a:cubicBezTo>
                    <a:pt x="122754" y="220954"/>
                    <a:pt x="101827" y="237589"/>
                    <a:pt x="94757" y="241629"/>
                  </a:cubicBezTo>
                  <a:cubicBezTo>
                    <a:pt x="90421" y="244107"/>
                    <a:pt x="85010" y="244134"/>
                    <a:pt x="80543" y="246367"/>
                  </a:cubicBezTo>
                  <a:cubicBezTo>
                    <a:pt x="75450" y="248913"/>
                    <a:pt x="71423" y="253296"/>
                    <a:pt x="66330" y="255842"/>
                  </a:cubicBezTo>
                  <a:cubicBezTo>
                    <a:pt x="58757" y="259629"/>
                    <a:pt x="40249" y="263294"/>
                    <a:pt x="33165" y="265318"/>
                  </a:cubicBezTo>
                  <a:cubicBezTo>
                    <a:pt x="9591" y="272054"/>
                    <a:pt x="28206" y="270056"/>
                    <a:pt x="0" y="270056"/>
                  </a:cubicBezTo>
                  <a:lnTo>
                    <a:pt x="113708" y="1430823"/>
                  </a:ln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grpSp>
          <p:nvGrpSpPr>
            <p:cNvPr id="57" name="グループ化 56">
              <a:extLst>
                <a:ext uri="{FF2B5EF4-FFF2-40B4-BE49-F238E27FC236}">
                  <a16:creationId xmlns:a16="http://schemas.microsoft.com/office/drawing/2014/main" id="{4822647A-8541-4009-BB18-8397D970457D}"/>
                </a:ext>
              </a:extLst>
            </p:cNvPr>
            <p:cNvGrpSpPr/>
            <p:nvPr/>
          </p:nvGrpSpPr>
          <p:grpSpPr>
            <a:xfrm>
              <a:off x="8994080" y="1089462"/>
              <a:ext cx="492093" cy="329624"/>
              <a:chOff x="8994081" y="1089462"/>
              <a:chExt cx="492093" cy="329624"/>
            </a:xfrm>
          </p:grpSpPr>
          <p:sp>
            <p:nvSpPr>
              <p:cNvPr id="58" name="楕円 57">
                <a:extLst>
                  <a:ext uri="{FF2B5EF4-FFF2-40B4-BE49-F238E27FC236}">
                    <a16:creationId xmlns:a16="http://schemas.microsoft.com/office/drawing/2014/main" id="{ADEB2E84-EA6F-40BC-9DC6-B1CD99DEC30F}"/>
                  </a:ext>
                </a:extLst>
              </p:cNvPr>
              <p:cNvSpPr/>
              <p:nvPr/>
            </p:nvSpPr>
            <p:spPr>
              <a:xfrm>
                <a:off x="8994081" y="1156705"/>
                <a:ext cx="492093" cy="262381"/>
              </a:xfrm>
              <a:prstGeom prst="ellipse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59" name="楕円 58">
                <a:extLst>
                  <a:ext uri="{FF2B5EF4-FFF2-40B4-BE49-F238E27FC236}">
                    <a16:creationId xmlns:a16="http://schemas.microsoft.com/office/drawing/2014/main" id="{CDAEAF2D-454B-484F-BC8E-EE6572C858D6}"/>
                  </a:ext>
                </a:extLst>
              </p:cNvPr>
              <p:cNvSpPr/>
              <p:nvPr/>
            </p:nvSpPr>
            <p:spPr>
              <a:xfrm>
                <a:off x="8994081" y="1089462"/>
                <a:ext cx="492093" cy="262381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60" name="楕円 59">
                <a:extLst>
                  <a:ext uri="{FF2B5EF4-FFF2-40B4-BE49-F238E27FC236}">
                    <a16:creationId xmlns:a16="http://schemas.microsoft.com/office/drawing/2014/main" id="{5EDA5B5A-4B1E-44F4-A7CB-507CE439044C}"/>
                  </a:ext>
                </a:extLst>
              </p:cNvPr>
              <p:cNvSpPr/>
              <p:nvPr/>
            </p:nvSpPr>
            <p:spPr>
              <a:xfrm>
                <a:off x="9074629" y="1136318"/>
                <a:ext cx="330996" cy="156434"/>
              </a:xfrm>
              <a:prstGeom prst="ellipse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id="{AA96DE08-F3B6-436F-A349-D098E1E4576C}"/>
                  </a:ext>
                </a:extLst>
              </p:cNvPr>
              <p:cNvCxnSpPr>
                <a:stCxn id="59" idx="6"/>
                <a:endCxn id="58" idx="6"/>
              </p:cNvCxnSpPr>
              <p:nvPr/>
            </p:nvCxnSpPr>
            <p:spPr>
              <a:xfrm>
                <a:off x="9486174" y="1220653"/>
                <a:ext cx="0" cy="672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4DB55820-00BA-4516-AD22-570C384E81A9}"/>
                  </a:ext>
                </a:extLst>
              </p:cNvPr>
              <p:cNvCxnSpPr/>
              <p:nvPr/>
            </p:nvCxnSpPr>
            <p:spPr>
              <a:xfrm>
                <a:off x="8994081" y="1217825"/>
                <a:ext cx="0" cy="10040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51" name="グループ化 250">
            <a:extLst>
              <a:ext uri="{FF2B5EF4-FFF2-40B4-BE49-F238E27FC236}">
                <a16:creationId xmlns:a16="http://schemas.microsoft.com/office/drawing/2014/main" id="{FD308843-90B2-487B-9231-2684AB32A292}"/>
              </a:ext>
            </a:extLst>
          </p:cNvPr>
          <p:cNvGrpSpPr>
            <a:grpSpLocks noChangeAspect="1"/>
          </p:cNvGrpSpPr>
          <p:nvPr/>
        </p:nvGrpSpPr>
        <p:grpSpPr>
          <a:xfrm>
            <a:off x="962124" y="7296135"/>
            <a:ext cx="195325" cy="972000"/>
            <a:chOff x="994943" y="6816948"/>
            <a:chExt cx="177719" cy="884385"/>
          </a:xfrm>
        </p:grpSpPr>
        <p:sp>
          <p:nvSpPr>
            <p:cNvPr id="79" name="円/楕円 48">
              <a:extLst>
                <a:ext uri="{FF2B5EF4-FFF2-40B4-BE49-F238E27FC236}">
                  <a16:creationId xmlns:a16="http://schemas.microsoft.com/office/drawing/2014/main" id="{E512AA06-1CEA-4F06-82BF-902E43B8BB5D}"/>
                </a:ext>
              </a:extLst>
            </p:cNvPr>
            <p:cNvSpPr/>
            <p:nvPr/>
          </p:nvSpPr>
          <p:spPr>
            <a:xfrm>
              <a:off x="1074262" y="7539922"/>
              <a:ext cx="54231" cy="28209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  <p:sp>
          <p:nvSpPr>
            <p:cNvPr id="80" name="円/楕円 48">
              <a:extLst>
                <a:ext uri="{FF2B5EF4-FFF2-40B4-BE49-F238E27FC236}">
                  <a16:creationId xmlns:a16="http://schemas.microsoft.com/office/drawing/2014/main" id="{CEAF9758-CD45-4237-847E-990B0DE56699}"/>
                </a:ext>
              </a:extLst>
            </p:cNvPr>
            <p:cNvSpPr/>
            <p:nvPr/>
          </p:nvSpPr>
          <p:spPr>
            <a:xfrm>
              <a:off x="1072768" y="7523787"/>
              <a:ext cx="57222" cy="28209"/>
            </a:xfrm>
            <a:prstGeom prst="ellipse">
              <a:avLst/>
            </a:prstGeom>
            <a:solidFill>
              <a:srgbClr val="FF9999">
                <a:alpha val="40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  <p:sp>
          <p:nvSpPr>
            <p:cNvPr id="81" name="フリーフォーム 54">
              <a:extLst>
                <a:ext uri="{FF2B5EF4-FFF2-40B4-BE49-F238E27FC236}">
                  <a16:creationId xmlns:a16="http://schemas.microsoft.com/office/drawing/2014/main" id="{5354BD22-AD3A-4707-8D78-E5802D74D99A}"/>
                </a:ext>
              </a:extLst>
            </p:cNvPr>
            <p:cNvSpPr/>
            <p:nvPr/>
          </p:nvSpPr>
          <p:spPr>
            <a:xfrm>
              <a:off x="1027036" y="7102834"/>
              <a:ext cx="128621" cy="465211"/>
            </a:xfrm>
            <a:custGeom>
              <a:avLst/>
              <a:gdLst>
                <a:gd name="connsiteX0" fmla="*/ 1463 w 208459"/>
                <a:gd name="connsiteY0" fmla="*/ 21994 h 753977"/>
                <a:gd name="connsiteX1" fmla="*/ 29949 w 208459"/>
                <a:gd name="connsiteY1" fmla="*/ 301157 h 753977"/>
                <a:gd name="connsiteX2" fmla="*/ 55587 w 208459"/>
                <a:gd name="connsiteY2" fmla="*/ 548985 h 753977"/>
                <a:gd name="connsiteX3" fmla="*/ 69830 w 208459"/>
                <a:gd name="connsiteY3" fmla="*/ 682869 h 753977"/>
                <a:gd name="connsiteX4" fmla="*/ 89770 w 208459"/>
                <a:gd name="connsiteY4" fmla="*/ 731295 h 753977"/>
                <a:gd name="connsiteX5" fmla="*/ 126802 w 208459"/>
                <a:gd name="connsiteY5" fmla="*/ 745538 h 753977"/>
                <a:gd name="connsiteX6" fmla="*/ 163833 w 208459"/>
                <a:gd name="connsiteY6" fmla="*/ 714204 h 753977"/>
                <a:gd name="connsiteX7" fmla="*/ 186622 w 208459"/>
                <a:gd name="connsiteY7" fmla="*/ 343886 h 753977"/>
                <a:gd name="connsiteX8" fmla="*/ 195168 w 208459"/>
                <a:gd name="connsiteY8" fmla="*/ 141636 h 753977"/>
                <a:gd name="connsiteX9" fmla="*/ 200865 w 208459"/>
                <a:gd name="connsiteY9" fmla="*/ 47632 h 753977"/>
                <a:gd name="connsiteX10" fmla="*/ 198016 w 208459"/>
                <a:gd name="connsiteY10" fmla="*/ 24843 h 753977"/>
                <a:gd name="connsiteX11" fmla="*/ 195168 w 208459"/>
                <a:gd name="connsiteY11" fmla="*/ 21994 h 753977"/>
                <a:gd name="connsiteX12" fmla="*/ 206562 w 208459"/>
                <a:gd name="connsiteY12" fmla="*/ 2054 h 753977"/>
                <a:gd name="connsiteX13" fmla="*/ 149590 w 208459"/>
                <a:gd name="connsiteY13" fmla="*/ 30540 h 753977"/>
                <a:gd name="connsiteX14" fmla="*/ 78375 w 208459"/>
                <a:gd name="connsiteY14" fmla="*/ 19146 h 753977"/>
                <a:gd name="connsiteX15" fmla="*/ 1463 w 208459"/>
                <a:gd name="connsiteY15" fmla="*/ 21994 h 7539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</a:cxnLst>
              <a:rect l="l" t="t" r="r" b="b"/>
              <a:pathLst>
                <a:path w="208459" h="753977">
                  <a:moveTo>
                    <a:pt x="1463" y="21994"/>
                  </a:moveTo>
                  <a:cubicBezTo>
                    <a:pt x="-6608" y="68996"/>
                    <a:pt x="20928" y="213325"/>
                    <a:pt x="29949" y="301157"/>
                  </a:cubicBezTo>
                  <a:cubicBezTo>
                    <a:pt x="38970" y="388989"/>
                    <a:pt x="48940" y="485366"/>
                    <a:pt x="55587" y="548985"/>
                  </a:cubicBezTo>
                  <a:cubicBezTo>
                    <a:pt x="62234" y="612604"/>
                    <a:pt x="64133" y="652484"/>
                    <a:pt x="69830" y="682869"/>
                  </a:cubicBezTo>
                  <a:cubicBezTo>
                    <a:pt x="75527" y="713254"/>
                    <a:pt x="80275" y="720850"/>
                    <a:pt x="89770" y="731295"/>
                  </a:cubicBezTo>
                  <a:cubicBezTo>
                    <a:pt x="99265" y="741740"/>
                    <a:pt x="114458" y="748387"/>
                    <a:pt x="126802" y="745538"/>
                  </a:cubicBezTo>
                  <a:cubicBezTo>
                    <a:pt x="139146" y="742690"/>
                    <a:pt x="153863" y="781146"/>
                    <a:pt x="163833" y="714204"/>
                  </a:cubicBezTo>
                  <a:cubicBezTo>
                    <a:pt x="173803" y="647262"/>
                    <a:pt x="181400" y="439314"/>
                    <a:pt x="186622" y="343886"/>
                  </a:cubicBezTo>
                  <a:cubicBezTo>
                    <a:pt x="191844" y="248458"/>
                    <a:pt x="192794" y="191012"/>
                    <a:pt x="195168" y="141636"/>
                  </a:cubicBezTo>
                  <a:cubicBezTo>
                    <a:pt x="197542" y="92260"/>
                    <a:pt x="200390" y="67097"/>
                    <a:pt x="200865" y="47632"/>
                  </a:cubicBezTo>
                  <a:cubicBezTo>
                    <a:pt x="201340" y="28167"/>
                    <a:pt x="198965" y="29116"/>
                    <a:pt x="198016" y="24843"/>
                  </a:cubicBezTo>
                  <a:cubicBezTo>
                    <a:pt x="197067" y="20570"/>
                    <a:pt x="193744" y="25792"/>
                    <a:pt x="195168" y="21994"/>
                  </a:cubicBezTo>
                  <a:cubicBezTo>
                    <a:pt x="196592" y="18196"/>
                    <a:pt x="214158" y="630"/>
                    <a:pt x="206562" y="2054"/>
                  </a:cubicBezTo>
                  <a:cubicBezTo>
                    <a:pt x="198966" y="3478"/>
                    <a:pt x="170954" y="27691"/>
                    <a:pt x="149590" y="30540"/>
                  </a:cubicBezTo>
                  <a:cubicBezTo>
                    <a:pt x="128226" y="33389"/>
                    <a:pt x="102113" y="20570"/>
                    <a:pt x="78375" y="19146"/>
                  </a:cubicBezTo>
                  <a:cubicBezTo>
                    <a:pt x="54637" y="17722"/>
                    <a:pt x="9534" y="-25008"/>
                    <a:pt x="1463" y="21994"/>
                  </a:cubicBezTo>
                  <a:close/>
                </a:path>
              </a:pathLst>
            </a:custGeom>
            <a:solidFill>
              <a:schemeClr val="accent4">
                <a:lumMod val="20000"/>
                <a:lumOff val="80000"/>
                <a:alpha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  <p:sp>
          <p:nvSpPr>
            <p:cNvPr id="82" name="円/楕円 37">
              <a:extLst>
                <a:ext uri="{FF2B5EF4-FFF2-40B4-BE49-F238E27FC236}">
                  <a16:creationId xmlns:a16="http://schemas.microsoft.com/office/drawing/2014/main" id="{5C6ED40B-0443-44D7-80AF-7268AEADFAAE}"/>
                </a:ext>
              </a:extLst>
            </p:cNvPr>
            <p:cNvSpPr/>
            <p:nvPr/>
          </p:nvSpPr>
          <p:spPr>
            <a:xfrm>
              <a:off x="994943" y="6816948"/>
              <a:ext cx="177718" cy="49211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613A0281-E49D-457B-89AA-867695A68682}"/>
                </a:ext>
              </a:extLst>
            </p:cNvPr>
            <p:cNvCxnSpPr/>
            <p:nvPr/>
          </p:nvCxnSpPr>
          <p:spPr>
            <a:xfrm>
              <a:off x="1083802" y="7698556"/>
              <a:ext cx="4443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円/楕円 49">
              <a:extLst>
                <a:ext uri="{FF2B5EF4-FFF2-40B4-BE49-F238E27FC236}">
                  <a16:creationId xmlns:a16="http://schemas.microsoft.com/office/drawing/2014/main" id="{4235E483-F8FC-4AF2-8CFA-FF7C6713D32D}"/>
                </a:ext>
              </a:extLst>
            </p:cNvPr>
            <p:cNvSpPr/>
            <p:nvPr/>
          </p:nvSpPr>
          <p:spPr>
            <a:xfrm>
              <a:off x="1072233" y="7528811"/>
              <a:ext cx="59232" cy="28209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711DE57B-BB12-4101-AAB9-79BA9E20471F}"/>
                </a:ext>
              </a:extLst>
            </p:cNvPr>
            <p:cNvCxnSpPr>
              <a:stCxn id="82" idx="6"/>
            </p:cNvCxnSpPr>
            <p:nvPr/>
          </p:nvCxnSpPr>
          <p:spPr>
            <a:xfrm flipH="1">
              <a:off x="1128232" y="6841554"/>
              <a:ext cx="44430" cy="8597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1895DDCD-DECF-490B-873F-DD033909230C}"/>
                </a:ext>
              </a:extLst>
            </p:cNvPr>
            <p:cNvCxnSpPr>
              <a:stCxn id="82" idx="2"/>
            </p:cNvCxnSpPr>
            <p:nvPr/>
          </p:nvCxnSpPr>
          <p:spPr>
            <a:xfrm>
              <a:off x="994943" y="6841554"/>
              <a:ext cx="88859" cy="85977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円/楕円 50">
              <a:extLst>
                <a:ext uri="{FF2B5EF4-FFF2-40B4-BE49-F238E27FC236}">
                  <a16:creationId xmlns:a16="http://schemas.microsoft.com/office/drawing/2014/main" id="{FB7EC447-1D6F-451E-9849-A66DFD17BB5B}"/>
                </a:ext>
              </a:extLst>
            </p:cNvPr>
            <p:cNvSpPr/>
            <p:nvPr/>
          </p:nvSpPr>
          <p:spPr>
            <a:xfrm>
              <a:off x="1030525" y="7095539"/>
              <a:ext cx="119923" cy="28209"/>
            </a:xfrm>
            <a:prstGeom prst="ellipse">
              <a:avLst/>
            </a:prstGeom>
            <a:solidFill>
              <a:schemeClr val="accent4">
                <a:lumMod val="20000"/>
                <a:lumOff val="80000"/>
                <a:alpha val="4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  <p:sp>
          <p:nvSpPr>
            <p:cNvPr id="91" name="円/楕円 48">
              <a:extLst>
                <a:ext uri="{FF2B5EF4-FFF2-40B4-BE49-F238E27FC236}">
                  <a16:creationId xmlns:a16="http://schemas.microsoft.com/office/drawing/2014/main" id="{0E0BDC69-D120-46A6-9951-B4196CBEAB62}"/>
                </a:ext>
              </a:extLst>
            </p:cNvPr>
            <p:cNvSpPr/>
            <p:nvPr/>
          </p:nvSpPr>
          <p:spPr>
            <a:xfrm>
              <a:off x="1071763" y="7516734"/>
              <a:ext cx="59232" cy="28209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/>
            </a:p>
          </p:txBody>
        </p:sp>
      </p:grpSp>
      <p:grpSp>
        <p:nvGrpSpPr>
          <p:cNvPr id="253" name="グループ化 252">
            <a:extLst>
              <a:ext uri="{FF2B5EF4-FFF2-40B4-BE49-F238E27FC236}">
                <a16:creationId xmlns:a16="http://schemas.microsoft.com/office/drawing/2014/main" id="{DD624E53-BC81-4AC3-9CCD-149BEF2BEDEB}"/>
              </a:ext>
            </a:extLst>
          </p:cNvPr>
          <p:cNvGrpSpPr/>
          <p:nvPr/>
        </p:nvGrpSpPr>
        <p:grpSpPr>
          <a:xfrm>
            <a:off x="1234647" y="7530135"/>
            <a:ext cx="396000" cy="504000"/>
            <a:chOff x="1237994" y="7078137"/>
            <a:chExt cx="370340" cy="402893"/>
          </a:xfrm>
        </p:grpSpPr>
        <p:cxnSp>
          <p:nvCxnSpPr>
            <p:cNvPr id="88" name="直線矢印コネクタ 87">
              <a:extLst>
                <a:ext uri="{FF2B5EF4-FFF2-40B4-BE49-F238E27FC236}">
                  <a16:creationId xmlns:a16="http://schemas.microsoft.com/office/drawing/2014/main" id="{3CBEA5A4-9C86-4B97-BDC2-B50CCCA19864}"/>
                </a:ext>
              </a:extLst>
            </p:cNvPr>
            <p:cNvCxnSpPr/>
            <p:nvPr/>
          </p:nvCxnSpPr>
          <p:spPr>
            <a:xfrm>
              <a:off x="1335253" y="7078137"/>
              <a:ext cx="26829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矢印コネクタ 88">
              <a:extLst>
                <a:ext uri="{FF2B5EF4-FFF2-40B4-BE49-F238E27FC236}">
                  <a16:creationId xmlns:a16="http://schemas.microsoft.com/office/drawing/2014/main" id="{FDF4A8B6-B88E-4B26-85ED-277761A8A9ED}"/>
                </a:ext>
              </a:extLst>
            </p:cNvPr>
            <p:cNvCxnSpPr>
              <a:cxnSpLocks/>
            </p:cNvCxnSpPr>
            <p:nvPr/>
          </p:nvCxnSpPr>
          <p:spPr>
            <a:xfrm>
              <a:off x="1340042" y="7481030"/>
              <a:ext cx="26829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C92BDAFD-BED4-40CE-9E09-F7AB65670B00}"/>
                </a:ext>
              </a:extLst>
            </p:cNvPr>
            <p:cNvCxnSpPr>
              <a:cxnSpLocks/>
            </p:cNvCxnSpPr>
            <p:nvPr/>
          </p:nvCxnSpPr>
          <p:spPr>
            <a:xfrm>
              <a:off x="1237994" y="7264086"/>
              <a:ext cx="102048" cy="21694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3A98D185-6DBD-4DAC-8C92-2C541D15C3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39431" y="7078137"/>
              <a:ext cx="99175" cy="18833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ED43C109-3B69-4417-98C5-802786819D50}"/>
              </a:ext>
            </a:extLst>
          </p:cNvPr>
          <p:cNvSpPr txBox="1"/>
          <p:nvPr/>
        </p:nvSpPr>
        <p:spPr>
          <a:xfrm>
            <a:off x="1637256" y="7408635"/>
            <a:ext cx="7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Fraction 1</a:t>
            </a:r>
            <a:endParaRPr kumimoji="1" lang="ja-JP" altLang="en-US" sz="1000" dirty="0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9EE6F7F3-7C18-4781-B30C-C4B811E0F696}"/>
              </a:ext>
            </a:extLst>
          </p:cNvPr>
          <p:cNvSpPr txBox="1"/>
          <p:nvPr/>
        </p:nvSpPr>
        <p:spPr>
          <a:xfrm>
            <a:off x="1637256" y="7911439"/>
            <a:ext cx="7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Fraction 2</a:t>
            </a:r>
            <a:endParaRPr kumimoji="1" lang="ja-JP" altLang="en-US" sz="1000" dirty="0"/>
          </a:p>
        </p:txBody>
      </p:sp>
      <p:grpSp>
        <p:nvGrpSpPr>
          <p:cNvPr id="152" name="グループ化 151">
            <a:extLst>
              <a:ext uri="{FF2B5EF4-FFF2-40B4-BE49-F238E27FC236}">
                <a16:creationId xmlns:a16="http://schemas.microsoft.com/office/drawing/2014/main" id="{3F362DD3-834D-433D-9AD2-8F0DB3A3BB7F}"/>
              </a:ext>
            </a:extLst>
          </p:cNvPr>
          <p:cNvGrpSpPr>
            <a:grpSpLocks noChangeAspect="1"/>
          </p:cNvGrpSpPr>
          <p:nvPr/>
        </p:nvGrpSpPr>
        <p:grpSpPr>
          <a:xfrm>
            <a:off x="2351614" y="7836549"/>
            <a:ext cx="162030" cy="396000"/>
            <a:chOff x="8955526" y="1089462"/>
            <a:chExt cx="586239" cy="1432768"/>
          </a:xfrm>
        </p:grpSpPr>
        <p:sp>
          <p:nvSpPr>
            <p:cNvPr id="153" name="フリーフォーム: 図形 152">
              <a:extLst>
                <a:ext uri="{FF2B5EF4-FFF2-40B4-BE49-F238E27FC236}">
                  <a16:creationId xmlns:a16="http://schemas.microsoft.com/office/drawing/2014/main" id="{78CC482C-8C30-4F07-B992-DF260AEA4F4A}"/>
                </a:ext>
              </a:extLst>
            </p:cNvPr>
            <p:cNvSpPr/>
            <p:nvPr/>
          </p:nvSpPr>
          <p:spPr>
            <a:xfrm>
              <a:off x="8955526" y="1253542"/>
              <a:ext cx="586239" cy="1268688"/>
            </a:xfrm>
            <a:custGeom>
              <a:avLst/>
              <a:gdLst>
                <a:gd name="connsiteX0" fmla="*/ 113708 w 947565"/>
                <a:gd name="connsiteY0" fmla="*/ 1430823 h 1440298"/>
                <a:gd name="connsiteX1" fmla="*/ 848071 w 947565"/>
                <a:gd name="connsiteY1" fmla="*/ 1440298 h 1440298"/>
                <a:gd name="connsiteX2" fmla="*/ 947565 w 947565"/>
                <a:gd name="connsiteY2" fmla="*/ 289007 h 1440298"/>
                <a:gd name="connsiteX3" fmla="*/ 947565 w 947565"/>
                <a:gd name="connsiteY3" fmla="*/ 289007 h 1440298"/>
                <a:gd name="connsiteX4" fmla="*/ 909663 w 947565"/>
                <a:gd name="connsiteY4" fmla="*/ 274794 h 1440298"/>
                <a:gd name="connsiteX5" fmla="*/ 881236 w 947565"/>
                <a:gd name="connsiteY5" fmla="*/ 265318 h 1440298"/>
                <a:gd name="connsiteX6" fmla="*/ 852809 w 947565"/>
                <a:gd name="connsiteY6" fmla="*/ 246367 h 1440298"/>
                <a:gd name="connsiteX7" fmla="*/ 838595 w 947565"/>
                <a:gd name="connsiteY7" fmla="*/ 236891 h 1440298"/>
                <a:gd name="connsiteX8" fmla="*/ 810168 w 947565"/>
                <a:gd name="connsiteY8" fmla="*/ 203726 h 1440298"/>
                <a:gd name="connsiteX9" fmla="*/ 800693 w 947565"/>
                <a:gd name="connsiteY9" fmla="*/ 189513 h 1440298"/>
                <a:gd name="connsiteX10" fmla="*/ 786479 w 947565"/>
                <a:gd name="connsiteY10" fmla="*/ 180037 h 1440298"/>
                <a:gd name="connsiteX11" fmla="*/ 781741 w 947565"/>
                <a:gd name="connsiteY11" fmla="*/ 165824 h 1440298"/>
                <a:gd name="connsiteX12" fmla="*/ 753314 w 947565"/>
                <a:gd name="connsiteY12" fmla="*/ 123183 h 1440298"/>
                <a:gd name="connsiteX13" fmla="*/ 743839 w 947565"/>
                <a:gd name="connsiteY13" fmla="*/ 108970 h 1440298"/>
                <a:gd name="connsiteX14" fmla="*/ 715412 w 947565"/>
                <a:gd name="connsiteY14" fmla="*/ 61591 h 1440298"/>
                <a:gd name="connsiteX15" fmla="*/ 705936 w 947565"/>
                <a:gd name="connsiteY15" fmla="*/ 47378 h 1440298"/>
                <a:gd name="connsiteX16" fmla="*/ 701198 w 947565"/>
                <a:gd name="connsiteY16" fmla="*/ 33165 h 1440298"/>
                <a:gd name="connsiteX17" fmla="*/ 691723 w 947565"/>
                <a:gd name="connsiteY17" fmla="*/ 18951 h 1440298"/>
                <a:gd name="connsiteX18" fmla="*/ 686985 w 947565"/>
                <a:gd name="connsiteY18" fmla="*/ 9475 h 1440298"/>
                <a:gd name="connsiteX19" fmla="*/ 246367 w 947565"/>
                <a:gd name="connsiteY19" fmla="*/ 0 h 1440298"/>
                <a:gd name="connsiteX20" fmla="*/ 246367 w 947565"/>
                <a:gd name="connsiteY20" fmla="*/ 0 h 1440298"/>
                <a:gd name="connsiteX21" fmla="*/ 232154 w 947565"/>
                <a:gd name="connsiteY21" fmla="*/ 37902 h 1440298"/>
                <a:gd name="connsiteX22" fmla="*/ 217940 w 947565"/>
                <a:gd name="connsiteY22" fmla="*/ 52116 h 1440298"/>
                <a:gd name="connsiteX23" fmla="*/ 198989 w 947565"/>
                <a:gd name="connsiteY23" fmla="*/ 80543 h 1440298"/>
                <a:gd name="connsiteX24" fmla="*/ 189513 w 947565"/>
                <a:gd name="connsiteY24" fmla="*/ 94756 h 1440298"/>
                <a:gd name="connsiteX25" fmla="*/ 180038 w 947565"/>
                <a:gd name="connsiteY25" fmla="*/ 108970 h 1440298"/>
                <a:gd name="connsiteX26" fmla="*/ 165824 w 947565"/>
                <a:gd name="connsiteY26" fmla="*/ 137397 h 1440298"/>
                <a:gd name="connsiteX27" fmla="*/ 146873 w 947565"/>
                <a:gd name="connsiteY27" fmla="*/ 165824 h 1440298"/>
                <a:gd name="connsiteX28" fmla="*/ 132659 w 947565"/>
                <a:gd name="connsiteY28" fmla="*/ 198988 h 1440298"/>
                <a:gd name="connsiteX29" fmla="*/ 127922 w 947565"/>
                <a:gd name="connsiteY29" fmla="*/ 213202 h 1440298"/>
                <a:gd name="connsiteX30" fmla="*/ 94757 w 947565"/>
                <a:gd name="connsiteY30" fmla="*/ 241629 h 1440298"/>
                <a:gd name="connsiteX31" fmla="*/ 80543 w 947565"/>
                <a:gd name="connsiteY31" fmla="*/ 246367 h 1440298"/>
                <a:gd name="connsiteX32" fmla="*/ 66330 w 947565"/>
                <a:gd name="connsiteY32" fmla="*/ 255842 h 1440298"/>
                <a:gd name="connsiteX33" fmla="*/ 33165 w 947565"/>
                <a:gd name="connsiteY33" fmla="*/ 265318 h 1440298"/>
                <a:gd name="connsiteX34" fmla="*/ 0 w 947565"/>
                <a:gd name="connsiteY34" fmla="*/ 270056 h 1440298"/>
                <a:gd name="connsiteX35" fmla="*/ 113708 w 947565"/>
                <a:gd name="connsiteY35" fmla="*/ 1430823 h 14402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947565" h="1440298">
                  <a:moveTo>
                    <a:pt x="113708" y="1430823"/>
                  </a:moveTo>
                  <a:lnTo>
                    <a:pt x="848071" y="1440298"/>
                  </a:lnTo>
                  <a:lnTo>
                    <a:pt x="947565" y="289007"/>
                  </a:lnTo>
                  <a:lnTo>
                    <a:pt x="947565" y="289007"/>
                  </a:lnTo>
                  <a:lnTo>
                    <a:pt x="909663" y="274794"/>
                  </a:lnTo>
                  <a:cubicBezTo>
                    <a:pt x="900257" y="271435"/>
                    <a:pt x="889547" y="270858"/>
                    <a:pt x="881236" y="265318"/>
                  </a:cubicBezTo>
                  <a:lnTo>
                    <a:pt x="852809" y="246367"/>
                  </a:lnTo>
                  <a:cubicBezTo>
                    <a:pt x="848071" y="243208"/>
                    <a:pt x="842622" y="240918"/>
                    <a:pt x="838595" y="236891"/>
                  </a:cubicBezTo>
                  <a:cubicBezTo>
                    <a:pt x="821377" y="219673"/>
                    <a:pt x="825362" y="224998"/>
                    <a:pt x="810168" y="203726"/>
                  </a:cubicBezTo>
                  <a:cubicBezTo>
                    <a:pt x="806859" y="199093"/>
                    <a:pt x="804719" y="193539"/>
                    <a:pt x="800693" y="189513"/>
                  </a:cubicBezTo>
                  <a:cubicBezTo>
                    <a:pt x="796666" y="185486"/>
                    <a:pt x="791217" y="183196"/>
                    <a:pt x="786479" y="180037"/>
                  </a:cubicBezTo>
                  <a:cubicBezTo>
                    <a:pt x="784900" y="175299"/>
                    <a:pt x="784166" y="170190"/>
                    <a:pt x="781741" y="165824"/>
                  </a:cubicBezTo>
                  <a:cubicBezTo>
                    <a:pt x="781738" y="165819"/>
                    <a:pt x="758053" y="130292"/>
                    <a:pt x="753314" y="123183"/>
                  </a:cubicBezTo>
                  <a:cubicBezTo>
                    <a:pt x="750156" y="118445"/>
                    <a:pt x="746385" y="114063"/>
                    <a:pt x="743839" y="108970"/>
                  </a:cubicBezTo>
                  <a:cubicBezTo>
                    <a:pt x="729271" y="79835"/>
                    <a:pt x="738279" y="95891"/>
                    <a:pt x="715412" y="61591"/>
                  </a:cubicBezTo>
                  <a:cubicBezTo>
                    <a:pt x="712253" y="56853"/>
                    <a:pt x="707737" y="52780"/>
                    <a:pt x="705936" y="47378"/>
                  </a:cubicBezTo>
                  <a:cubicBezTo>
                    <a:pt x="704357" y="42640"/>
                    <a:pt x="703431" y="37632"/>
                    <a:pt x="701198" y="33165"/>
                  </a:cubicBezTo>
                  <a:cubicBezTo>
                    <a:pt x="698652" y="28072"/>
                    <a:pt x="694652" y="23834"/>
                    <a:pt x="691723" y="18951"/>
                  </a:cubicBezTo>
                  <a:cubicBezTo>
                    <a:pt x="689906" y="15923"/>
                    <a:pt x="688564" y="12634"/>
                    <a:pt x="686985" y="9475"/>
                  </a:cubicBezTo>
                  <a:lnTo>
                    <a:pt x="246367" y="0"/>
                  </a:lnTo>
                  <a:lnTo>
                    <a:pt x="246367" y="0"/>
                  </a:lnTo>
                  <a:cubicBezTo>
                    <a:pt x="241629" y="12634"/>
                    <a:pt x="238615" y="26056"/>
                    <a:pt x="232154" y="37902"/>
                  </a:cubicBezTo>
                  <a:cubicBezTo>
                    <a:pt x="228945" y="43784"/>
                    <a:pt x="222054" y="46827"/>
                    <a:pt x="217940" y="52116"/>
                  </a:cubicBezTo>
                  <a:cubicBezTo>
                    <a:pt x="210948" y="61105"/>
                    <a:pt x="205306" y="71067"/>
                    <a:pt x="198989" y="80543"/>
                  </a:cubicBezTo>
                  <a:lnTo>
                    <a:pt x="189513" y="94756"/>
                  </a:lnTo>
                  <a:cubicBezTo>
                    <a:pt x="186354" y="99494"/>
                    <a:pt x="181839" y="103568"/>
                    <a:pt x="180038" y="108970"/>
                  </a:cubicBezTo>
                  <a:cubicBezTo>
                    <a:pt x="168129" y="144694"/>
                    <a:pt x="184193" y="100660"/>
                    <a:pt x="165824" y="137397"/>
                  </a:cubicBezTo>
                  <a:cubicBezTo>
                    <a:pt x="152110" y="164824"/>
                    <a:pt x="173817" y="138878"/>
                    <a:pt x="146873" y="165824"/>
                  </a:cubicBezTo>
                  <a:cubicBezTo>
                    <a:pt x="137010" y="205272"/>
                    <a:pt x="149021" y="166263"/>
                    <a:pt x="132659" y="198988"/>
                  </a:cubicBezTo>
                  <a:cubicBezTo>
                    <a:pt x="130426" y="203455"/>
                    <a:pt x="130692" y="209047"/>
                    <a:pt x="127922" y="213202"/>
                  </a:cubicBezTo>
                  <a:cubicBezTo>
                    <a:pt x="122754" y="220954"/>
                    <a:pt x="101827" y="237589"/>
                    <a:pt x="94757" y="241629"/>
                  </a:cubicBezTo>
                  <a:cubicBezTo>
                    <a:pt x="90421" y="244107"/>
                    <a:pt x="85010" y="244134"/>
                    <a:pt x="80543" y="246367"/>
                  </a:cubicBezTo>
                  <a:cubicBezTo>
                    <a:pt x="75450" y="248913"/>
                    <a:pt x="71423" y="253296"/>
                    <a:pt x="66330" y="255842"/>
                  </a:cubicBezTo>
                  <a:cubicBezTo>
                    <a:pt x="58757" y="259629"/>
                    <a:pt x="40249" y="263294"/>
                    <a:pt x="33165" y="265318"/>
                  </a:cubicBezTo>
                  <a:cubicBezTo>
                    <a:pt x="9591" y="272054"/>
                    <a:pt x="28206" y="270056"/>
                    <a:pt x="0" y="270056"/>
                  </a:cubicBezTo>
                  <a:lnTo>
                    <a:pt x="113708" y="1430823"/>
                  </a:lnTo>
                  <a:close/>
                </a:path>
              </a:pathLst>
            </a:cu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grpSp>
          <p:nvGrpSpPr>
            <p:cNvPr id="154" name="グループ化 153">
              <a:extLst>
                <a:ext uri="{FF2B5EF4-FFF2-40B4-BE49-F238E27FC236}">
                  <a16:creationId xmlns:a16="http://schemas.microsoft.com/office/drawing/2014/main" id="{0A232D82-BE42-4DA9-BA53-2F9842452C17}"/>
                </a:ext>
              </a:extLst>
            </p:cNvPr>
            <p:cNvGrpSpPr/>
            <p:nvPr/>
          </p:nvGrpSpPr>
          <p:grpSpPr>
            <a:xfrm>
              <a:off x="8994080" y="1089462"/>
              <a:ext cx="492093" cy="329624"/>
              <a:chOff x="8994081" y="1089462"/>
              <a:chExt cx="492093" cy="329624"/>
            </a:xfrm>
          </p:grpSpPr>
          <p:sp>
            <p:nvSpPr>
              <p:cNvPr id="155" name="楕円 154">
                <a:extLst>
                  <a:ext uri="{FF2B5EF4-FFF2-40B4-BE49-F238E27FC236}">
                    <a16:creationId xmlns:a16="http://schemas.microsoft.com/office/drawing/2014/main" id="{58C6E76B-D01D-4135-BB0C-31926107EC23}"/>
                  </a:ext>
                </a:extLst>
              </p:cNvPr>
              <p:cNvSpPr/>
              <p:nvPr/>
            </p:nvSpPr>
            <p:spPr>
              <a:xfrm>
                <a:off x="8994081" y="1156705"/>
                <a:ext cx="492093" cy="262381"/>
              </a:xfrm>
              <a:prstGeom prst="ellipse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56" name="楕円 155">
                <a:extLst>
                  <a:ext uri="{FF2B5EF4-FFF2-40B4-BE49-F238E27FC236}">
                    <a16:creationId xmlns:a16="http://schemas.microsoft.com/office/drawing/2014/main" id="{1920822E-F243-43F3-B9B5-C44E3E79D460}"/>
                  </a:ext>
                </a:extLst>
              </p:cNvPr>
              <p:cNvSpPr/>
              <p:nvPr/>
            </p:nvSpPr>
            <p:spPr>
              <a:xfrm>
                <a:off x="8994081" y="1089462"/>
                <a:ext cx="492093" cy="262381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57" name="楕円 156">
                <a:extLst>
                  <a:ext uri="{FF2B5EF4-FFF2-40B4-BE49-F238E27FC236}">
                    <a16:creationId xmlns:a16="http://schemas.microsoft.com/office/drawing/2014/main" id="{4604A4F8-BA40-49F4-8C57-C6F300856873}"/>
                  </a:ext>
                </a:extLst>
              </p:cNvPr>
              <p:cNvSpPr/>
              <p:nvPr/>
            </p:nvSpPr>
            <p:spPr>
              <a:xfrm>
                <a:off x="9074629" y="1136318"/>
                <a:ext cx="330996" cy="156434"/>
              </a:xfrm>
              <a:prstGeom prst="ellipse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FD1B3ADB-D862-40DE-9C11-D08C1BD725E3}"/>
                  </a:ext>
                </a:extLst>
              </p:cNvPr>
              <p:cNvCxnSpPr>
                <a:stCxn id="156" idx="6"/>
                <a:endCxn id="155" idx="6"/>
              </p:cNvCxnSpPr>
              <p:nvPr/>
            </p:nvCxnSpPr>
            <p:spPr>
              <a:xfrm>
                <a:off x="9486174" y="1220653"/>
                <a:ext cx="0" cy="672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0C4C2267-8FF0-47E5-9E00-DECA5EB58947}"/>
                  </a:ext>
                </a:extLst>
              </p:cNvPr>
              <p:cNvCxnSpPr/>
              <p:nvPr/>
            </p:nvCxnSpPr>
            <p:spPr>
              <a:xfrm>
                <a:off x="8994081" y="1217825"/>
                <a:ext cx="0" cy="10040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45101D77-4540-487B-985D-10762D4ECD92}"/>
              </a:ext>
            </a:extLst>
          </p:cNvPr>
          <p:cNvSpPr txBox="1"/>
          <p:nvPr/>
        </p:nvSpPr>
        <p:spPr>
          <a:xfrm>
            <a:off x="320763" y="7494154"/>
            <a:ext cx="6607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/>
              <a:t>C18-SCX </a:t>
            </a:r>
          </a:p>
          <a:p>
            <a:pPr algn="ctr"/>
            <a:r>
              <a:rPr lang="en-US" altLang="ja-JP" sz="1000" dirty="0" err="1"/>
              <a:t>StageTip</a:t>
            </a:r>
            <a:r>
              <a:rPr lang="en-US" altLang="ja-JP" sz="1000" dirty="0"/>
              <a:t> </a:t>
            </a:r>
          </a:p>
        </p:txBody>
      </p: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E67B827E-F5E5-4FDC-923D-B4EC9CBBF24F}"/>
              </a:ext>
            </a:extLst>
          </p:cNvPr>
          <p:cNvGrpSpPr/>
          <p:nvPr/>
        </p:nvGrpSpPr>
        <p:grpSpPr>
          <a:xfrm>
            <a:off x="4138370" y="4473019"/>
            <a:ext cx="967104" cy="276999"/>
            <a:chOff x="-4810530" y="4097080"/>
            <a:chExt cx="967104" cy="276999"/>
          </a:xfrm>
          <a:solidFill>
            <a:schemeClr val="bg1">
              <a:lumMod val="85000"/>
            </a:schemeClr>
          </a:solidFill>
        </p:grpSpPr>
        <p:sp>
          <p:nvSpPr>
            <p:cNvPr id="192" name="正方形/長方形 191">
              <a:extLst>
                <a:ext uri="{FF2B5EF4-FFF2-40B4-BE49-F238E27FC236}">
                  <a16:creationId xmlns:a16="http://schemas.microsoft.com/office/drawing/2014/main" id="{90CA4F17-5647-4A78-ACF7-6990AF33E2FA}"/>
                </a:ext>
              </a:extLst>
            </p:cNvPr>
            <p:cNvSpPr/>
            <p:nvPr/>
          </p:nvSpPr>
          <p:spPr>
            <a:xfrm>
              <a:off x="-4810530" y="4145579"/>
              <a:ext cx="900000" cy="180000"/>
            </a:xfrm>
            <a:prstGeom prst="rect">
              <a:avLst/>
            </a:prstGeom>
            <a:grp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kumimoji="1" lang="ja-JP" altLang="en-US"/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AFB3A97D-B0B5-4753-B73E-FA04818A3E97}"/>
                </a:ext>
              </a:extLst>
            </p:cNvPr>
            <p:cNvSpPr txBox="1"/>
            <p:nvPr/>
          </p:nvSpPr>
          <p:spPr>
            <a:xfrm>
              <a:off x="-4189996" y="4097080"/>
              <a:ext cx="346570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ja-JP" sz="1200" b="1" dirty="0"/>
                <a:t>K*</a:t>
              </a:r>
              <a:endParaRPr lang="ja-JP" altLang="en-US" sz="1200" b="1" dirty="0"/>
            </a:p>
          </p:txBody>
        </p:sp>
      </p:grp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id="{D9D3B230-F51F-4EFB-887B-7C8B554DBC68}"/>
              </a:ext>
            </a:extLst>
          </p:cNvPr>
          <p:cNvGrpSpPr/>
          <p:nvPr/>
        </p:nvGrpSpPr>
        <p:grpSpPr>
          <a:xfrm>
            <a:off x="4761611" y="4676519"/>
            <a:ext cx="967104" cy="276999"/>
            <a:chOff x="-3822952" y="4097080"/>
            <a:chExt cx="967104" cy="276999"/>
          </a:xfrm>
        </p:grpSpPr>
        <p:sp>
          <p:nvSpPr>
            <p:cNvPr id="190" name="正方形/長方形 189">
              <a:extLst>
                <a:ext uri="{FF2B5EF4-FFF2-40B4-BE49-F238E27FC236}">
                  <a16:creationId xmlns:a16="http://schemas.microsoft.com/office/drawing/2014/main" id="{357D0D48-4425-4B6A-93E2-B965D352C673}"/>
                </a:ext>
              </a:extLst>
            </p:cNvPr>
            <p:cNvSpPr/>
            <p:nvPr/>
          </p:nvSpPr>
          <p:spPr>
            <a:xfrm>
              <a:off x="-3822952" y="4145579"/>
              <a:ext cx="900000" cy="180000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kumimoji="1" lang="ja-JP" altLang="en-US"/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3E218C52-6A85-435A-885D-AEB7A9F1A071}"/>
                </a:ext>
              </a:extLst>
            </p:cNvPr>
            <p:cNvSpPr txBox="1"/>
            <p:nvPr/>
          </p:nvSpPr>
          <p:spPr>
            <a:xfrm>
              <a:off x="-3202418" y="4097080"/>
              <a:ext cx="346570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ja-JP" sz="1200" b="1" dirty="0"/>
                <a:t>K*</a:t>
              </a:r>
              <a:endParaRPr lang="ja-JP" altLang="en-US" sz="1200" b="1" dirty="0"/>
            </a:p>
          </p:txBody>
        </p:sp>
      </p:grpSp>
      <p:grpSp>
        <p:nvGrpSpPr>
          <p:cNvPr id="187" name="グループ化 186">
            <a:extLst>
              <a:ext uri="{FF2B5EF4-FFF2-40B4-BE49-F238E27FC236}">
                <a16:creationId xmlns:a16="http://schemas.microsoft.com/office/drawing/2014/main" id="{4282B72F-1F64-4096-98DF-24C255A6999D}"/>
              </a:ext>
            </a:extLst>
          </p:cNvPr>
          <p:cNvGrpSpPr/>
          <p:nvPr/>
        </p:nvGrpSpPr>
        <p:grpSpPr>
          <a:xfrm>
            <a:off x="5402743" y="4896028"/>
            <a:ext cx="1188367" cy="276999"/>
            <a:chOff x="-2557282" y="4097080"/>
            <a:chExt cx="1145602" cy="276999"/>
          </a:xfrm>
        </p:grpSpPr>
        <p:sp>
          <p:nvSpPr>
            <p:cNvPr id="188" name="正方形/長方形 187">
              <a:extLst>
                <a:ext uri="{FF2B5EF4-FFF2-40B4-BE49-F238E27FC236}">
                  <a16:creationId xmlns:a16="http://schemas.microsoft.com/office/drawing/2014/main" id="{B7110DD9-BB6D-4841-9545-921965539C87}"/>
                </a:ext>
              </a:extLst>
            </p:cNvPr>
            <p:cNvSpPr/>
            <p:nvPr/>
          </p:nvSpPr>
          <p:spPr>
            <a:xfrm>
              <a:off x="-2557282" y="4145579"/>
              <a:ext cx="1080000" cy="180000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kumimoji="1" lang="ja-JP" altLang="en-US"/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E7821AEA-E0A4-49E8-BD9E-925818674B23}"/>
                </a:ext>
              </a:extLst>
            </p:cNvPr>
            <p:cNvSpPr txBox="1"/>
            <p:nvPr/>
          </p:nvSpPr>
          <p:spPr>
            <a:xfrm>
              <a:off x="-1987479" y="4097080"/>
              <a:ext cx="575799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altLang="ja-JP" sz="1200" b="1" dirty="0"/>
                <a:t>K*/R*</a:t>
              </a:r>
              <a:endParaRPr lang="ja-JP" altLang="en-US" sz="1200" b="1" dirty="0"/>
            </a:p>
          </p:txBody>
        </p:sp>
      </p:grpSp>
      <p:pic>
        <p:nvPicPr>
          <p:cNvPr id="165" name="Picture 4">
            <a:extLst>
              <a:ext uri="{FF2B5EF4-FFF2-40B4-BE49-F238E27FC236}">
                <a16:creationId xmlns:a16="http://schemas.microsoft.com/office/drawing/2014/main" id="{AD321CD0-1739-4DCE-A994-D661BE0FAC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duotone>
              <a:schemeClr val="bg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artisticPaintStrokes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158000">
            <a:off x="3418483" y="1449547"/>
            <a:ext cx="680738" cy="680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クリックすると新しいウィンドウで開きます">
            <a:extLst>
              <a:ext uri="{FF2B5EF4-FFF2-40B4-BE49-F238E27FC236}">
                <a16:creationId xmlns:a16="http://schemas.microsoft.com/office/drawing/2014/main" id="{0E90B34B-431D-4F58-8DE5-EE6FB29F25F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431"/>
          <a:stretch/>
        </p:blipFill>
        <p:spPr bwMode="auto">
          <a:xfrm>
            <a:off x="1563206" y="1390777"/>
            <a:ext cx="360000" cy="6581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9AEDD29-4A84-4D34-8D82-782333D2635F}"/>
              </a:ext>
            </a:extLst>
          </p:cNvPr>
          <p:cNvSpPr txBox="1"/>
          <p:nvPr/>
        </p:nvSpPr>
        <p:spPr>
          <a:xfrm>
            <a:off x="947136" y="1500509"/>
            <a:ext cx="641522" cy="461665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altLang="ja-JP" sz="1200" b="1" dirty="0"/>
              <a:t>Plasma</a:t>
            </a:r>
          </a:p>
          <a:p>
            <a:pPr algn="ctr"/>
            <a:r>
              <a:rPr lang="en-US" altLang="ja-JP" sz="1200" b="1" dirty="0"/>
              <a:t>100 µl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FE0123A-247D-4B10-B052-96F9AB1E40D9}"/>
              </a:ext>
            </a:extLst>
          </p:cNvPr>
          <p:cNvSpPr txBox="1"/>
          <p:nvPr/>
        </p:nvSpPr>
        <p:spPr>
          <a:xfrm>
            <a:off x="1990644" y="2028563"/>
            <a:ext cx="1181734" cy="55399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000" dirty="0"/>
              <a:t>Ultracentrifugation</a:t>
            </a:r>
          </a:p>
          <a:p>
            <a:r>
              <a:rPr lang="en-US" altLang="ja-JP" sz="1000" dirty="0"/>
              <a:t>  + 0.22 µm filter</a:t>
            </a:r>
          </a:p>
          <a:p>
            <a:r>
              <a:rPr lang="en-US" altLang="ja-JP" sz="1000" dirty="0"/>
              <a:t>  + sucrose cushion</a:t>
            </a:r>
            <a:endParaRPr lang="ja-JP" altLang="en-US" sz="10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B75985B-3E84-4543-84F6-38FE7ECC3003}"/>
              </a:ext>
            </a:extLst>
          </p:cNvPr>
          <p:cNvSpPr txBox="1"/>
          <p:nvPr/>
        </p:nvSpPr>
        <p:spPr>
          <a:xfrm>
            <a:off x="1297676" y="2585820"/>
            <a:ext cx="937821" cy="2769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200" b="1" dirty="0"/>
              <a:t>EVs fraction</a:t>
            </a:r>
            <a:endParaRPr lang="ja-JP" altLang="en-US" sz="1200" b="1" dirty="0"/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D4D929C6-388A-4E7C-94D4-CEA7814AC369}"/>
              </a:ext>
            </a:extLst>
          </p:cNvPr>
          <p:cNvGrpSpPr>
            <a:grpSpLocks noChangeAspect="1"/>
          </p:cNvGrpSpPr>
          <p:nvPr/>
        </p:nvGrpSpPr>
        <p:grpSpPr>
          <a:xfrm>
            <a:off x="927997" y="3156087"/>
            <a:ext cx="466455" cy="454944"/>
            <a:chOff x="9413244" y="4963206"/>
            <a:chExt cx="1484727" cy="1448092"/>
          </a:xfrm>
        </p:grpSpPr>
        <p:sp>
          <p:nvSpPr>
            <p:cNvPr id="25" name="楕円 24">
              <a:extLst>
                <a:ext uri="{FF2B5EF4-FFF2-40B4-BE49-F238E27FC236}">
                  <a16:creationId xmlns:a16="http://schemas.microsoft.com/office/drawing/2014/main" id="{8177FC57-9E34-4822-9507-F03DC64EE02F}"/>
                </a:ext>
              </a:extLst>
            </p:cNvPr>
            <p:cNvSpPr/>
            <p:nvPr/>
          </p:nvSpPr>
          <p:spPr>
            <a:xfrm>
              <a:off x="9496223" y="5092210"/>
              <a:ext cx="1401748" cy="1293986"/>
            </a:xfrm>
            <a:prstGeom prst="ellipse">
              <a:avLst/>
            </a:prstGeom>
            <a:noFill/>
            <a:ln w="12065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dirty="0"/>
            </a:p>
          </p:txBody>
        </p:sp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DFEEB1B2-AFAB-45AD-A4D8-9996C5458775}"/>
                </a:ext>
              </a:extLst>
            </p:cNvPr>
            <p:cNvGrpSpPr/>
            <p:nvPr/>
          </p:nvGrpSpPr>
          <p:grpSpPr>
            <a:xfrm>
              <a:off x="10054433" y="4963206"/>
              <a:ext cx="317475" cy="258007"/>
              <a:chOff x="5462221" y="506896"/>
              <a:chExt cx="317475" cy="258007"/>
            </a:xfrm>
          </p:grpSpPr>
          <p:sp>
            <p:nvSpPr>
              <p:cNvPr id="39" name="フリーフォーム: 図形 38">
                <a:extLst>
                  <a:ext uri="{FF2B5EF4-FFF2-40B4-BE49-F238E27FC236}">
                    <a16:creationId xmlns:a16="http://schemas.microsoft.com/office/drawing/2014/main" id="{D190B3D6-5F71-4EB0-8164-562819A6EED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2221" y="506896"/>
                <a:ext cx="143450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40" name="フリーフォーム: 図形 39">
                <a:extLst>
                  <a:ext uri="{FF2B5EF4-FFF2-40B4-BE49-F238E27FC236}">
                    <a16:creationId xmlns:a16="http://schemas.microsoft.com/office/drawing/2014/main" id="{BCEF68CE-D192-4E66-A331-27EBDEFF914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8528" flipH="1">
                <a:off x="5636677" y="516644"/>
                <a:ext cx="143019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</p:grpSp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00C77B58-3634-4A7B-8B89-AB1EE8C56680}"/>
                </a:ext>
              </a:extLst>
            </p:cNvPr>
            <p:cNvGrpSpPr/>
            <p:nvPr/>
          </p:nvGrpSpPr>
          <p:grpSpPr>
            <a:xfrm rot="8217376">
              <a:off x="10467518" y="6103304"/>
              <a:ext cx="317475" cy="258007"/>
              <a:chOff x="5462221" y="506896"/>
              <a:chExt cx="317475" cy="258007"/>
            </a:xfrm>
          </p:grpSpPr>
          <p:sp>
            <p:nvSpPr>
              <p:cNvPr id="37" name="フリーフォーム: 図形 36">
                <a:extLst>
                  <a:ext uri="{FF2B5EF4-FFF2-40B4-BE49-F238E27FC236}">
                    <a16:creationId xmlns:a16="http://schemas.microsoft.com/office/drawing/2014/main" id="{76086A51-09A3-4CF5-980A-76738EE1E73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2221" y="506896"/>
                <a:ext cx="143450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38" name="フリーフォーム: 図形 37">
                <a:extLst>
                  <a:ext uri="{FF2B5EF4-FFF2-40B4-BE49-F238E27FC236}">
                    <a16:creationId xmlns:a16="http://schemas.microsoft.com/office/drawing/2014/main" id="{0111BCCC-B196-4B3F-A4BE-1D2452EA4E7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8528" flipH="1">
                <a:off x="5636677" y="516644"/>
                <a:ext cx="143019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</p:grpSp>
        <p:sp>
          <p:nvSpPr>
            <p:cNvPr id="28" name="フリーフォーム: 図形 27">
              <a:extLst>
                <a:ext uri="{FF2B5EF4-FFF2-40B4-BE49-F238E27FC236}">
                  <a16:creationId xmlns:a16="http://schemas.microsoft.com/office/drawing/2014/main" id="{52ADB644-B587-4997-9AF7-CBEBB3C6EECC}"/>
                </a:ext>
              </a:extLst>
            </p:cNvPr>
            <p:cNvSpPr>
              <a:spLocks noChangeAspect="1"/>
            </p:cNvSpPr>
            <p:nvPr/>
          </p:nvSpPr>
          <p:spPr>
            <a:xfrm rot="1932916">
              <a:off x="10581850" y="5179394"/>
              <a:ext cx="274290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9" name="フリーフォーム: 図形 28">
              <a:extLst>
                <a:ext uri="{FF2B5EF4-FFF2-40B4-BE49-F238E27FC236}">
                  <a16:creationId xmlns:a16="http://schemas.microsoft.com/office/drawing/2014/main" id="{DADEA5E6-873B-46E9-A86D-E7FC1E7BBA75}"/>
                </a:ext>
              </a:extLst>
            </p:cNvPr>
            <p:cNvSpPr>
              <a:spLocks noChangeAspect="1"/>
            </p:cNvSpPr>
            <p:nvPr/>
          </p:nvSpPr>
          <p:spPr>
            <a:xfrm rot="18026397">
              <a:off x="9417628" y="5272985"/>
              <a:ext cx="274290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0" name="フリーフォーム: 図形 29">
              <a:extLst>
                <a:ext uri="{FF2B5EF4-FFF2-40B4-BE49-F238E27FC236}">
                  <a16:creationId xmlns:a16="http://schemas.microsoft.com/office/drawing/2014/main" id="{7EE208AC-94EB-4B23-BCF3-C7B835BDA472}"/>
                </a:ext>
              </a:extLst>
            </p:cNvPr>
            <p:cNvSpPr>
              <a:spLocks noChangeAspect="1"/>
            </p:cNvSpPr>
            <p:nvPr/>
          </p:nvSpPr>
          <p:spPr>
            <a:xfrm rot="13130338">
              <a:off x="9645564" y="6128240"/>
              <a:ext cx="274289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1" name="フリーフォーム: 図形 30">
              <a:extLst>
                <a:ext uri="{FF2B5EF4-FFF2-40B4-BE49-F238E27FC236}">
                  <a16:creationId xmlns:a16="http://schemas.microsoft.com/office/drawing/2014/main" id="{52818DDE-E455-4DAD-B502-032669B238C4}"/>
                </a:ext>
              </a:extLst>
            </p:cNvPr>
            <p:cNvSpPr/>
            <p:nvPr/>
          </p:nvSpPr>
          <p:spPr>
            <a:xfrm>
              <a:off x="9759639" y="5329216"/>
              <a:ext cx="337374" cy="320633"/>
            </a:xfrm>
            <a:custGeom>
              <a:avLst/>
              <a:gdLst>
                <a:gd name="connsiteX0" fmla="*/ 0 w 467139"/>
                <a:gd name="connsiteY0" fmla="*/ 427382 h 427382"/>
                <a:gd name="connsiteX1" fmla="*/ 9939 w 467139"/>
                <a:gd name="connsiteY1" fmla="*/ 377687 h 427382"/>
                <a:gd name="connsiteX2" fmla="*/ 19878 w 467139"/>
                <a:gd name="connsiteY2" fmla="*/ 258417 h 427382"/>
                <a:gd name="connsiteX3" fmla="*/ 29817 w 467139"/>
                <a:gd name="connsiteY3" fmla="*/ 218661 h 427382"/>
                <a:gd name="connsiteX4" fmla="*/ 49696 w 467139"/>
                <a:gd name="connsiteY4" fmla="*/ 198782 h 427382"/>
                <a:gd name="connsiteX5" fmla="*/ 119269 w 467139"/>
                <a:gd name="connsiteY5" fmla="*/ 168965 h 427382"/>
                <a:gd name="connsiteX6" fmla="*/ 168965 w 467139"/>
                <a:gd name="connsiteY6" fmla="*/ 159026 h 427382"/>
                <a:gd name="connsiteX7" fmla="*/ 278296 w 467139"/>
                <a:gd name="connsiteY7" fmla="*/ 198782 h 427382"/>
                <a:gd name="connsiteX8" fmla="*/ 288235 w 467139"/>
                <a:gd name="connsiteY8" fmla="*/ 228600 h 427382"/>
                <a:gd name="connsiteX9" fmla="*/ 278296 w 467139"/>
                <a:gd name="connsiteY9" fmla="*/ 318052 h 427382"/>
                <a:gd name="connsiteX10" fmla="*/ 228600 w 467139"/>
                <a:gd name="connsiteY10" fmla="*/ 327991 h 427382"/>
                <a:gd name="connsiteX11" fmla="*/ 188843 w 467139"/>
                <a:gd name="connsiteY11" fmla="*/ 308113 h 427382"/>
                <a:gd name="connsiteX12" fmla="*/ 168965 w 467139"/>
                <a:gd name="connsiteY12" fmla="*/ 288234 h 427382"/>
                <a:gd name="connsiteX13" fmla="*/ 139148 w 467139"/>
                <a:gd name="connsiteY13" fmla="*/ 268356 h 427382"/>
                <a:gd name="connsiteX14" fmla="*/ 129209 w 467139"/>
                <a:gd name="connsiteY14" fmla="*/ 238539 h 427382"/>
                <a:gd name="connsiteX15" fmla="*/ 168965 w 467139"/>
                <a:gd name="connsiteY15" fmla="*/ 99391 h 427382"/>
                <a:gd name="connsiteX16" fmla="*/ 198783 w 467139"/>
                <a:gd name="connsiteY16" fmla="*/ 79513 h 427382"/>
                <a:gd name="connsiteX17" fmla="*/ 258417 w 467139"/>
                <a:gd name="connsiteY17" fmla="*/ 89452 h 427382"/>
                <a:gd name="connsiteX18" fmla="*/ 218661 w 467139"/>
                <a:gd name="connsiteY18" fmla="*/ 208721 h 427382"/>
                <a:gd name="connsiteX19" fmla="*/ 198783 w 467139"/>
                <a:gd name="connsiteY19" fmla="*/ 178904 h 427382"/>
                <a:gd name="connsiteX20" fmla="*/ 178904 w 467139"/>
                <a:gd name="connsiteY20" fmla="*/ 159026 h 427382"/>
                <a:gd name="connsiteX21" fmla="*/ 228600 w 467139"/>
                <a:gd name="connsiteY21" fmla="*/ 39756 h 427382"/>
                <a:gd name="connsiteX22" fmla="*/ 288235 w 467139"/>
                <a:gd name="connsiteY22" fmla="*/ 29817 h 427382"/>
                <a:gd name="connsiteX23" fmla="*/ 357809 w 467139"/>
                <a:gd name="connsiteY23" fmla="*/ 39756 h 427382"/>
                <a:gd name="connsiteX24" fmla="*/ 417443 w 467139"/>
                <a:gd name="connsiteY24" fmla="*/ 59634 h 427382"/>
                <a:gd name="connsiteX25" fmla="*/ 447261 w 467139"/>
                <a:gd name="connsiteY25" fmla="*/ 49695 h 427382"/>
                <a:gd name="connsiteX26" fmla="*/ 457200 w 467139"/>
                <a:gd name="connsiteY26" fmla="*/ 19878 h 427382"/>
                <a:gd name="connsiteX27" fmla="*/ 467139 w 467139"/>
                <a:gd name="connsiteY27" fmla="*/ 0 h 4273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467139" h="427382">
                  <a:moveTo>
                    <a:pt x="0" y="427382"/>
                  </a:moveTo>
                  <a:cubicBezTo>
                    <a:pt x="3313" y="410817"/>
                    <a:pt x="7965" y="394464"/>
                    <a:pt x="9939" y="377687"/>
                  </a:cubicBezTo>
                  <a:cubicBezTo>
                    <a:pt x="14600" y="338066"/>
                    <a:pt x="14930" y="298003"/>
                    <a:pt x="19878" y="258417"/>
                  </a:cubicBezTo>
                  <a:cubicBezTo>
                    <a:pt x="21572" y="244863"/>
                    <a:pt x="23708" y="230879"/>
                    <a:pt x="29817" y="218661"/>
                  </a:cubicBezTo>
                  <a:cubicBezTo>
                    <a:pt x="34008" y="210279"/>
                    <a:pt x="41899" y="203980"/>
                    <a:pt x="49696" y="198782"/>
                  </a:cubicBezTo>
                  <a:cubicBezTo>
                    <a:pt x="66762" y="187404"/>
                    <a:pt x="98066" y="174266"/>
                    <a:pt x="119269" y="168965"/>
                  </a:cubicBezTo>
                  <a:cubicBezTo>
                    <a:pt x="135658" y="164868"/>
                    <a:pt x="152400" y="162339"/>
                    <a:pt x="168965" y="159026"/>
                  </a:cubicBezTo>
                  <a:cubicBezTo>
                    <a:pt x="228768" y="166501"/>
                    <a:pt x="247302" y="152292"/>
                    <a:pt x="278296" y="198782"/>
                  </a:cubicBezTo>
                  <a:cubicBezTo>
                    <a:pt x="284108" y="207499"/>
                    <a:pt x="284922" y="218661"/>
                    <a:pt x="288235" y="228600"/>
                  </a:cubicBezTo>
                  <a:cubicBezTo>
                    <a:pt x="284922" y="258417"/>
                    <a:pt x="286190" y="289108"/>
                    <a:pt x="278296" y="318052"/>
                  </a:cubicBezTo>
                  <a:cubicBezTo>
                    <a:pt x="269582" y="350001"/>
                    <a:pt x="246541" y="335680"/>
                    <a:pt x="228600" y="327991"/>
                  </a:cubicBezTo>
                  <a:cubicBezTo>
                    <a:pt x="214981" y="322155"/>
                    <a:pt x="202095" y="314739"/>
                    <a:pt x="188843" y="308113"/>
                  </a:cubicBezTo>
                  <a:cubicBezTo>
                    <a:pt x="182217" y="301487"/>
                    <a:pt x="176282" y="294088"/>
                    <a:pt x="168965" y="288234"/>
                  </a:cubicBezTo>
                  <a:cubicBezTo>
                    <a:pt x="159637" y="280772"/>
                    <a:pt x="146610" y="277684"/>
                    <a:pt x="139148" y="268356"/>
                  </a:cubicBezTo>
                  <a:cubicBezTo>
                    <a:pt x="132603" y="260175"/>
                    <a:pt x="132522" y="248478"/>
                    <a:pt x="129209" y="238539"/>
                  </a:cubicBezTo>
                  <a:cubicBezTo>
                    <a:pt x="138043" y="141358"/>
                    <a:pt x="114185" y="145040"/>
                    <a:pt x="168965" y="99391"/>
                  </a:cubicBezTo>
                  <a:cubicBezTo>
                    <a:pt x="178142" y="91744"/>
                    <a:pt x="188844" y="86139"/>
                    <a:pt x="198783" y="79513"/>
                  </a:cubicBezTo>
                  <a:lnTo>
                    <a:pt x="258417" y="89452"/>
                  </a:lnTo>
                  <a:cubicBezTo>
                    <a:pt x="316486" y="252046"/>
                    <a:pt x="272769" y="226759"/>
                    <a:pt x="218661" y="208721"/>
                  </a:cubicBezTo>
                  <a:cubicBezTo>
                    <a:pt x="212035" y="198782"/>
                    <a:pt x="206245" y="188232"/>
                    <a:pt x="198783" y="178904"/>
                  </a:cubicBezTo>
                  <a:cubicBezTo>
                    <a:pt x="192929" y="171587"/>
                    <a:pt x="178904" y="168397"/>
                    <a:pt x="178904" y="159026"/>
                  </a:cubicBezTo>
                  <a:cubicBezTo>
                    <a:pt x="178904" y="109946"/>
                    <a:pt x="178527" y="56447"/>
                    <a:pt x="228600" y="39756"/>
                  </a:cubicBezTo>
                  <a:cubicBezTo>
                    <a:pt x="247718" y="33383"/>
                    <a:pt x="268357" y="33130"/>
                    <a:pt x="288235" y="29817"/>
                  </a:cubicBezTo>
                  <a:cubicBezTo>
                    <a:pt x="311426" y="33130"/>
                    <a:pt x="334982" y="34488"/>
                    <a:pt x="357809" y="39756"/>
                  </a:cubicBezTo>
                  <a:cubicBezTo>
                    <a:pt x="378226" y="44468"/>
                    <a:pt x="417443" y="59634"/>
                    <a:pt x="417443" y="59634"/>
                  </a:cubicBezTo>
                  <a:cubicBezTo>
                    <a:pt x="427382" y="56321"/>
                    <a:pt x="439853" y="57103"/>
                    <a:pt x="447261" y="49695"/>
                  </a:cubicBezTo>
                  <a:cubicBezTo>
                    <a:pt x="454669" y="42287"/>
                    <a:pt x="453309" y="29605"/>
                    <a:pt x="457200" y="19878"/>
                  </a:cubicBezTo>
                  <a:cubicBezTo>
                    <a:pt x="459951" y="13000"/>
                    <a:pt x="463826" y="6626"/>
                    <a:pt x="467139" y="0"/>
                  </a:cubicBezTo>
                </a:path>
              </a:pathLst>
            </a:custGeom>
            <a:noFill/>
            <a:ln w="31750">
              <a:solidFill>
                <a:srgbClr val="CC66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ADF4A183-5024-45C7-A3D9-335398AC0584}"/>
                </a:ext>
              </a:extLst>
            </p:cNvPr>
            <p:cNvGrpSpPr>
              <a:grpSpLocks noChangeAspect="1"/>
            </p:cNvGrpSpPr>
            <p:nvPr/>
          </p:nvGrpSpPr>
          <p:grpSpPr>
            <a:xfrm rot="2259212">
              <a:off x="10233133" y="5410997"/>
              <a:ext cx="373706" cy="188725"/>
              <a:chOff x="4597676" y="556450"/>
              <a:chExt cx="830518" cy="419420"/>
            </a:xfrm>
          </p:grpSpPr>
          <p:sp>
            <p:nvSpPr>
              <p:cNvPr id="35" name="フリーフォーム: 図形 34">
                <a:extLst>
                  <a:ext uri="{FF2B5EF4-FFF2-40B4-BE49-F238E27FC236}">
                    <a16:creationId xmlns:a16="http://schemas.microsoft.com/office/drawing/2014/main" id="{B77B2B27-4D12-4348-9744-FD6316F73B4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631635" y="556450"/>
                <a:ext cx="796559" cy="417585"/>
              </a:xfrm>
              <a:custGeom>
                <a:avLst/>
                <a:gdLst>
                  <a:gd name="connsiteX0" fmla="*/ 0 w 1441174"/>
                  <a:gd name="connsiteY0" fmla="*/ 705820 h 755515"/>
                  <a:gd name="connsiteX1" fmla="*/ 367748 w 1441174"/>
                  <a:gd name="connsiteY1" fmla="*/ 141 h 755515"/>
                  <a:gd name="connsiteX2" fmla="*/ 735495 w 1441174"/>
                  <a:gd name="connsiteY2" fmla="*/ 755515 h 755515"/>
                  <a:gd name="connsiteX3" fmla="*/ 1103243 w 1441174"/>
                  <a:gd name="connsiteY3" fmla="*/ 141 h 755515"/>
                  <a:gd name="connsiteX4" fmla="*/ 1441174 w 1441174"/>
                  <a:gd name="connsiteY4" fmla="*/ 745576 h 7555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1174" h="755515">
                    <a:moveTo>
                      <a:pt x="0" y="705820"/>
                    </a:moveTo>
                    <a:cubicBezTo>
                      <a:pt x="122583" y="348839"/>
                      <a:pt x="245166" y="-8141"/>
                      <a:pt x="367748" y="141"/>
                    </a:cubicBezTo>
                    <a:cubicBezTo>
                      <a:pt x="490330" y="8423"/>
                      <a:pt x="612913" y="755515"/>
                      <a:pt x="735495" y="755515"/>
                    </a:cubicBezTo>
                    <a:cubicBezTo>
                      <a:pt x="858077" y="755515"/>
                      <a:pt x="985630" y="1797"/>
                      <a:pt x="1103243" y="141"/>
                    </a:cubicBezTo>
                    <a:cubicBezTo>
                      <a:pt x="1220856" y="-1515"/>
                      <a:pt x="1331015" y="372030"/>
                      <a:pt x="1441174" y="745576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36" name="フリーフォーム: 図形 35">
                <a:extLst>
                  <a:ext uri="{FF2B5EF4-FFF2-40B4-BE49-F238E27FC236}">
                    <a16:creationId xmlns:a16="http://schemas.microsoft.com/office/drawing/2014/main" id="{A26DB20A-12B8-4F0E-ADFF-0A016286C8F0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4597676" y="558285"/>
                <a:ext cx="796560" cy="417585"/>
              </a:xfrm>
              <a:custGeom>
                <a:avLst/>
                <a:gdLst>
                  <a:gd name="connsiteX0" fmla="*/ 0 w 1441174"/>
                  <a:gd name="connsiteY0" fmla="*/ 705820 h 755515"/>
                  <a:gd name="connsiteX1" fmla="*/ 367748 w 1441174"/>
                  <a:gd name="connsiteY1" fmla="*/ 141 h 755515"/>
                  <a:gd name="connsiteX2" fmla="*/ 735495 w 1441174"/>
                  <a:gd name="connsiteY2" fmla="*/ 755515 h 755515"/>
                  <a:gd name="connsiteX3" fmla="*/ 1103243 w 1441174"/>
                  <a:gd name="connsiteY3" fmla="*/ 141 h 755515"/>
                  <a:gd name="connsiteX4" fmla="*/ 1441174 w 1441174"/>
                  <a:gd name="connsiteY4" fmla="*/ 745576 h 7555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1174" h="755515">
                    <a:moveTo>
                      <a:pt x="0" y="705820"/>
                    </a:moveTo>
                    <a:cubicBezTo>
                      <a:pt x="122583" y="348839"/>
                      <a:pt x="245166" y="-8141"/>
                      <a:pt x="367748" y="141"/>
                    </a:cubicBezTo>
                    <a:cubicBezTo>
                      <a:pt x="490330" y="8423"/>
                      <a:pt x="612913" y="755515"/>
                      <a:pt x="735495" y="755515"/>
                    </a:cubicBezTo>
                    <a:cubicBezTo>
                      <a:pt x="858077" y="755515"/>
                      <a:pt x="985630" y="1797"/>
                      <a:pt x="1103243" y="141"/>
                    </a:cubicBezTo>
                    <a:cubicBezTo>
                      <a:pt x="1220856" y="-1515"/>
                      <a:pt x="1331015" y="372030"/>
                      <a:pt x="1441174" y="745576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 dirty="0"/>
              </a:p>
            </p:txBody>
          </p:sp>
        </p:grpSp>
        <p:sp>
          <p:nvSpPr>
            <p:cNvPr id="33" name="涙形 32">
              <a:extLst>
                <a:ext uri="{FF2B5EF4-FFF2-40B4-BE49-F238E27FC236}">
                  <a16:creationId xmlns:a16="http://schemas.microsoft.com/office/drawing/2014/main" id="{C8630A44-1CED-47B9-88EF-33BC9F003019}"/>
                </a:ext>
              </a:extLst>
            </p:cNvPr>
            <p:cNvSpPr/>
            <p:nvPr/>
          </p:nvSpPr>
          <p:spPr>
            <a:xfrm>
              <a:off x="10267534" y="5790606"/>
              <a:ext cx="259979" cy="221931"/>
            </a:xfrm>
            <a:prstGeom prst="teardrop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dirty="0"/>
            </a:p>
          </p:txBody>
        </p:sp>
        <p:sp>
          <p:nvSpPr>
            <p:cNvPr id="34" name="部分円 33">
              <a:extLst>
                <a:ext uri="{FF2B5EF4-FFF2-40B4-BE49-F238E27FC236}">
                  <a16:creationId xmlns:a16="http://schemas.microsoft.com/office/drawing/2014/main" id="{6EFA71B1-C2CC-4862-8172-6383AC705306}"/>
                </a:ext>
              </a:extLst>
            </p:cNvPr>
            <p:cNvSpPr/>
            <p:nvPr/>
          </p:nvSpPr>
          <p:spPr>
            <a:xfrm>
              <a:off x="9863557" y="5767600"/>
              <a:ext cx="233456" cy="212741"/>
            </a:xfrm>
            <a:prstGeom prst="pi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1"/>
                </a:solidFill>
              </a:endParaRPr>
            </a:p>
          </p:txBody>
        </p:sp>
      </p:grpSp>
      <p:sp>
        <p:nvSpPr>
          <p:cNvPr id="148" name="四角形: 角を丸くする 147">
            <a:extLst>
              <a:ext uri="{FF2B5EF4-FFF2-40B4-BE49-F238E27FC236}">
                <a16:creationId xmlns:a16="http://schemas.microsoft.com/office/drawing/2014/main" id="{77171B42-5D9A-4596-AEDE-C26C4FFFD02E}"/>
              </a:ext>
            </a:extLst>
          </p:cNvPr>
          <p:cNvSpPr/>
          <p:nvPr/>
        </p:nvSpPr>
        <p:spPr>
          <a:xfrm>
            <a:off x="131228" y="1119047"/>
            <a:ext cx="3240000" cy="2700000"/>
          </a:xfrm>
          <a:prstGeom prst="roundRect">
            <a:avLst>
              <a:gd name="adj" fmla="val 6609"/>
            </a:avLst>
          </a:prstGeom>
          <a:noFill/>
          <a:ln w="381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2A3DB90D-54D0-4A78-B336-EA2E362197CC}"/>
              </a:ext>
            </a:extLst>
          </p:cNvPr>
          <p:cNvSpPr txBox="1"/>
          <p:nvPr/>
        </p:nvSpPr>
        <p:spPr>
          <a:xfrm>
            <a:off x="3983153" y="1573084"/>
            <a:ext cx="27430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cDNA encoding target peptid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Transcription factors (RNA polymerase etc.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Translation factors (ribosomes, etc.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ja-JP" sz="1000" dirty="0"/>
              <a:t>Stable isotope-labeled Lys (</a:t>
            </a:r>
            <a:r>
              <a:rPr lang="en-US" altLang="ja-JP" sz="1000" b="1" dirty="0"/>
              <a:t>K*</a:t>
            </a:r>
            <a:r>
              <a:rPr lang="en-US" altLang="ja-JP" sz="1000" dirty="0"/>
              <a:t>) and</a:t>
            </a:r>
            <a:r>
              <a:rPr lang="ja-JP" altLang="en-US" sz="1000" dirty="0"/>
              <a:t> </a:t>
            </a:r>
            <a:r>
              <a:rPr lang="en-US" altLang="ja-JP" sz="1000" dirty="0" err="1"/>
              <a:t>Arg</a:t>
            </a:r>
            <a:r>
              <a:rPr lang="en-US" altLang="ja-JP" sz="1000" dirty="0"/>
              <a:t> (</a:t>
            </a:r>
            <a:r>
              <a:rPr lang="en-US" altLang="ja-JP" sz="1000" b="1" dirty="0"/>
              <a:t>R*</a:t>
            </a:r>
            <a:r>
              <a:rPr lang="en-US" altLang="ja-JP" sz="1000" dirty="0"/>
              <a:t>) </a:t>
            </a:r>
            <a:endParaRPr lang="ja-JP" altLang="en-US" sz="1000" dirty="0"/>
          </a:p>
        </p:txBody>
      </p:sp>
      <p:sp>
        <p:nvSpPr>
          <p:cNvPr id="163" name="四角形: 角を丸くする 162">
            <a:extLst>
              <a:ext uri="{FF2B5EF4-FFF2-40B4-BE49-F238E27FC236}">
                <a16:creationId xmlns:a16="http://schemas.microsoft.com/office/drawing/2014/main" id="{EB23B395-CD2A-49E2-959D-01BB5000BFE8}"/>
              </a:ext>
            </a:extLst>
          </p:cNvPr>
          <p:cNvSpPr/>
          <p:nvPr/>
        </p:nvSpPr>
        <p:spPr>
          <a:xfrm>
            <a:off x="3486773" y="1119047"/>
            <a:ext cx="3240000" cy="2700000"/>
          </a:xfrm>
          <a:prstGeom prst="roundRect">
            <a:avLst>
              <a:gd name="adj" fmla="val 6609"/>
            </a:avLst>
          </a:prstGeom>
          <a:noFill/>
          <a:ln w="381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/>
          </a:p>
        </p:txBody>
      </p: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D27CA5A1-952D-412C-9EAA-3C750DA4C2C4}"/>
              </a:ext>
            </a:extLst>
          </p:cNvPr>
          <p:cNvGrpSpPr/>
          <p:nvPr/>
        </p:nvGrpSpPr>
        <p:grpSpPr>
          <a:xfrm>
            <a:off x="3590976" y="3154270"/>
            <a:ext cx="3048415" cy="487999"/>
            <a:chOff x="-4460095" y="3886080"/>
            <a:chExt cx="3048415" cy="487999"/>
          </a:xfrm>
        </p:grpSpPr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1D671D6-9F42-4DFA-BF4E-6E93C23ED5A3}"/>
                </a:ext>
              </a:extLst>
            </p:cNvPr>
            <p:cNvSpPr txBox="1"/>
            <p:nvPr/>
          </p:nvSpPr>
          <p:spPr>
            <a:xfrm>
              <a:off x="-2520686" y="3886080"/>
              <a:ext cx="1083951" cy="24622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solidFill>
                    <a:schemeClr val="tx1"/>
                  </a:solidFill>
                </a:rPr>
                <a:t>Targeted peptide</a:t>
              </a:r>
              <a:endParaRPr lang="ja-JP" altLang="en-US" sz="1000" dirty="0">
                <a:solidFill>
                  <a:schemeClr val="tx1"/>
                </a:solidFill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B33B1AE7-72EA-4B82-8460-B124401B8610}"/>
                </a:ext>
              </a:extLst>
            </p:cNvPr>
            <p:cNvSpPr txBox="1"/>
            <p:nvPr/>
          </p:nvSpPr>
          <p:spPr>
            <a:xfrm>
              <a:off x="-4460095" y="3886080"/>
              <a:ext cx="9749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/>
                <a:t>Purification tag</a:t>
              </a:r>
              <a:endParaRPr lang="ja-JP" altLang="en-US" sz="1000" dirty="0"/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B96FE2CD-C967-48E6-A9CD-821F53B414D6}"/>
                </a:ext>
              </a:extLst>
            </p:cNvPr>
            <p:cNvSpPr txBox="1"/>
            <p:nvPr/>
          </p:nvSpPr>
          <p:spPr>
            <a:xfrm>
              <a:off x="-3573159" y="3886080"/>
              <a:ext cx="11224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/>
                <a:t>Quantification tag</a:t>
              </a:r>
              <a:endParaRPr lang="ja-JP" altLang="en-US" sz="1000" dirty="0"/>
            </a:p>
          </p:txBody>
        </p:sp>
        <p:grpSp>
          <p:nvGrpSpPr>
            <p:cNvPr id="169" name="グループ化 168">
              <a:extLst>
                <a:ext uri="{FF2B5EF4-FFF2-40B4-BE49-F238E27FC236}">
                  <a16:creationId xmlns:a16="http://schemas.microsoft.com/office/drawing/2014/main" id="{2DC46AE6-92EC-4A55-B1EA-25DBADCF4F3F}"/>
                </a:ext>
              </a:extLst>
            </p:cNvPr>
            <p:cNvGrpSpPr/>
            <p:nvPr/>
          </p:nvGrpSpPr>
          <p:grpSpPr>
            <a:xfrm>
              <a:off x="-4370134" y="4097080"/>
              <a:ext cx="2958454" cy="276999"/>
              <a:chOff x="-4370134" y="4097080"/>
              <a:chExt cx="2958454" cy="276999"/>
            </a:xfrm>
          </p:grpSpPr>
          <p:grpSp>
            <p:nvGrpSpPr>
              <p:cNvPr id="167" name="グループ化 166">
                <a:extLst>
                  <a:ext uri="{FF2B5EF4-FFF2-40B4-BE49-F238E27FC236}">
                    <a16:creationId xmlns:a16="http://schemas.microsoft.com/office/drawing/2014/main" id="{05790230-330D-46CF-8D8B-28B0168DA1BA}"/>
                  </a:ext>
                </a:extLst>
              </p:cNvPr>
              <p:cNvGrpSpPr/>
              <p:nvPr/>
            </p:nvGrpSpPr>
            <p:grpSpPr>
              <a:xfrm>
                <a:off x="-4370134" y="4097080"/>
                <a:ext cx="967104" cy="276999"/>
                <a:chOff x="-4810530" y="4097080"/>
                <a:chExt cx="967104" cy="276999"/>
              </a:xfrm>
            </p:grpSpPr>
            <p:sp>
              <p:nvSpPr>
                <p:cNvPr id="119" name="正方形/長方形 118">
                  <a:extLst>
                    <a:ext uri="{FF2B5EF4-FFF2-40B4-BE49-F238E27FC236}">
                      <a16:creationId xmlns:a16="http://schemas.microsoft.com/office/drawing/2014/main" id="{433EFC48-8CD8-4245-A61B-C7B514881E07}"/>
                    </a:ext>
                  </a:extLst>
                </p:cNvPr>
                <p:cNvSpPr/>
                <p:nvPr/>
              </p:nvSpPr>
              <p:spPr>
                <a:xfrm>
                  <a:off x="-4810530" y="4145579"/>
                  <a:ext cx="900000" cy="1800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:endParaRPr kumimoji="1" lang="ja-JP" altLang="en-US"/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ACDE71DF-E12B-4BB7-9276-F2E90A6B4F87}"/>
                    </a:ext>
                  </a:extLst>
                </p:cNvPr>
                <p:cNvSpPr txBox="1"/>
                <p:nvPr/>
              </p:nvSpPr>
              <p:spPr>
                <a:xfrm>
                  <a:off x="-4189996" y="4097080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altLang="ja-JP" sz="1200" b="1" dirty="0"/>
                    <a:t>K*</a:t>
                  </a:r>
                  <a:endParaRPr lang="ja-JP" altLang="en-US" sz="1200" b="1" dirty="0"/>
                </a:p>
              </p:txBody>
            </p:sp>
          </p:grpSp>
          <p:grpSp>
            <p:nvGrpSpPr>
              <p:cNvPr id="166" name="グループ化 165">
                <a:extLst>
                  <a:ext uri="{FF2B5EF4-FFF2-40B4-BE49-F238E27FC236}">
                    <a16:creationId xmlns:a16="http://schemas.microsoft.com/office/drawing/2014/main" id="{34C693BB-6845-4761-8429-4AA14E3D98E6}"/>
                  </a:ext>
                </a:extLst>
              </p:cNvPr>
              <p:cNvGrpSpPr/>
              <p:nvPr/>
            </p:nvGrpSpPr>
            <p:grpSpPr>
              <a:xfrm>
                <a:off x="-3466438" y="4097080"/>
                <a:ext cx="967104" cy="276999"/>
                <a:chOff x="-3822952" y="4097080"/>
                <a:chExt cx="967104" cy="276999"/>
              </a:xfrm>
            </p:grpSpPr>
            <p:sp>
              <p:nvSpPr>
                <p:cNvPr id="134" name="正方形/長方形 133">
                  <a:extLst>
                    <a:ext uri="{FF2B5EF4-FFF2-40B4-BE49-F238E27FC236}">
                      <a16:creationId xmlns:a16="http://schemas.microsoft.com/office/drawing/2014/main" id="{B28992B0-4442-4F5D-B9D5-C402F597E512}"/>
                    </a:ext>
                  </a:extLst>
                </p:cNvPr>
                <p:cNvSpPr/>
                <p:nvPr/>
              </p:nvSpPr>
              <p:spPr>
                <a:xfrm>
                  <a:off x="-3822952" y="4145579"/>
                  <a:ext cx="900000" cy="180000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:endParaRPr kumimoji="1" lang="ja-JP" altLang="en-US"/>
                </a:p>
              </p:txBody>
            </p:sp>
            <p:sp>
              <p:nvSpPr>
                <p:cNvPr id="133" name="テキスト ボックス 132">
                  <a:extLst>
                    <a:ext uri="{FF2B5EF4-FFF2-40B4-BE49-F238E27FC236}">
                      <a16:creationId xmlns:a16="http://schemas.microsoft.com/office/drawing/2014/main" id="{7B125B95-ABA0-4CCE-A2C4-76C50D4CBADA}"/>
                    </a:ext>
                  </a:extLst>
                </p:cNvPr>
                <p:cNvSpPr txBox="1"/>
                <p:nvPr/>
              </p:nvSpPr>
              <p:spPr>
                <a:xfrm>
                  <a:off x="-3202418" y="4097080"/>
                  <a:ext cx="346570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altLang="ja-JP" sz="1200" b="1" dirty="0"/>
                    <a:t>K*</a:t>
                  </a:r>
                  <a:endParaRPr lang="ja-JP" altLang="en-US" sz="1200" b="1" dirty="0"/>
                </a:p>
              </p:txBody>
            </p:sp>
          </p:grpSp>
          <p:grpSp>
            <p:nvGrpSpPr>
              <p:cNvPr id="168" name="グループ化 167">
                <a:extLst>
                  <a:ext uri="{FF2B5EF4-FFF2-40B4-BE49-F238E27FC236}">
                    <a16:creationId xmlns:a16="http://schemas.microsoft.com/office/drawing/2014/main" id="{E9AFBA44-A3BE-4216-937F-0A8DBF4F71EB}"/>
                  </a:ext>
                </a:extLst>
              </p:cNvPr>
              <p:cNvGrpSpPr/>
              <p:nvPr/>
            </p:nvGrpSpPr>
            <p:grpSpPr>
              <a:xfrm>
                <a:off x="-2557282" y="4097080"/>
                <a:ext cx="1145602" cy="276999"/>
                <a:chOff x="-2557282" y="4097080"/>
                <a:chExt cx="1145602" cy="276999"/>
              </a:xfrm>
            </p:grpSpPr>
            <p:sp>
              <p:nvSpPr>
                <p:cNvPr id="129" name="正方形/長方形 128">
                  <a:extLst>
                    <a:ext uri="{FF2B5EF4-FFF2-40B4-BE49-F238E27FC236}">
                      <a16:creationId xmlns:a16="http://schemas.microsoft.com/office/drawing/2014/main" id="{1ABA0628-D4A0-46F0-9FCA-F3ED67C763E6}"/>
                    </a:ext>
                  </a:extLst>
                </p:cNvPr>
                <p:cNvSpPr/>
                <p:nvPr/>
              </p:nvSpPr>
              <p:spPr>
                <a:xfrm>
                  <a:off x="-2557282" y="4145579"/>
                  <a:ext cx="1080000" cy="180000"/>
                </a:xfrm>
                <a:prstGeom prst="rect">
                  <a:avLst/>
                </a:prstGeom>
                <a:solidFill>
                  <a:schemeClr val="accent5">
                    <a:lumMod val="40000"/>
                    <a:lumOff val="6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:endParaRPr kumimoji="1" lang="ja-JP" altLang="en-US"/>
                </a:p>
              </p:txBody>
            </p:sp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477C0783-716A-4503-AE0D-6E2156B77746}"/>
                    </a:ext>
                  </a:extLst>
                </p:cNvPr>
                <p:cNvSpPr txBox="1"/>
                <p:nvPr/>
              </p:nvSpPr>
              <p:spPr>
                <a:xfrm>
                  <a:off x="-1987479" y="4097080"/>
                  <a:ext cx="575799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altLang="ja-JP" sz="1200" b="1" dirty="0"/>
                    <a:t>K*/R*</a:t>
                  </a:r>
                  <a:endParaRPr lang="ja-JP" altLang="en-US" sz="1200" b="1" dirty="0"/>
                </a:p>
              </p:txBody>
            </p:sp>
          </p:grpSp>
        </p:grpSp>
      </p:grp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0BD2EA1D-886E-47C5-9F89-5634A645A528}"/>
              </a:ext>
            </a:extLst>
          </p:cNvPr>
          <p:cNvSpPr txBox="1"/>
          <p:nvPr/>
        </p:nvSpPr>
        <p:spPr>
          <a:xfrm>
            <a:off x="4507050" y="2833858"/>
            <a:ext cx="1244251" cy="2616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100" b="1" dirty="0"/>
              <a:t>MS-</a:t>
            </a:r>
            <a:r>
              <a:rPr kumimoji="1" lang="en-US" altLang="ja-JP" sz="1100" b="1" dirty="0" err="1"/>
              <a:t>QBiC</a:t>
            </a:r>
            <a:r>
              <a:rPr kumimoji="1" lang="en-US" altLang="ja-JP" sz="1100" b="1" dirty="0"/>
              <a:t> peptides</a:t>
            </a:r>
            <a:endParaRPr kumimoji="1" lang="ja-JP" altLang="en-US" sz="1100" b="1" dirty="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2479FCF9-CA33-455D-906E-D23ADFD9B8A8}"/>
              </a:ext>
            </a:extLst>
          </p:cNvPr>
          <p:cNvSpPr txBox="1"/>
          <p:nvPr/>
        </p:nvSpPr>
        <p:spPr>
          <a:xfrm>
            <a:off x="4502698" y="947003"/>
            <a:ext cx="1208151" cy="338554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1600" b="1" dirty="0"/>
              <a:t>SIL peptides</a:t>
            </a:r>
            <a:endParaRPr lang="ja-JP" altLang="en-US" sz="1600" b="1" dirty="0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42985686-4041-438A-AEC0-79E3E98A4F82}"/>
              </a:ext>
            </a:extLst>
          </p:cNvPr>
          <p:cNvSpPr txBox="1"/>
          <p:nvPr/>
        </p:nvSpPr>
        <p:spPr>
          <a:xfrm>
            <a:off x="1027120" y="961183"/>
            <a:ext cx="1448217" cy="338554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1600" b="1" dirty="0"/>
              <a:t>Clinical sample</a:t>
            </a:r>
            <a:endParaRPr lang="ja-JP" altLang="en-US" sz="1600" b="1" dirty="0"/>
          </a:p>
        </p:txBody>
      </p:sp>
      <p:cxnSp>
        <p:nvCxnSpPr>
          <p:cNvPr id="178" name="直線矢印コネクタ 177">
            <a:extLst>
              <a:ext uri="{FF2B5EF4-FFF2-40B4-BE49-F238E27FC236}">
                <a16:creationId xmlns:a16="http://schemas.microsoft.com/office/drawing/2014/main" id="{102E549F-6701-4A5B-AA5A-D3B05E92C3D9}"/>
              </a:ext>
            </a:extLst>
          </p:cNvPr>
          <p:cNvCxnSpPr>
            <a:cxnSpLocks/>
          </p:cNvCxnSpPr>
          <p:nvPr/>
        </p:nvCxnSpPr>
        <p:spPr>
          <a:xfrm>
            <a:off x="5106773" y="2371711"/>
            <a:ext cx="0" cy="36000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2" name="グループ化 211">
            <a:extLst>
              <a:ext uri="{FF2B5EF4-FFF2-40B4-BE49-F238E27FC236}">
                <a16:creationId xmlns:a16="http://schemas.microsoft.com/office/drawing/2014/main" id="{678F9F79-D645-415D-9258-8B00D1ACEBA6}"/>
              </a:ext>
            </a:extLst>
          </p:cNvPr>
          <p:cNvGrpSpPr>
            <a:grpSpLocks noChangeAspect="1"/>
          </p:cNvGrpSpPr>
          <p:nvPr/>
        </p:nvGrpSpPr>
        <p:grpSpPr>
          <a:xfrm>
            <a:off x="1498700" y="2936501"/>
            <a:ext cx="466455" cy="454944"/>
            <a:chOff x="9413244" y="4963206"/>
            <a:chExt cx="1484727" cy="1448092"/>
          </a:xfrm>
        </p:grpSpPr>
        <p:sp>
          <p:nvSpPr>
            <p:cNvPr id="213" name="楕円 212">
              <a:extLst>
                <a:ext uri="{FF2B5EF4-FFF2-40B4-BE49-F238E27FC236}">
                  <a16:creationId xmlns:a16="http://schemas.microsoft.com/office/drawing/2014/main" id="{A62405FD-452F-4D3F-A22E-1C60AB04A764}"/>
                </a:ext>
              </a:extLst>
            </p:cNvPr>
            <p:cNvSpPr/>
            <p:nvPr/>
          </p:nvSpPr>
          <p:spPr>
            <a:xfrm>
              <a:off x="9496223" y="5092210"/>
              <a:ext cx="1401748" cy="1293986"/>
            </a:xfrm>
            <a:prstGeom prst="ellipse">
              <a:avLst/>
            </a:prstGeom>
            <a:noFill/>
            <a:ln w="12065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dirty="0"/>
            </a:p>
          </p:txBody>
        </p:sp>
        <p:grpSp>
          <p:nvGrpSpPr>
            <p:cNvPr id="214" name="グループ化 213">
              <a:extLst>
                <a:ext uri="{FF2B5EF4-FFF2-40B4-BE49-F238E27FC236}">
                  <a16:creationId xmlns:a16="http://schemas.microsoft.com/office/drawing/2014/main" id="{45A5128D-F3D5-43C6-BA01-5ACD7BC36382}"/>
                </a:ext>
              </a:extLst>
            </p:cNvPr>
            <p:cNvGrpSpPr/>
            <p:nvPr/>
          </p:nvGrpSpPr>
          <p:grpSpPr>
            <a:xfrm>
              <a:off x="10054433" y="4963206"/>
              <a:ext cx="317475" cy="258007"/>
              <a:chOff x="5462221" y="506896"/>
              <a:chExt cx="317475" cy="258007"/>
            </a:xfrm>
          </p:grpSpPr>
          <p:sp>
            <p:nvSpPr>
              <p:cNvPr id="227" name="フリーフォーム: 図形 226">
                <a:extLst>
                  <a:ext uri="{FF2B5EF4-FFF2-40B4-BE49-F238E27FC236}">
                    <a16:creationId xmlns:a16="http://schemas.microsoft.com/office/drawing/2014/main" id="{351B0865-4214-488C-AB1C-F3BCDBC1201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2221" y="506896"/>
                <a:ext cx="143450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28" name="フリーフォーム: 図形 227">
                <a:extLst>
                  <a:ext uri="{FF2B5EF4-FFF2-40B4-BE49-F238E27FC236}">
                    <a16:creationId xmlns:a16="http://schemas.microsoft.com/office/drawing/2014/main" id="{1D91B56F-EA92-4885-85E6-1C269299118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8528" flipH="1">
                <a:off x="5636677" y="516644"/>
                <a:ext cx="143019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</p:grpSp>
        <p:grpSp>
          <p:nvGrpSpPr>
            <p:cNvPr id="215" name="グループ化 214">
              <a:extLst>
                <a:ext uri="{FF2B5EF4-FFF2-40B4-BE49-F238E27FC236}">
                  <a16:creationId xmlns:a16="http://schemas.microsoft.com/office/drawing/2014/main" id="{167048E6-FF58-42C1-8A2E-2442237DDF15}"/>
                </a:ext>
              </a:extLst>
            </p:cNvPr>
            <p:cNvGrpSpPr/>
            <p:nvPr/>
          </p:nvGrpSpPr>
          <p:grpSpPr>
            <a:xfrm rot="8217376">
              <a:off x="10467518" y="6103304"/>
              <a:ext cx="317475" cy="258007"/>
              <a:chOff x="5462221" y="506896"/>
              <a:chExt cx="317475" cy="258007"/>
            </a:xfrm>
          </p:grpSpPr>
          <p:sp>
            <p:nvSpPr>
              <p:cNvPr id="225" name="フリーフォーム: 図形 224">
                <a:extLst>
                  <a:ext uri="{FF2B5EF4-FFF2-40B4-BE49-F238E27FC236}">
                    <a16:creationId xmlns:a16="http://schemas.microsoft.com/office/drawing/2014/main" id="{0DFFBF98-015F-4C72-8EB6-FBE60F6F0B5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2221" y="506896"/>
                <a:ext cx="143450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26" name="フリーフォーム: 図形 225">
                <a:extLst>
                  <a:ext uri="{FF2B5EF4-FFF2-40B4-BE49-F238E27FC236}">
                    <a16:creationId xmlns:a16="http://schemas.microsoft.com/office/drawing/2014/main" id="{0D193CEA-59D1-459B-8362-5A92FD296E21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8528" flipH="1">
                <a:off x="5636677" y="516644"/>
                <a:ext cx="143019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</p:grpSp>
        <p:sp>
          <p:nvSpPr>
            <p:cNvPr id="216" name="フリーフォーム: 図形 215">
              <a:extLst>
                <a:ext uri="{FF2B5EF4-FFF2-40B4-BE49-F238E27FC236}">
                  <a16:creationId xmlns:a16="http://schemas.microsoft.com/office/drawing/2014/main" id="{AF061DB8-8EFA-49C6-9C46-CA761F1DBF71}"/>
                </a:ext>
              </a:extLst>
            </p:cNvPr>
            <p:cNvSpPr>
              <a:spLocks noChangeAspect="1"/>
            </p:cNvSpPr>
            <p:nvPr/>
          </p:nvSpPr>
          <p:spPr>
            <a:xfrm rot="1932916">
              <a:off x="10581850" y="5179394"/>
              <a:ext cx="274290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17" name="フリーフォーム: 図形 216">
              <a:extLst>
                <a:ext uri="{FF2B5EF4-FFF2-40B4-BE49-F238E27FC236}">
                  <a16:creationId xmlns:a16="http://schemas.microsoft.com/office/drawing/2014/main" id="{E5125B9F-9FDC-4E7F-9E35-6453B6AC81F4}"/>
                </a:ext>
              </a:extLst>
            </p:cNvPr>
            <p:cNvSpPr>
              <a:spLocks noChangeAspect="1"/>
            </p:cNvSpPr>
            <p:nvPr/>
          </p:nvSpPr>
          <p:spPr>
            <a:xfrm rot="18026397">
              <a:off x="9417628" y="5272985"/>
              <a:ext cx="274290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18" name="フリーフォーム: 図形 217">
              <a:extLst>
                <a:ext uri="{FF2B5EF4-FFF2-40B4-BE49-F238E27FC236}">
                  <a16:creationId xmlns:a16="http://schemas.microsoft.com/office/drawing/2014/main" id="{DDD0FFC4-16C6-4AB9-8F70-54E4FF9AD9D6}"/>
                </a:ext>
              </a:extLst>
            </p:cNvPr>
            <p:cNvSpPr>
              <a:spLocks noChangeAspect="1"/>
            </p:cNvSpPr>
            <p:nvPr/>
          </p:nvSpPr>
          <p:spPr>
            <a:xfrm rot="13130338">
              <a:off x="9645564" y="6128240"/>
              <a:ext cx="274289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19" name="フリーフォーム: 図形 218">
              <a:extLst>
                <a:ext uri="{FF2B5EF4-FFF2-40B4-BE49-F238E27FC236}">
                  <a16:creationId xmlns:a16="http://schemas.microsoft.com/office/drawing/2014/main" id="{616D2D61-1F8E-4175-99E4-A0868755D95A}"/>
                </a:ext>
              </a:extLst>
            </p:cNvPr>
            <p:cNvSpPr/>
            <p:nvPr/>
          </p:nvSpPr>
          <p:spPr>
            <a:xfrm>
              <a:off x="9759639" y="5329216"/>
              <a:ext cx="337374" cy="320633"/>
            </a:xfrm>
            <a:custGeom>
              <a:avLst/>
              <a:gdLst>
                <a:gd name="connsiteX0" fmla="*/ 0 w 467139"/>
                <a:gd name="connsiteY0" fmla="*/ 427382 h 427382"/>
                <a:gd name="connsiteX1" fmla="*/ 9939 w 467139"/>
                <a:gd name="connsiteY1" fmla="*/ 377687 h 427382"/>
                <a:gd name="connsiteX2" fmla="*/ 19878 w 467139"/>
                <a:gd name="connsiteY2" fmla="*/ 258417 h 427382"/>
                <a:gd name="connsiteX3" fmla="*/ 29817 w 467139"/>
                <a:gd name="connsiteY3" fmla="*/ 218661 h 427382"/>
                <a:gd name="connsiteX4" fmla="*/ 49696 w 467139"/>
                <a:gd name="connsiteY4" fmla="*/ 198782 h 427382"/>
                <a:gd name="connsiteX5" fmla="*/ 119269 w 467139"/>
                <a:gd name="connsiteY5" fmla="*/ 168965 h 427382"/>
                <a:gd name="connsiteX6" fmla="*/ 168965 w 467139"/>
                <a:gd name="connsiteY6" fmla="*/ 159026 h 427382"/>
                <a:gd name="connsiteX7" fmla="*/ 278296 w 467139"/>
                <a:gd name="connsiteY7" fmla="*/ 198782 h 427382"/>
                <a:gd name="connsiteX8" fmla="*/ 288235 w 467139"/>
                <a:gd name="connsiteY8" fmla="*/ 228600 h 427382"/>
                <a:gd name="connsiteX9" fmla="*/ 278296 w 467139"/>
                <a:gd name="connsiteY9" fmla="*/ 318052 h 427382"/>
                <a:gd name="connsiteX10" fmla="*/ 228600 w 467139"/>
                <a:gd name="connsiteY10" fmla="*/ 327991 h 427382"/>
                <a:gd name="connsiteX11" fmla="*/ 188843 w 467139"/>
                <a:gd name="connsiteY11" fmla="*/ 308113 h 427382"/>
                <a:gd name="connsiteX12" fmla="*/ 168965 w 467139"/>
                <a:gd name="connsiteY12" fmla="*/ 288234 h 427382"/>
                <a:gd name="connsiteX13" fmla="*/ 139148 w 467139"/>
                <a:gd name="connsiteY13" fmla="*/ 268356 h 427382"/>
                <a:gd name="connsiteX14" fmla="*/ 129209 w 467139"/>
                <a:gd name="connsiteY14" fmla="*/ 238539 h 427382"/>
                <a:gd name="connsiteX15" fmla="*/ 168965 w 467139"/>
                <a:gd name="connsiteY15" fmla="*/ 99391 h 427382"/>
                <a:gd name="connsiteX16" fmla="*/ 198783 w 467139"/>
                <a:gd name="connsiteY16" fmla="*/ 79513 h 427382"/>
                <a:gd name="connsiteX17" fmla="*/ 258417 w 467139"/>
                <a:gd name="connsiteY17" fmla="*/ 89452 h 427382"/>
                <a:gd name="connsiteX18" fmla="*/ 218661 w 467139"/>
                <a:gd name="connsiteY18" fmla="*/ 208721 h 427382"/>
                <a:gd name="connsiteX19" fmla="*/ 198783 w 467139"/>
                <a:gd name="connsiteY19" fmla="*/ 178904 h 427382"/>
                <a:gd name="connsiteX20" fmla="*/ 178904 w 467139"/>
                <a:gd name="connsiteY20" fmla="*/ 159026 h 427382"/>
                <a:gd name="connsiteX21" fmla="*/ 228600 w 467139"/>
                <a:gd name="connsiteY21" fmla="*/ 39756 h 427382"/>
                <a:gd name="connsiteX22" fmla="*/ 288235 w 467139"/>
                <a:gd name="connsiteY22" fmla="*/ 29817 h 427382"/>
                <a:gd name="connsiteX23" fmla="*/ 357809 w 467139"/>
                <a:gd name="connsiteY23" fmla="*/ 39756 h 427382"/>
                <a:gd name="connsiteX24" fmla="*/ 417443 w 467139"/>
                <a:gd name="connsiteY24" fmla="*/ 59634 h 427382"/>
                <a:gd name="connsiteX25" fmla="*/ 447261 w 467139"/>
                <a:gd name="connsiteY25" fmla="*/ 49695 h 427382"/>
                <a:gd name="connsiteX26" fmla="*/ 457200 w 467139"/>
                <a:gd name="connsiteY26" fmla="*/ 19878 h 427382"/>
                <a:gd name="connsiteX27" fmla="*/ 467139 w 467139"/>
                <a:gd name="connsiteY27" fmla="*/ 0 h 4273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467139" h="427382">
                  <a:moveTo>
                    <a:pt x="0" y="427382"/>
                  </a:moveTo>
                  <a:cubicBezTo>
                    <a:pt x="3313" y="410817"/>
                    <a:pt x="7965" y="394464"/>
                    <a:pt x="9939" y="377687"/>
                  </a:cubicBezTo>
                  <a:cubicBezTo>
                    <a:pt x="14600" y="338066"/>
                    <a:pt x="14930" y="298003"/>
                    <a:pt x="19878" y="258417"/>
                  </a:cubicBezTo>
                  <a:cubicBezTo>
                    <a:pt x="21572" y="244863"/>
                    <a:pt x="23708" y="230879"/>
                    <a:pt x="29817" y="218661"/>
                  </a:cubicBezTo>
                  <a:cubicBezTo>
                    <a:pt x="34008" y="210279"/>
                    <a:pt x="41899" y="203980"/>
                    <a:pt x="49696" y="198782"/>
                  </a:cubicBezTo>
                  <a:cubicBezTo>
                    <a:pt x="66762" y="187404"/>
                    <a:pt x="98066" y="174266"/>
                    <a:pt x="119269" y="168965"/>
                  </a:cubicBezTo>
                  <a:cubicBezTo>
                    <a:pt x="135658" y="164868"/>
                    <a:pt x="152400" y="162339"/>
                    <a:pt x="168965" y="159026"/>
                  </a:cubicBezTo>
                  <a:cubicBezTo>
                    <a:pt x="228768" y="166501"/>
                    <a:pt x="247302" y="152292"/>
                    <a:pt x="278296" y="198782"/>
                  </a:cubicBezTo>
                  <a:cubicBezTo>
                    <a:pt x="284108" y="207499"/>
                    <a:pt x="284922" y="218661"/>
                    <a:pt x="288235" y="228600"/>
                  </a:cubicBezTo>
                  <a:cubicBezTo>
                    <a:pt x="284922" y="258417"/>
                    <a:pt x="286190" y="289108"/>
                    <a:pt x="278296" y="318052"/>
                  </a:cubicBezTo>
                  <a:cubicBezTo>
                    <a:pt x="269582" y="350001"/>
                    <a:pt x="246541" y="335680"/>
                    <a:pt x="228600" y="327991"/>
                  </a:cubicBezTo>
                  <a:cubicBezTo>
                    <a:pt x="214981" y="322155"/>
                    <a:pt x="202095" y="314739"/>
                    <a:pt x="188843" y="308113"/>
                  </a:cubicBezTo>
                  <a:cubicBezTo>
                    <a:pt x="182217" y="301487"/>
                    <a:pt x="176282" y="294088"/>
                    <a:pt x="168965" y="288234"/>
                  </a:cubicBezTo>
                  <a:cubicBezTo>
                    <a:pt x="159637" y="280772"/>
                    <a:pt x="146610" y="277684"/>
                    <a:pt x="139148" y="268356"/>
                  </a:cubicBezTo>
                  <a:cubicBezTo>
                    <a:pt x="132603" y="260175"/>
                    <a:pt x="132522" y="248478"/>
                    <a:pt x="129209" y="238539"/>
                  </a:cubicBezTo>
                  <a:cubicBezTo>
                    <a:pt x="138043" y="141358"/>
                    <a:pt x="114185" y="145040"/>
                    <a:pt x="168965" y="99391"/>
                  </a:cubicBezTo>
                  <a:cubicBezTo>
                    <a:pt x="178142" y="91744"/>
                    <a:pt x="188844" y="86139"/>
                    <a:pt x="198783" y="79513"/>
                  </a:cubicBezTo>
                  <a:lnTo>
                    <a:pt x="258417" y="89452"/>
                  </a:lnTo>
                  <a:cubicBezTo>
                    <a:pt x="316486" y="252046"/>
                    <a:pt x="272769" y="226759"/>
                    <a:pt x="218661" y="208721"/>
                  </a:cubicBezTo>
                  <a:cubicBezTo>
                    <a:pt x="212035" y="198782"/>
                    <a:pt x="206245" y="188232"/>
                    <a:pt x="198783" y="178904"/>
                  </a:cubicBezTo>
                  <a:cubicBezTo>
                    <a:pt x="192929" y="171587"/>
                    <a:pt x="178904" y="168397"/>
                    <a:pt x="178904" y="159026"/>
                  </a:cubicBezTo>
                  <a:cubicBezTo>
                    <a:pt x="178904" y="109946"/>
                    <a:pt x="178527" y="56447"/>
                    <a:pt x="228600" y="39756"/>
                  </a:cubicBezTo>
                  <a:cubicBezTo>
                    <a:pt x="247718" y="33383"/>
                    <a:pt x="268357" y="33130"/>
                    <a:pt x="288235" y="29817"/>
                  </a:cubicBezTo>
                  <a:cubicBezTo>
                    <a:pt x="311426" y="33130"/>
                    <a:pt x="334982" y="34488"/>
                    <a:pt x="357809" y="39756"/>
                  </a:cubicBezTo>
                  <a:cubicBezTo>
                    <a:pt x="378226" y="44468"/>
                    <a:pt x="417443" y="59634"/>
                    <a:pt x="417443" y="59634"/>
                  </a:cubicBezTo>
                  <a:cubicBezTo>
                    <a:pt x="427382" y="56321"/>
                    <a:pt x="439853" y="57103"/>
                    <a:pt x="447261" y="49695"/>
                  </a:cubicBezTo>
                  <a:cubicBezTo>
                    <a:pt x="454669" y="42287"/>
                    <a:pt x="453309" y="29605"/>
                    <a:pt x="457200" y="19878"/>
                  </a:cubicBezTo>
                  <a:cubicBezTo>
                    <a:pt x="459951" y="13000"/>
                    <a:pt x="463826" y="6626"/>
                    <a:pt x="467139" y="0"/>
                  </a:cubicBezTo>
                </a:path>
              </a:pathLst>
            </a:custGeom>
            <a:noFill/>
            <a:ln w="31750">
              <a:solidFill>
                <a:srgbClr val="CC66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grpSp>
          <p:nvGrpSpPr>
            <p:cNvPr id="220" name="グループ化 219">
              <a:extLst>
                <a:ext uri="{FF2B5EF4-FFF2-40B4-BE49-F238E27FC236}">
                  <a16:creationId xmlns:a16="http://schemas.microsoft.com/office/drawing/2014/main" id="{5250C53F-CD36-409F-9815-62AD98EFEBCA}"/>
                </a:ext>
              </a:extLst>
            </p:cNvPr>
            <p:cNvGrpSpPr>
              <a:grpSpLocks noChangeAspect="1"/>
            </p:cNvGrpSpPr>
            <p:nvPr/>
          </p:nvGrpSpPr>
          <p:grpSpPr>
            <a:xfrm rot="2259212">
              <a:off x="10233133" y="5410997"/>
              <a:ext cx="373706" cy="188725"/>
              <a:chOff x="4597676" y="556450"/>
              <a:chExt cx="830518" cy="419420"/>
            </a:xfrm>
          </p:grpSpPr>
          <p:sp>
            <p:nvSpPr>
              <p:cNvPr id="223" name="フリーフォーム: 図形 222">
                <a:extLst>
                  <a:ext uri="{FF2B5EF4-FFF2-40B4-BE49-F238E27FC236}">
                    <a16:creationId xmlns:a16="http://schemas.microsoft.com/office/drawing/2014/main" id="{013FEDAE-471A-481E-A9C2-C4CB298FF61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631635" y="556450"/>
                <a:ext cx="796559" cy="417585"/>
              </a:xfrm>
              <a:custGeom>
                <a:avLst/>
                <a:gdLst>
                  <a:gd name="connsiteX0" fmla="*/ 0 w 1441174"/>
                  <a:gd name="connsiteY0" fmla="*/ 705820 h 755515"/>
                  <a:gd name="connsiteX1" fmla="*/ 367748 w 1441174"/>
                  <a:gd name="connsiteY1" fmla="*/ 141 h 755515"/>
                  <a:gd name="connsiteX2" fmla="*/ 735495 w 1441174"/>
                  <a:gd name="connsiteY2" fmla="*/ 755515 h 755515"/>
                  <a:gd name="connsiteX3" fmla="*/ 1103243 w 1441174"/>
                  <a:gd name="connsiteY3" fmla="*/ 141 h 755515"/>
                  <a:gd name="connsiteX4" fmla="*/ 1441174 w 1441174"/>
                  <a:gd name="connsiteY4" fmla="*/ 745576 h 7555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1174" h="755515">
                    <a:moveTo>
                      <a:pt x="0" y="705820"/>
                    </a:moveTo>
                    <a:cubicBezTo>
                      <a:pt x="122583" y="348839"/>
                      <a:pt x="245166" y="-8141"/>
                      <a:pt x="367748" y="141"/>
                    </a:cubicBezTo>
                    <a:cubicBezTo>
                      <a:pt x="490330" y="8423"/>
                      <a:pt x="612913" y="755515"/>
                      <a:pt x="735495" y="755515"/>
                    </a:cubicBezTo>
                    <a:cubicBezTo>
                      <a:pt x="858077" y="755515"/>
                      <a:pt x="985630" y="1797"/>
                      <a:pt x="1103243" y="141"/>
                    </a:cubicBezTo>
                    <a:cubicBezTo>
                      <a:pt x="1220856" y="-1515"/>
                      <a:pt x="1331015" y="372030"/>
                      <a:pt x="1441174" y="745576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24" name="フリーフォーム: 図形 223">
                <a:extLst>
                  <a:ext uri="{FF2B5EF4-FFF2-40B4-BE49-F238E27FC236}">
                    <a16:creationId xmlns:a16="http://schemas.microsoft.com/office/drawing/2014/main" id="{8C8CC9F2-A5FF-49DA-9D0D-2B598B7DFCCB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4597676" y="558285"/>
                <a:ext cx="796560" cy="417585"/>
              </a:xfrm>
              <a:custGeom>
                <a:avLst/>
                <a:gdLst>
                  <a:gd name="connsiteX0" fmla="*/ 0 w 1441174"/>
                  <a:gd name="connsiteY0" fmla="*/ 705820 h 755515"/>
                  <a:gd name="connsiteX1" fmla="*/ 367748 w 1441174"/>
                  <a:gd name="connsiteY1" fmla="*/ 141 h 755515"/>
                  <a:gd name="connsiteX2" fmla="*/ 735495 w 1441174"/>
                  <a:gd name="connsiteY2" fmla="*/ 755515 h 755515"/>
                  <a:gd name="connsiteX3" fmla="*/ 1103243 w 1441174"/>
                  <a:gd name="connsiteY3" fmla="*/ 141 h 755515"/>
                  <a:gd name="connsiteX4" fmla="*/ 1441174 w 1441174"/>
                  <a:gd name="connsiteY4" fmla="*/ 745576 h 7555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1174" h="755515">
                    <a:moveTo>
                      <a:pt x="0" y="705820"/>
                    </a:moveTo>
                    <a:cubicBezTo>
                      <a:pt x="122583" y="348839"/>
                      <a:pt x="245166" y="-8141"/>
                      <a:pt x="367748" y="141"/>
                    </a:cubicBezTo>
                    <a:cubicBezTo>
                      <a:pt x="490330" y="8423"/>
                      <a:pt x="612913" y="755515"/>
                      <a:pt x="735495" y="755515"/>
                    </a:cubicBezTo>
                    <a:cubicBezTo>
                      <a:pt x="858077" y="755515"/>
                      <a:pt x="985630" y="1797"/>
                      <a:pt x="1103243" y="141"/>
                    </a:cubicBezTo>
                    <a:cubicBezTo>
                      <a:pt x="1220856" y="-1515"/>
                      <a:pt x="1331015" y="372030"/>
                      <a:pt x="1441174" y="745576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 dirty="0"/>
              </a:p>
            </p:txBody>
          </p:sp>
        </p:grpSp>
        <p:sp>
          <p:nvSpPr>
            <p:cNvPr id="221" name="涙形 220">
              <a:extLst>
                <a:ext uri="{FF2B5EF4-FFF2-40B4-BE49-F238E27FC236}">
                  <a16:creationId xmlns:a16="http://schemas.microsoft.com/office/drawing/2014/main" id="{BB9A099C-7781-4AF0-B7CE-E29F9ABBF7EE}"/>
                </a:ext>
              </a:extLst>
            </p:cNvPr>
            <p:cNvSpPr/>
            <p:nvPr/>
          </p:nvSpPr>
          <p:spPr>
            <a:xfrm>
              <a:off x="10267534" y="5790606"/>
              <a:ext cx="259979" cy="221931"/>
            </a:xfrm>
            <a:prstGeom prst="teardrop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dirty="0"/>
            </a:p>
          </p:txBody>
        </p:sp>
        <p:sp>
          <p:nvSpPr>
            <p:cNvPr id="222" name="部分円 221">
              <a:extLst>
                <a:ext uri="{FF2B5EF4-FFF2-40B4-BE49-F238E27FC236}">
                  <a16:creationId xmlns:a16="http://schemas.microsoft.com/office/drawing/2014/main" id="{13CF2799-917B-4908-AE3D-4F98E6B4818D}"/>
                </a:ext>
              </a:extLst>
            </p:cNvPr>
            <p:cNvSpPr/>
            <p:nvPr/>
          </p:nvSpPr>
          <p:spPr>
            <a:xfrm>
              <a:off x="9863557" y="5767600"/>
              <a:ext cx="233456" cy="212741"/>
            </a:xfrm>
            <a:prstGeom prst="pi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1"/>
                </a:solidFill>
              </a:endParaRPr>
            </a:p>
          </p:txBody>
        </p:sp>
      </p:grpSp>
      <p:grpSp>
        <p:nvGrpSpPr>
          <p:cNvPr id="229" name="グループ化 228">
            <a:extLst>
              <a:ext uri="{FF2B5EF4-FFF2-40B4-BE49-F238E27FC236}">
                <a16:creationId xmlns:a16="http://schemas.microsoft.com/office/drawing/2014/main" id="{4685EED2-797F-455A-ADA7-111383EC9953}"/>
              </a:ext>
            </a:extLst>
          </p:cNvPr>
          <p:cNvGrpSpPr>
            <a:grpSpLocks noChangeAspect="1"/>
          </p:cNvGrpSpPr>
          <p:nvPr/>
        </p:nvGrpSpPr>
        <p:grpSpPr>
          <a:xfrm>
            <a:off x="2032020" y="3250836"/>
            <a:ext cx="466455" cy="454944"/>
            <a:chOff x="9413244" y="4963206"/>
            <a:chExt cx="1484727" cy="1448092"/>
          </a:xfrm>
        </p:grpSpPr>
        <p:sp>
          <p:nvSpPr>
            <p:cNvPr id="230" name="楕円 229">
              <a:extLst>
                <a:ext uri="{FF2B5EF4-FFF2-40B4-BE49-F238E27FC236}">
                  <a16:creationId xmlns:a16="http://schemas.microsoft.com/office/drawing/2014/main" id="{36754E12-5271-49DF-BDF2-CE1CCC0B0043}"/>
                </a:ext>
              </a:extLst>
            </p:cNvPr>
            <p:cNvSpPr/>
            <p:nvPr/>
          </p:nvSpPr>
          <p:spPr>
            <a:xfrm>
              <a:off x="9496223" y="5092210"/>
              <a:ext cx="1401748" cy="1293986"/>
            </a:xfrm>
            <a:prstGeom prst="ellipse">
              <a:avLst/>
            </a:prstGeom>
            <a:noFill/>
            <a:ln w="12065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dirty="0"/>
            </a:p>
          </p:txBody>
        </p:sp>
        <p:grpSp>
          <p:nvGrpSpPr>
            <p:cNvPr id="231" name="グループ化 230">
              <a:extLst>
                <a:ext uri="{FF2B5EF4-FFF2-40B4-BE49-F238E27FC236}">
                  <a16:creationId xmlns:a16="http://schemas.microsoft.com/office/drawing/2014/main" id="{47CDFA33-7CF8-4206-91C3-DFF3740B41A0}"/>
                </a:ext>
              </a:extLst>
            </p:cNvPr>
            <p:cNvGrpSpPr/>
            <p:nvPr/>
          </p:nvGrpSpPr>
          <p:grpSpPr>
            <a:xfrm>
              <a:off x="10054433" y="4963206"/>
              <a:ext cx="317475" cy="258007"/>
              <a:chOff x="5462221" y="506896"/>
              <a:chExt cx="317475" cy="258007"/>
            </a:xfrm>
          </p:grpSpPr>
          <p:sp>
            <p:nvSpPr>
              <p:cNvPr id="244" name="フリーフォーム: 図形 243">
                <a:extLst>
                  <a:ext uri="{FF2B5EF4-FFF2-40B4-BE49-F238E27FC236}">
                    <a16:creationId xmlns:a16="http://schemas.microsoft.com/office/drawing/2014/main" id="{894E2937-AE98-4FD4-8787-2D983A9D047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2221" y="506896"/>
                <a:ext cx="143450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45" name="フリーフォーム: 図形 244">
                <a:extLst>
                  <a:ext uri="{FF2B5EF4-FFF2-40B4-BE49-F238E27FC236}">
                    <a16:creationId xmlns:a16="http://schemas.microsoft.com/office/drawing/2014/main" id="{657C8D65-ED23-4B04-8D04-365664B5D78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8528" flipH="1">
                <a:off x="5636677" y="516644"/>
                <a:ext cx="143019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</p:grpSp>
        <p:grpSp>
          <p:nvGrpSpPr>
            <p:cNvPr id="232" name="グループ化 231">
              <a:extLst>
                <a:ext uri="{FF2B5EF4-FFF2-40B4-BE49-F238E27FC236}">
                  <a16:creationId xmlns:a16="http://schemas.microsoft.com/office/drawing/2014/main" id="{188F0E84-564B-4BA5-B939-A51C35CFEE55}"/>
                </a:ext>
              </a:extLst>
            </p:cNvPr>
            <p:cNvGrpSpPr/>
            <p:nvPr/>
          </p:nvGrpSpPr>
          <p:grpSpPr>
            <a:xfrm rot="8217376">
              <a:off x="10467518" y="6103304"/>
              <a:ext cx="317475" cy="258007"/>
              <a:chOff x="5462221" y="506896"/>
              <a:chExt cx="317475" cy="258007"/>
            </a:xfrm>
          </p:grpSpPr>
          <p:sp>
            <p:nvSpPr>
              <p:cNvPr id="242" name="フリーフォーム: 図形 241">
                <a:extLst>
                  <a:ext uri="{FF2B5EF4-FFF2-40B4-BE49-F238E27FC236}">
                    <a16:creationId xmlns:a16="http://schemas.microsoft.com/office/drawing/2014/main" id="{B3BA1E1E-BD58-4425-8CEA-D238398AFEE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62221" y="506896"/>
                <a:ext cx="143450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43" name="フリーフォーム: 図形 242">
                <a:extLst>
                  <a:ext uri="{FF2B5EF4-FFF2-40B4-BE49-F238E27FC236}">
                    <a16:creationId xmlns:a16="http://schemas.microsoft.com/office/drawing/2014/main" id="{072B2CA9-A138-4ECD-966B-BAD36C26A44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8528" flipH="1">
                <a:off x="5636677" y="516644"/>
                <a:ext cx="143019" cy="248259"/>
              </a:xfrm>
              <a:custGeom>
                <a:avLst/>
                <a:gdLst>
                  <a:gd name="connsiteX0" fmla="*/ 421745 w 421745"/>
                  <a:gd name="connsiteY0" fmla="*/ 715617 h 729884"/>
                  <a:gd name="connsiteX1" fmla="*/ 421745 w 421745"/>
                  <a:gd name="connsiteY1" fmla="*/ 715617 h 729884"/>
                  <a:gd name="connsiteX2" fmla="*/ 421745 w 421745"/>
                  <a:gd name="connsiteY2" fmla="*/ 39756 h 729884"/>
                  <a:gd name="connsiteX3" fmla="*/ 421745 w 421745"/>
                  <a:gd name="connsiteY3" fmla="*/ 39756 h 729884"/>
                  <a:gd name="connsiteX4" fmla="*/ 342232 w 421745"/>
                  <a:gd name="connsiteY4" fmla="*/ 9939 h 729884"/>
                  <a:gd name="connsiteX5" fmla="*/ 312415 w 421745"/>
                  <a:gd name="connsiteY5" fmla="*/ 0 h 729884"/>
                  <a:gd name="connsiteX6" fmla="*/ 123571 w 421745"/>
                  <a:gd name="connsiteY6" fmla="*/ 9939 h 729884"/>
                  <a:gd name="connsiteX7" fmla="*/ 73876 w 421745"/>
                  <a:gd name="connsiteY7" fmla="*/ 19878 h 729884"/>
                  <a:gd name="connsiteX8" fmla="*/ 14241 w 421745"/>
                  <a:gd name="connsiteY8" fmla="*/ 39756 h 729884"/>
                  <a:gd name="connsiteX9" fmla="*/ 14241 w 421745"/>
                  <a:gd name="connsiteY9" fmla="*/ 188843 h 729884"/>
                  <a:gd name="connsiteX10" fmla="*/ 44058 w 421745"/>
                  <a:gd name="connsiteY10" fmla="*/ 208721 h 729884"/>
                  <a:gd name="connsiteX11" fmla="*/ 93754 w 421745"/>
                  <a:gd name="connsiteY11" fmla="*/ 258417 h 729884"/>
                  <a:gd name="connsiteX12" fmla="*/ 133510 w 421745"/>
                  <a:gd name="connsiteY12" fmla="*/ 298174 h 729884"/>
                  <a:gd name="connsiteX13" fmla="*/ 183206 w 421745"/>
                  <a:gd name="connsiteY13" fmla="*/ 347869 h 729884"/>
                  <a:gd name="connsiteX14" fmla="*/ 203084 w 421745"/>
                  <a:gd name="connsiteY14" fmla="*/ 377687 h 729884"/>
                  <a:gd name="connsiteX15" fmla="*/ 222963 w 421745"/>
                  <a:gd name="connsiteY15" fmla="*/ 397565 h 729884"/>
                  <a:gd name="connsiteX16" fmla="*/ 232902 w 421745"/>
                  <a:gd name="connsiteY16" fmla="*/ 447261 h 729884"/>
                  <a:gd name="connsiteX17" fmla="*/ 262719 w 421745"/>
                  <a:gd name="connsiteY17" fmla="*/ 655982 h 729884"/>
                  <a:gd name="connsiteX18" fmla="*/ 332293 w 421745"/>
                  <a:gd name="connsiteY18" fmla="*/ 705678 h 729884"/>
                  <a:gd name="connsiteX19" fmla="*/ 362110 w 421745"/>
                  <a:gd name="connsiteY19" fmla="*/ 725556 h 729884"/>
                  <a:gd name="connsiteX20" fmla="*/ 421745 w 421745"/>
                  <a:gd name="connsiteY20" fmla="*/ 715617 h 7298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21745" h="729884">
                    <a:moveTo>
                      <a:pt x="421745" y="715617"/>
                    </a:moveTo>
                    <a:lnTo>
                      <a:pt x="421745" y="715617"/>
                    </a:lnTo>
                    <a:lnTo>
                      <a:pt x="421745" y="39756"/>
                    </a:lnTo>
                    <a:lnTo>
                      <a:pt x="421745" y="39756"/>
                    </a:lnTo>
                    <a:lnTo>
                      <a:pt x="342232" y="9939"/>
                    </a:lnTo>
                    <a:cubicBezTo>
                      <a:pt x="332386" y="6359"/>
                      <a:pt x="322892" y="0"/>
                      <a:pt x="312415" y="0"/>
                    </a:cubicBezTo>
                    <a:cubicBezTo>
                      <a:pt x="249380" y="0"/>
                      <a:pt x="186519" y="6626"/>
                      <a:pt x="123571" y="9939"/>
                    </a:cubicBezTo>
                    <a:cubicBezTo>
                      <a:pt x="107006" y="13252"/>
                      <a:pt x="90174" y="15433"/>
                      <a:pt x="73876" y="19878"/>
                    </a:cubicBezTo>
                    <a:cubicBezTo>
                      <a:pt x="53661" y="25391"/>
                      <a:pt x="14241" y="39756"/>
                      <a:pt x="14241" y="39756"/>
                    </a:cubicBezTo>
                    <a:cubicBezTo>
                      <a:pt x="-114" y="97176"/>
                      <a:pt x="-8881" y="113696"/>
                      <a:pt x="14241" y="188843"/>
                    </a:cubicBezTo>
                    <a:cubicBezTo>
                      <a:pt x="17754" y="200260"/>
                      <a:pt x="35068" y="200855"/>
                      <a:pt x="44058" y="208721"/>
                    </a:cubicBezTo>
                    <a:cubicBezTo>
                      <a:pt x="61689" y="224148"/>
                      <a:pt x="77189" y="241852"/>
                      <a:pt x="93754" y="258417"/>
                    </a:cubicBezTo>
                    <a:cubicBezTo>
                      <a:pt x="107006" y="271669"/>
                      <a:pt x="123114" y="282580"/>
                      <a:pt x="133510" y="298174"/>
                    </a:cubicBezTo>
                    <a:cubicBezTo>
                      <a:pt x="160015" y="337930"/>
                      <a:pt x="143450" y="321365"/>
                      <a:pt x="183206" y="347869"/>
                    </a:cubicBezTo>
                    <a:cubicBezTo>
                      <a:pt x="189832" y="357808"/>
                      <a:pt x="195622" y="368359"/>
                      <a:pt x="203084" y="377687"/>
                    </a:cubicBezTo>
                    <a:cubicBezTo>
                      <a:pt x="208938" y="385004"/>
                      <a:pt x="219272" y="388952"/>
                      <a:pt x="222963" y="397565"/>
                    </a:cubicBezTo>
                    <a:cubicBezTo>
                      <a:pt x="229618" y="413092"/>
                      <a:pt x="229589" y="430696"/>
                      <a:pt x="232902" y="447261"/>
                    </a:cubicBezTo>
                    <a:cubicBezTo>
                      <a:pt x="232938" y="447724"/>
                      <a:pt x="239953" y="633216"/>
                      <a:pt x="262719" y="655982"/>
                    </a:cubicBezTo>
                    <a:cubicBezTo>
                      <a:pt x="338266" y="731529"/>
                      <a:pt x="268831" y="673947"/>
                      <a:pt x="332293" y="705678"/>
                    </a:cubicBezTo>
                    <a:cubicBezTo>
                      <a:pt x="342977" y="711020"/>
                      <a:pt x="351426" y="720214"/>
                      <a:pt x="362110" y="725556"/>
                    </a:cubicBezTo>
                    <a:cubicBezTo>
                      <a:pt x="371481" y="730241"/>
                      <a:pt x="391928" y="735495"/>
                      <a:pt x="421745" y="715617"/>
                    </a:cubicBezTo>
                    <a:close/>
                  </a:path>
                </a:pathLst>
              </a:cu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</p:grpSp>
        <p:sp>
          <p:nvSpPr>
            <p:cNvPr id="233" name="フリーフォーム: 図形 232">
              <a:extLst>
                <a:ext uri="{FF2B5EF4-FFF2-40B4-BE49-F238E27FC236}">
                  <a16:creationId xmlns:a16="http://schemas.microsoft.com/office/drawing/2014/main" id="{7CB5D21B-1CC1-493A-9CB1-C86A7288010A}"/>
                </a:ext>
              </a:extLst>
            </p:cNvPr>
            <p:cNvSpPr>
              <a:spLocks noChangeAspect="1"/>
            </p:cNvSpPr>
            <p:nvPr/>
          </p:nvSpPr>
          <p:spPr>
            <a:xfrm rot="1932916">
              <a:off x="10581850" y="5179394"/>
              <a:ext cx="274290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34" name="フリーフォーム: 図形 233">
              <a:extLst>
                <a:ext uri="{FF2B5EF4-FFF2-40B4-BE49-F238E27FC236}">
                  <a16:creationId xmlns:a16="http://schemas.microsoft.com/office/drawing/2014/main" id="{BFADBC5D-8B08-49D0-88F7-000071C8D5F0}"/>
                </a:ext>
              </a:extLst>
            </p:cNvPr>
            <p:cNvSpPr>
              <a:spLocks noChangeAspect="1"/>
            </p:cNvSpPr>
            <p:nvPr/>
          </p:nvSpPr>
          <p:spPr>
            <a:xfrm rot="18026397">
              <a:off x="9417628" y="5272985"/>
              <a:ext cx="274290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35" name="フリーフォーム: 図形 234">
              <a:extLst>
                <a:ext uri="{FF2B5EF4-FFF2-40B4-BE49-F238E27FC236}">
                  <a16:creationId xmlns:a16="http://schemas.microsoft.com/office/drawing/2014/main" id="{87751441-AF66-4627-B6BF-881BB16D30A4}"/>
                </a:ext>
              </a:extLst>
            </p:cNvPr>
            <p:cNvSpPr>
              <a:spLocks noChangeAspect="1"/>
            </p:cNvSpPr>
            <p:nvPr/>
          </p:nvSpPr>
          <p:spPr>
            <a:xfrm rot="13130338">
              <a:off x="9645564" y="6128240"/>
              <a:ext cx="274289" cy="283058"/>
            </a:xfrm>
            <a:custGeom>
              <a:avLst/>
              <a:gdLst>
                <a:gd name="connsiteX0" fmla="*/ 39873 w 1502478"/>
                <a:gd name="connsiteY0" fmla="*/ 0 h 1550504"/>
                <a:gd name="connsiteX1" fmla="*/ 39873 w 1502478"/>
                <a:gd name="connsiteY1" fmla="*/ 0 h 1550504"/>
                <a:gd name="connsiteX2" fmla="*/ 298290 w 1502478"/>
                <a:gd name="connsiteY2" fmla="*/ 9939 h 1550504"/>
                <a:gd name="connsiteX3" fmla="*/ 328108 w 1502478"/>
                <a:gd name="connsiteY3" fmla="*/ 19878 h 1550504"/>
                <a:gd name="connsiteX4" fmla="*/ 357925 w 1502478"/>
                <a:gd name="connsiteY4" fmla="*/ 39756 h 1550504"/>
                <a:gd name="connsiteX5" fmla="*/ 377803 w 1502478"/>
                <a:gd name="connsiteY5" fmla="*/ 79513 h 1550504"/>
                <a:gd name="connsiteX6" fmla="*/ 397682 w 1502478"/>
                <a:gd name="connsiteY6" fmla="*/ 99391 h 1550504"/>
                <a:gd name="connsiteX7" fmla="*/ 417560 w 1502478"/>
                <a:gd name="connsiteY7" fmla="*/ 129208 h 1550504"/>
                <a:gd name="connsiteX8" fmla="*/ 457316 w 1502478"/>
                <a:gd name="connsiteY8" fmla="*/ 178904 h 1550504"/>
                <a:gd name="connsiteX9" fmla="*/ 467255 w 1502478"/>
                <a:gd name="connsiteY9" fmla="*/ 208721 h 1550504"/>
                <a:gd name="connsiteX10" fmla="*/ 507012 w 1502478"/>
                <a:gd name="connsiteY10" fmla="*/ 268356 h 1550504"/>
                <a:gd name="connsiteX11" fmla="*/ 546768 w 1502478"/>
                <a:gd name="connsiteY11" fmla="*/ 337930 h 1550504"/>
                <a:gd name="connsiteX12" fmla="*/ 576586 w 1502478"/>
                <a:gd name="connsiteY12" fmla="*/ 357808 h 1550504"/>
                <a:gd name="connsiteX13" fmla="*/ 596464 w 1502478"/>
                <a:gd name="connsiteY13" fmla="*/ 377687 h 1550504"/>
                <a:gd name="connsiteX14" fmla="*/ 656099 w 1502478"/>
                <a:gd name="connsiteY14" fmla="*/ 397565 h 1550504"/>
                <a:gd name="connsiteX15" fmla="*/ 914516 w 1502478"/>
                <a:gd name="connsiteY15" fmla="*/ 387626 h 1550504"/>
                <a:gd name="connsiteX16" fmla="*/ 954273 w 1502478"/>
                <a:gd name="connsiteY16" fmla="*/ 337930 h 1550504"/>
                <a:gd name="connsiteX17" fmla="*/ 974151 w 1502478"/>
                <a:gd name="connsiteY17" fmla="*/ 278295 h 1550504"/>
                <a:gd name="connsiteX18" fmla="*/ 994029 w 1502478"/>
                <a:gd name="connsiteY18" fmla="*/ 238539 h 1550504"/>
                <a:gd name="connsiteX19" fmla="*/ 1003968 w 1502478"/>
                <a:gd name="connsiteY19" fmla="*/ 208721 h 1550504"/>
                <a:gd name="connsiteX20" fmla="*/ 1023847 w 1502478"/>
                <a:gd name="connsiteY20" fmla="*/ 178904 h 1550504"/>
                <a:gd name="connsiteX21" fmla="*/ 1053664 w 1502478"/>
                <a:gd name="connsiteY21" fmla="*/ 129208 h 1550504"/>
                <a:gd name="connsiteX22" fmla="*/ 1073542 w 1502478"/>
                <a:gd name="connsiteY22" fmla="*/ 99391 h 1550504"/>
                <a:gd name="connsiteX23" fmla="*/ 1143116 w 1502478"/>
                <a:gd name="connsiteY23" fmla="*/ 69574 h 1550504"/>
                <a:gd name="connsiteX24" fmla="*/ 1162995 w 1502478"/>
                <a:gd name="connsiteY24" fmla="*/ 49695 h 1550504"/>
                <a:gd name="connsiteX25" fmla="*/ 1192812 w 1502478"/>
                <a:gd name="connsiteY25" fmla="*/ 39756 h 1550504"/>
                <a:gd name="connsiteX26" fmla="*/ 1451229 w 1502478"/>
                <a:gd name="connsiteY26" fmla="*/ 49695 h 1550504"/>
                <a:gd name="connsiteX27" fmla="*/ 1500925 w 1502478"/>
                <a:gd name="connsiteY27" fmla="*/ 79513 h 1550504"/>
                <a:gd name="connsiteX28" fmla="*/ 1481047 w 1502478"/>
                <a:gd name="connsiteY28" fmla="*/ 318052 h 1550504"/>
                <a:gd name="connsiteX29" fmla="*/ 1451229 w 1502478"/>
                <a:gd name="connsiteY29" fmla="*/ 407504 h 1550504"/>
                <a:gd name="connsiteX30" fmla="*/ 1441290 w 1502478"/>
                <a:gd name="connsiteY30" fmla="*/ 437321 h 1550504"/>
                <a:gd name="connsiteX31" fmla="*/ 1411473 w 1502478"/>
                <a:gd name="connsiteY31" fmla="*/ 496956 h 1550504"/>
                <a:gd name="connsiteX32" fmla="*/ 1371716 w 1502478"/>
                <a:gd name="connsiteY32" fmla="*/ 556591 h 1550504"/>
                <a:gd name="connsiteX33" fmla="*/ 1341899 w 1502478"/>
                <a:gd name="connsiteY33" fmla="*/ 616226 h 1550504"/>
                <a:gd name="connsiteX34" fmla="*/ 1331960 w 1502478"/>
                <a:gd name="connsiteY34" fmla="*/ 646043 h 1550504"/>
                <a:gd name="connsiteX35" fmla="*/ 1312082 w 1502478"/>
                <a:gd name="connsiteY35" fmla="*/ 685800 h 1550504"/>
                <a:gd name="connsiteX36" fmla="*/ 1282264 w 1502478"/>
                <a:gd name="connsiteY36" fmla="*/ 745434 h 1550504"/>
                <a:gd name="connsiteX37" fmla="*/ 1262386 w 1502478"/>
                <a:gd name="connsiteY37" fmla="*/ 805069 h 1550504"/>
                <a:gd name="connsiteX38" fmla="*/ 1242508 w 1502478"/>
                <a:gd name="connsiteY38" fmla="*/ 834887 h 1550504"/>
                <a:gd name="connsiteX39" fmla="*/ 1232568 w 1502478"/>
                <a:gd name="connsiteY39" fmla="*/ 864704 h 1550504"/>
                <a:gd name="connsiteX40" fmla="*/ 1192812 w 1502478"/>
                <a:gd name="connsiteY40" fmla="*/ 924339 h 1550504"/>
                <a:gd name="connsiteX41" fmla="*/ 1172934 w 1502478"/>
                <a:gd name="connsiteY41" fmla="*/ 954156 h 1550504"/>
                <a:gd name="connsiteX42" fmla="*/ 1153055 w 1502478"/>
                <a:gd name="connsiteY42" fmla="*/ 983974 h 1550504"/>
                <a:gd name="connsiteX43" fmla="*/ 1123238 w 1502478"/>
                <a:gd name="connsiteY43" fmla="*/ 1043608 h 1550504"/>
                <a:gd name="connsiteX44" fmla="*/ 1103360 w 1502478"/>
                <a:gd name="connsiteY44" fmla="*/ 1113182 h 1550504"/>
                <a:gd name="connsiteX45" fmla="*/ 1083482 w 1502478"/>
                <a:gd name="connsiteY45" fmla="*/ 1222513 h 1550504"/>
                <a:gd name="connsiteX46" fmla="*/ 1063603 w 1502478"/>
                <a:gd name="connsiteY46" fmla="*/ 1421295 h 1550504"/>
                <a:gd name="connsiteX47" fmla="*/ 1043725 w 1502478"/>
                <a:gd name="connsiteY47" fmla="*/ 1480930 h 1550504"/>
                <a:gd name="connsiteX48" fmla="*/ 974151 w 1502478"/>
                <a:gd name="connsiteY48" fmla="*/ 1530626 h 1550504"/>
                <a:gd name="connsiteX49" fmla="*/ 914516 w 1502478"/>
                <a:gd name="connsiteY49" fmla="*/ 1550504 h 1550504"/>
                <a:gd name="connsiteX50" fmla="*/ 596464 w 1502478"/>
                <a:gd name="connsiteY50" fmla="*/ 1540565 h 1550504"/>
                <a:gd name="connsiteX51" fmla="*/ 487134 w 1502478"/>
                <a:gd name="connsiteY51" fmla="*/ 1520687 h 1550504"/>
                <a:gd name="connsiteX52" fmla="*/ 457316 w 1502478"/>
                <a:gd name="connsiteY52" fmla="*/ 1500808 h 1550504"/>
                <a:gd name="connsiteX53" fmla="*/ 427499 w 1502478"/>
                <a:gd name="connsiteY53" fmla="*/ 1441174 h 1550504"/>
                <a:gd name="connsiteX54" fmla="*/ 407621 w 1502478"/>
                <a:gd name="connsiteY54" fmla="*/ 1411356 h 1550504"/>
                <a:gd name="connsiteX55" fmla="*/ 397682 w 1502478"/>
                <a:gd name="connsiteY55" fmla="*/ 1371600 h 1550504"/>
                <a:gd name="connsiteX56" fmla="*/ 387742 w 1502478"/>
                <a:gd name="connsiteY56" fmla="*/ 1341782 h 1550504"/>
                <a:gd name="connsiteX57" fmla="*/ 367864 w 1502478"/>
                <a:gd name="connsiteY57" fmla="*/ 1083365 h 1550504"/>
                <a:gd name="connsiteX58" fmla="*/ 347986 w 1502478"/>
                <a:gd name="connsiteY58" fmla="*/ 1013791 h 1550504"/>
                <a:gd name="connsiteX59" fmla="*/ 338047 w 1502478"/>
                <a:gd name="connsiteY59" fmla="*/ 974034 h 1550504"/>
                <a:gd name="connsiteX60" fmla="*/ 318168 w 1502478"/>
                <a:gd name="connsiteY60" fmla="*/ 914400 h 1550504"/>
                <a:gd name="connsiteX61" fmla="*/ 308229 w 1502478"/>
                <a:gd name="connsiteY61" fmla="*/ 874643 h 1550504"/>
                <a:gd name="connsiteX62" fmla="*/ 288351 w 1502478"/>
                <a:gd name="connsiteY62" fmla="*/ 834887 h 1550504"/>
                <a:gd name="connsiteX63" fmla="*/ 278412 w 1502478"/>
                <a:gd name="connsiteY63" fmla="*/ 755374 h 1550504"/>
                <a:gd name="connsiteX64" fmla="*/ 258534 w 1502478"/>
                <a:gd name="connsiteY64" fmla="*/ 665921 h 1550504"/>
                <a:gd name="connsiteX65" fmla="*/ 238655 w 1502478"/>
                <a:gd name="connsiteY65" fmla="*/ 606287 h 1550504"/>
                <a:gd name="connsiteX66" fmla="*/ 218777 w 1502478"/>
                <a:gd name="connsiteY66" fmla="*/ 536713 h 1550504"/>
                <a:gd name="connsiteX67" fmla="*/ 198899 w 1502478"/>
                <a:gd name="connsiteY67" fmla="*/ 506895 h 1550504"/>
                <a:gd name="connsiteX68" fmla="*/ 188960 w 1502478"/>
                <a:gd name="connsiteY68" fmla="*/ 477078 h 1550504"/>
                <a:gd name="connsiteX69" fmla="*/ 149203 w 1502478"/>
                <a:gd name="connsiteY69" fmla="*/ 417443 h 1550504"/>
                <a:gd name="connsiteX70" fmla="*/ 129325 w 1502478"/>
                <a:gd name="connsiteY70" fmla="*/ 387626 h 1550504"/>
                <a:gd name="connsiteX71" fmla="*/ 109447 w 1502478"/>
                <a:gd name="connsiteY71" fmla="*/ 367747 h 1550504"/>
                <a:gd name="connsiteX72" fmla="*/ 69690 w 1502478"/>
                <a:gd name="connsiteY72" fmla="*/ 298174 h 1550504"/>
                <a:gd name="connsiteX73" fmla="*/ 49812 w 1502478"/>
                <a:gd name="connsiteY73" fmla="*/ 278295 h 1550504"/>
                <a:gd name="connsiteX74" fmla="*/ 39873 w 1502478"/>
                <a:gd name="connsiteY74" fmla="*/ 248478 h 1550504"/>
                <a:gd name="connsiteX75" fmla="*/ 10055 w 1502478"/>
                <a:gd name="connsiteY75" fmla="*/ 218661 h 1550504"/>
                <a:gd name="connsiteX76" fmla="*/ 116 w 1502478"/>
                <a:gd name="connsiteY76" fmla="*/ 159026 h 1550504"/>
                <a:gd name="connsiteX77" fmla="*/ 39873 w 1502478"/>
                <a:gd name="connsiteY77" fmla="*/ 0 h 15505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</a:cxnLst>
              <a:rect l="l" t="t" r="r" b="b"/>
              <a:pathLst>
                <a:path w="1502478" h="1550504">
                  <a:moveTo>
                    <a:pt x="39873" y="0"/>
                  </a:moveTo>
                  <a:lnTo>
                    <a:pt x="39873" y="0"/>
                  </a:lnTo>
                  <a:cubicBezTo>
                    <a:pt x="126012" y="3313"/>
                    <a:pt x="212292" y="4008"/>
                    <a:pt x="298290" y="9939"/>
                  </a:cubicBezTo>
                  <a:cubicBezTo>
                    <a:pt x="308742" y="10660"/>
                    <a:pt x="318737" y="15193"/>
                    <a:pt x="328108" y="19878"/>
                  </a:cubicBezTo>
                  <a:cubicBezTo>
                    <a:pt x="338792" y="25220"/>
                    <a:pt x="347986" y="33130"/>
                    <a:pt x="357925" y="39756"/>
                  </a:cubicBezTo>
                  <a:cubicBezTo>
                    <a:pt x="364551" y="53008"/>
                    <a:pt x="369584" y="67185"/>
                    <a:pt x="377803" y="79513"/>
                  </a:cubicBezTo>
                  <a:cubicBezTo>
                    <a:pt x="383001" y="87310"/>
                    <a:pt x="391828" y="92074"/>
                    <a:pt x="397682" y="99391"/>
                  </a:cubicBezTo>
                  <a:cubicBezTo>
                    <a:pt x="405144" y="108719"/>
                    <a:pt x="410934" y="119269"/>
                    <a:pt x="417560" y="129208"/>
                  </a:cubicBezTo>
                  <a:cubicBezTo>
                    <a:pt x="442542" y="204155"/>
                    <a:pt x="405938" y="114681"/>
                    <a:pt x="457316" y="178904"/>
                  </a:cubicBezTo>
                  <a:cubicBezTo>
                    <a:pt x="463861" y="187085"/>
                    <a:pt x="462167" y="199563"/>
                    <a:pt x="467255" y="208721"/>
                  </a:cubicBezTo>
                  <a:cubicBezTo>
                    <a:pt x="478857" y="229605"/>
                    <a:pt x="496328" y="246987"/>
                    <a:pt x="507012" y="268356"/>
                  </a:cubicBezTo>
                  <a:cubicBezTo>
                    <a:pt x="514807" y="283947"/>
                    <a:pt x="532719" y="323882"/>
                    <a:pt x="546768" y="337930"/>
                  </a:cubicBezTo>
                  <a:cubicBezTo>
                    <a:pt x="555215" y="346377"/>
                    <a:pt x="567258" y="350346"/>
                    <a:pt x="576586" y="357808"/>
                  </a:cubicBezTo>
                  <a:cubicBezTo>
                    <a:pt x="583903" y="363662"/>
                    <a:pt x="588083" y="373496"/>
                    <a:pt x="596464" y="377687"/>
                  </a:cubicBezTo>
                  <a:cubicBezTo>
                    <a:pt x="615205" y="387058"/>
                    <a:pt x="656099" y="397565"/>
                    <a:pt x="656099" y="397565"/>
                  </a:cubicBezTo>
                  <a:cubicBezTo>
                    <a:pt x="742238" y="394252"/>
                    <a:pt x="828804" y="396810"/>
                    <a:pt x="914516" y="387626"/>
                  </a:cubicBezTo>
                  <a:cubicBezTo>
                    <a:pt x="924154" y="386593"/>
                    <a:pt x="953018" y="340754"/>
                    <a:pt x="954273" y="337930"/>
                  </a:cubicBezTo>
                  <a:cubicBezTo>
                    <a:pt x="962783" y="318782"/>
                    <a:pt x="964780" y="297036"/>
                    <a:pt x="974151" y="278295"/>
                  </a:cubicBezTo>
                  <a:cubicBezTo>
                    <a:pt x="980777" y="265043"/>
                    <a:pt x="988193" y="252157"/>
                    <a:pt x="994029" y="238539"/>
                  </a:cubicBezTo>
                  <a:cubicBezTo>
                    <a:pt x="998156" y="228909"/>
                    <a:pt x="999283" y="218092"/>
                    <a:pt x="1003968" y="208721"/>
                  </a:cubicBezTo>
                  <a:cubicBezTo>
                    <a:pt x="1009310" y="198037"/>
                    <a:pt x="1017221" y="188843"/>
                    <a:pt x="1023847" y="178904"/>
                  </a:cubicBezTo>
                  <a:cubicBezTo>
                    <a:pt x="1041107" y="127124"/>
                    <a:pt x="1022480" y="168188"/>
                    <a:pt x="1053664" y="129208"/>
                  </a:cubicBezTo>
                  <a:cubicBezTo>
                    <a:pt x="1061126" y="119880"/>
                    <a:pt x="1064365" y="107038"/>
                    <a:pt x="1073542" y="99391"/>
                  </a:cubicBezTo>
                  <a:cubicBezTo>
                    <a:pt x="1089917" y="85745"/>
                    <a:pt x="1122402" y="76479"/>
                    <a:pt x="1143116" y="69574"/>
                  </a:cubicBezTo>
                  <a:cubicBezTo>
                    <a:pt x="1149742" y="62948"/>
                    <a:pt x="1154959" y="54516"/>
                    <a:pt x="1162995" y="49695"/>
                  </a:cubicBezTo>
                  <a:cubicBezTo>
                    <a:pt x="1171979" y="44305"/>
                    <a:pt x="1182335" y="39756"/>
                    <a:pt x="1192812" y="39756"/>
                  </a:cubicBezTo>
                  <a:cubicBezTo>
                    <a:pt x="1279015" y="39756"/>
                    <a:pt x="1365090" y="46382"/>
                    <a:pt x="1451229" y="49695"/>
                  </a:cubicBezTo>
                  <a:cubicBezTo>
                    <a:pt x="1460369" y="52741"/>
                    <a:pt x="1500085" y="61041"/>
                    <a:pt x="1500925" y="79513"/>
                  </a:cubicBezTo>
                  <a:cubicBezTo>
                    <a:pt x="1504215" y="151898"/>
                    <a:pt x="1504212" y="242767"/>
                    <a:pt x="1481047" y="318052"/>
                  </a:cubicBezTo>
                  <a:cubicBezTo>
                    <a:pt x="1471804" y="348092"/>
                    <a:pt x="1461168" y="377687"/>
                    <a:pt x="1451229" y="407504"/>
                  </a:cubicBezTo>
                  <a:cubicBezTo>
                    <a:pt x="1447916" y="417443"/>
                    <a:pt x="1447101" y="428604"/>
                    <a:pt x="1441290" y="437321"/>
                  </a:cubicBezTo>
                  <a:cubicBezTo>
                    <a:pt x="1353028" y="569719"/>
                    <a:pt x="1480068" y="373486"/>
                    <a:pt x="1411473" y="496956"/>
                  </a:cubicBezTo>
                  <a:cubicBezTo>
                    <a:pt x="1399871" y="517840"/>
                    <a:pt x="1371716" y="556591"/>
                    <a:pt x="1371716" y="556591"/>
                  </a:cubicBezTo>
                  <a:cubicBezTo>
                    <a:pt x="1346734" y="631536"/>
                    <a:pt x="1380433" y="539157"/>
                    <a:pt x="1341899" y="616226"/>
                  </a:cubicBezTo>
                  <a:cubicBezTo>
                    <a:pt x="1337214" y="625597"/>
                    <a:pt x="1336087" y="636413"/>
                    <a:pt x="1331960" y="646043"/>
                  </a:cubicBezTo>
                  <a:cubicBezTo>
                    <a:pt x="1326124" y="659662"/>
                    <a:pt x="1317919" y="672182"/>
                    <a:pt x="1312082" y="685800"/>
                  </a:cubicBezTo>
                  <a:cubicBezTo>
                    <a:pt x="1287394" y="743405"/>
                    <a:pt x="1320462" y="688137"/>
                    <a:pt x="1282264" y="745434"/>
                  </a:cubicBezTo>
                  <a:cubicBezTo>
                    <a:pt x="1275638" y="765312"/>
                    <a:pt x="1274009" y="787634"/>
                    <a:pt x="1262386" y="805069"/>
                  </a:cubicBezTo>
                  <a:cubicBezTo>
                    <a:pt x="1255760" y="815008"/>
                    <a:pt x="1247850" y="824203"/>
                    <a:pt x="1242508" y="834887"/>
                  </a:cubicBezTo>
                  <a:cubicBezTo>
                    <a:pt x="1237823" y="844258"/>
                    <a:pt x="1237656" y="855546"/>
                    <a:pt x="1232568" y="864704"/>
                  </a:cubicBezTo>
                  <a:cubicBezTo>
                    <a:pt x="1220966" y="885588"/>
                    <a:pt x="1206064" y="904461"/>
                    <a:pt x="1192812" y="924339"/>
                  </a:cubicBezTo>
                  <a:lnTo>
                    <a:pt x="1172934" y="954156"/>
                  </a:lnTo>
                  <a:lnTo>
                    <a:pt x="1153055" y="983974"/>
                  </a:lnTo>
                  <a:cubicBezTo>
                    <a:pt x="1128072" y="1058923"/>
                    <a:pt x="1161773" y="966536"/>
                    <a:pt x="1123238" y="1043608"/>
                  </a:cubicBezTo>
                  <a:cubicBezTo>
                    <a:pt x="1116598" y="1056889"/>
                    <a:pt x="1105907" y="1101719"/>
                    <a:pt x="1103360" y="1113182"/>
                  </a:cubicBezTo>
                  <a:cubicBezTo>
                    <a:pt x="1094100" y="1154855"/>
                    <a:pt x="1090674" y="1179359"/>
                    <a:pt x="1083482" y="1222513"/>
                  </a:cubicBezTo>
                  <a:cubicBezTo>
                    <a:pt x="1079254" y="1285923"/>
                    <a:pt x="1080991" y="1357538"/>
                    <a:pt x="1063603" y="1421295"/>
                  </a:cubicBezTo>
                  <a:cubicBezTo>
                    <a:pt x="1058090" y="1441510"/>
                    <a:pt x="1060488" y="1468358"/>
                    <a:pt x="1043725" y="1480930"/>
                  </a:cubicBezTo>
                  <a:cubicBezTo>
                    <a:pt x="1038393" y="1484929"/>
                    <a:pt x="986035" y="1525344"/>
                    <a:pt x="974151" y="1530626"/>
                  </a:cubicBezTo>
                  <a:cubicBezTo>
                    <a:pt x="955003" y="1539136"/>
                    <a:pt x="914516" y="1550504"/>
                    <a:pt x="914516" y="1550504"/>
                  </a:cubicBezTo>
                  <a:cubicBezTo>
                    <a:pt x="808499" y="1547191"/>
                    <a:pt x="702386" y="1546140"/>
                    <a:pt x="596464" y="1540565"/>
                  </a:cubicBezTo>
                  <a:cubicBezTo>
                    <a:pt x="579205" y="1539657"/>
                    <a:pt x="507100" y="1524680"/>
                    <a:pt x="487134" y="1520687"/>
                  </a:cubicBezTo>
                  <a:cubicBezTo>
                    <a:pt x="477195" y="1514061"/>
                    <a:pt x="465763" y="1509255"/>
                    <a:pt x="457316" y="1500808"/>
                  </a:cubicBezTo>
                  <a:cubicBezTo>
                    <a:pt x="428833" y="1472325"/>
                    <a:pt x="443666" y="1473508"/>
                    <a:pt x="427499" y="1441174"/>
                  </a:cubicBezTo>
                  <a:cubicBezTo>
                    <a:pt x="422157" y="1430490"/>
                    <a:pt x="414247" y="1421295"/>
                    <a:pt x="407621" y="1411356"/>
                  </a:cubicBezTo>
                  <a:cubicBezTo>
                    <a:pt x="404308" y="1398104"/>
                    <a:pt x="401435" y="1384734"/>
                    <a:pt x="397682" y="1371600"/>
                  </a:cubicBezTo>
                  <a:cubicBezTo>
                    <a:pt x="394804" y="1361526"/>
                    <a:pt x="388966" y="1352187"/>
                    <a:pt x="387742" y="1341782"/>
                  </a:cubicBezTo>
                  <a:cubicBezTo>
                    <a:pt x="363034" y="1131772"/>
                    <a:pt x="391897" y="1275629"/>
                    <a:pt x="367864" y="1083365"/>
                  </a:cubicBezTo>
                  <a:cubicBezTo>
                    <a:pt x="364411" y="1055743"/>
                    <a:pt x="355321" y="1039465"/>
                    <a:pt x="347986" y="1013791"/>
                  </a:cubicBezTo>
                  <a:cubicBezTo>
                    <a:pt x="344233" y="1000656"/>
                    <a:pt x="341972" y="987118"/>
                    <a:pt x="338047" y="974034"/>
                  </a:cubicBezTo>
                  <a:cubicBezTo>
                    <a:pt x="332026" y="953964"/>
                    <a:pt x="323250" y="934728"/>
                    <a:pt x="318168" y="914400"/>
                  </a:cubicBezTo>
                  <a:cubicBezTo>
                    <a:pt x="314855" y="901148"/>
                    <a:pt x="313025" y="887433"/>
                    <a:pt x="308229" y="874643"/>
                  </a:cubicBezTo>
                  <a:cubicBezTo>
                    <a:pt x="303027" y="860770"/>
                    <a:pt x="294977" y="848139"/>
                    <a:pt x="288351" y="834887"/>
                  </a:cubicBezTo>
                  <a:cubicBezTo>
                    <a:pt x="285038" y="808383"/>
                    <a:pt x="282473" y="781774"/>
                    <a:pt x="278412" y="755374"/>
                  </a:cubicBezTo>
                  <a:cubicBezTo>
                    <a:pt x="275426" y="735963"/>
                    <a:pt x="264782" y="686747"/>
                    <a:pt x="258534" y="665921"/>
                  </a:cubicBezTo>
                  <a:cubicBezTo>
                    <a:pt x="252513" y="645851"/>
                    <a:pt x="243737" y="626615"/>
                    <a:pt x="238655" y="606287"/>
                  </a:cubicBezTo>
                  <a:cubicBezTo>
                    <a:pt x="235470" y="593548"/>
                    <a:pt x="225907" y="550973"/>
                    <a:pt x="218777" y="536713"/>
                  </a:cubicBezTo>
                  <a:cubicBezTo>
                    <a:pt x="213435" y="526029"/>
                    <a:pt x="204241" y="517579"/>
                    <a:pt x="198899" y="506895"/>
                  </a:cubicBezTo>
                  <a:cubicBezTo>
                    <a:pt x="194214" y="497524"/>
                    <a:pt x="194048" y="486236"/>
                    <a:pt x="188960" y="477078"/>
                  </a:cubicBezTo>
                  <a:cubicBezTo>
                    <a:pt x="177358" y="456194"/>
                    <a:pt x="162455" y="437321"/>
                    <a:pt x="149203" y="417443"/>
                  </a:cubicBezTo>
                  <a:cubicBezTo>
                    <a:pt x="142577" y="407504"/>
                    <a:pt x="137771" y="396073"/>
                    <a:pt x="129325" y="387626"/>
                  </a:cubicBezTo>
                  <a:cubicBezTo>
                    <a:pt x="122699" y="381000"/>
                    <a:pt x="115301" y="375064"/>
                    <a:pt x="109447" y="367747"/>
                  </a:cubicBezTo>
                  <a:cubicBezTo>
                    <a:pt x="68776" y="316908"/>
                    <a:pt x="110505" y="359398"/>
                    <a:pt x="69690" y="298174"/>
                  </a:cubicBezTo>
                  <a:cubicBezTo>
                    <a:pt x="64492" y="290377"/>
                    <a:pt x="56438" y="284921"/>
                    <a:pt x="49812" y="278295"/>
                  </a:cubicBezTo>
                  <a:cubicBezTo>
                    <a:pt x="46499" y="268356"/>
                    <a:pt x="45684" y="257195"/>
                    <a:pt x="39873" y="248478"/>
                  </a:cubicBezTo>
                  <a:cubicBezTo>
                    <a:pt x="32076" y="236783"/>
                    <a:pt x="15764" y="231506"/>
                    <a:pt x="10055" y="218661"/>
                  </a:cubicBezTo>
                  <a:cubicBezTo>
                    <a:pt x="1870" y="200245"/>
                    <a:pt x="1031" y="179158"/>
                    <a:pt x="116" y="159026"/>
                  </a:cubicBezTo>
                  <a:cubicBezTo>
                    <a:pt x="-2291" y="106072"/>
                    <a:pt x="33247" y="26504"/>
                    <a:pt x="39873" y="0"/>
                  </a:cubicBezTo>
                  <a:close/>
                </a:path>
              </a:pathLst>
            </a:custGeom>
            <a:solidFill>
              <a:srgbClr val="FF00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236" name="フリーフォーム: 図形 235">
              <a:extLst>
                <a:ext uri="{FF2B5EF4-FFF2-40B4-BE49-F238E27FC236}">
                  <a16:creationId xmlns:a16="http://schemas.microsoft.com/office/drawing/2014/main" id="{A78CE9EC-1820-4106-87E9-808613805AA0}"/>
                </a:ext>
              </a:extLst>
            </p:cNvPr>
            <p:cNvSpPr/>
            <p:nvPr/>
          </p:nvSpPr>
          <p:spPr>
            <a:xfrm>
              <a:off x="9759639" y="5329216"/>
              <a:ext cx="337374" cy="320633"/>
            </a:xfrm>
            <a:custGeom>
              <a:avLst/>
              <a:gdLst>
                <a:gd name="connsiteX0" fmla="*/ 0 w 467139"/>
                <a:gd name="connsiteY0" fmla="*/ 427382 h 427382"/>
                <a:gd name="connsiteX1" fmla="*/ 9939 w 467139"/>
                <a:gd name="connsiteY1" fmla="*/ 377687 h 427382"/>
                <a:gd name="connsiteX2" fmla="*/ 19878 w 467139"/>
                <a:gd name="connsiteY2" fmla="*/ 258417 h 427382"/>
                <a:gd name="connsiteX3" fmla="*/ 29817 w 467139"/>
                <a:gd name="connsiteY3" fmla="*/ 218661 h 427382"/>
                <a:gd name="connsiteX4" fmla="*/ 49696 w 467139"/>
                <a:gd name="connsiteY4" fmla="*/ 198782 h 427382"/>
                <a:gd name="connsiteX5" fmla="*/ 119269 w 467139"/>
                <a:gd name="connsiteY5" fmla="*/ 168965 h 427382"/>
                <a:gd name="connsiteX6" fmla="*/ 168965 w 467139"/>
                <a:gd name="connsiteY6" fmla="*/ 159026 h 427382"/>
                <a:gd name="connsiteX7" fmla="*/ 278296 w 467139"/>
                <a:gd name="connsiteY7" fmla="*/ 198782 h 427382"/>
                <a:gd name="connsiteX8" fmla="*/ 288235 w 467139"/>
                <a:gd name="connsiteY8" fmla="*/ 228600 h 427382"/>
                <a:gd name="connsiteX9" fmla="*/ 278296 w 467139"/>
                <a:gd name="connsiteY9" fmla="*/ 318052 h 427382"/>
                <a:gd name="connsiteX10" fmla="*/ 228600 w 467139"/>
                <a:gd name="connsiteY10" fmla="*/ 327991 h 427382"/>
                <a:gd name="connsiteX11" fmla="*/ 188843 w 467139"/>
                <a:gd name="connsiteY11" fmla="*/ 308113 h 427382"/>
                <a:gd name="connsiteX12" fmla="*/ 168965 w 467139"/>
                <a:gd name="connsiteY12" fmla="*/ 288234 h 427382"/>
                <a:gd name="connsiteX13" fmla="*/ 139148 w 467139"/>
                <a:gd name="connsiteY13" fmla="*/ 268356 h 427382"/>
                <a:gd name="connsiteX14" fmla="*/ 129209 w 467139"/>
                <a:gd name="connsiteY14" fmla="*/ 238539 h 427382"/>
                <a:gd name="connsiteX15" fmla="*/ 168965 w 467139"/>
                <a:gd name="connsiteY15" fmla="*/ 99391 h 427382"/>
                <a:gd name="connsiteX16" fmla="*/ 198783 w 467139"/>
                <a:gd name="connsiteY16" fmla="*/ 79513 h 427382"/>
                <a:gd name="connsiteX17" fmla="*/ 258417 w 467139"/>
                <a:gd name="connsiteY17" fmla="*/ 89452 h 427382"/>
                <a:gd name="connsiteX18" fmla="*/ 218661 w 467139"/>
                <a:gd name="connsiteY18" fmla="*/ 208721 h 427382"/>
                <a:gd name="connsiteX19" fmla="*/ 198783 w 467139"/>
                <a:gd name="connsiteY19" fmla="*/ 178904 h 427382"/>
                <a:gd name="connsiteX20" fmla="*/ 178904 w 467139"/>
                <a:gd name="connsiteY20" fmla="*/ 159026 h 427382"/>
                <a:gd name="connsiteX21" fmla="*/ 228600 w 467139"/>
                <a:gd name="connsiteY21" fmla="*/ 39756 h 427382"/>
                <a:gd name="connsiteX22" fmla="*/ 288235 w 467139"/>
                <a:gd name="connsiteY22" fmla="*/ 29817 h 427382"/>
                <a:gd name="connsiteX23" fmla="*/ 357809 w 467139"/>
                <a:gd name="connsiteY23" fmla="*/ 39756 h 427382"/>
                <a:gd name="connsiteX24" fmla="*/ 417443 w 467139"/>
                <a:gd name="connsiteY24" fmla="*/ 59634 h 427382"/>
                <a:gd name="connsiteX25" fmla="*/ 447261 w 467139"/>
                <a:gd name="connsiteY25" fmla="*/ 49695 h 427382"/>
                <a:gd name="connsiteX26" fmla="*/ 457200 w 467139"/>
                <a:gd name="connsiteY26" fmla="*/ 19878 h 427382"/>
                <a:gd name="connsiteX27" fmla="*/ 467139 w 467139"/>
                <a:gd name="connsiteY27" fmla="*/ 0 h 42738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467139" h="427382">
                  <a:moveTo>
                    <a:pt x="0" y="427382"/>
                  </a:moveTo>
                  <a:cubicBezTo>
                    <a:pt x="3313" y="410817"/>
                    <a:pt x="7965" y="394464"/>
                    <a:pt x="9939" y="377687"/>
                  </a:cubicBezTo>
                  <a:cubicBezTo>
                    <a:pt x="14600" y="338066"/>
                    <a:pt x="14930" y="298003"/>
                    <a:pt x="19878" y="258417"/>
                  </a:cubicBezTo>
                  <a:cubicBezTo>
                    <a:pt x="21572" y="244863"/>
                    <a:pt x="23708" y="230879"/>
                    <a:pt x="29817" y="218661"/>
                  </a:cubicBezTo>
                  <a:cubicBezTo>
                    <a:pt x="34008" y="210279"/>
                    <a:pt x="41899" y="203980"/>
                    <a:pt x="49696" y="198782"/>
                  </a:cubicBezTo>
                  <a:cubicBezTo>
                    <a:pt x="66762" y="187404"/>
                    <a:pt x="98066" y="174266"/>
                    <a:pt x="119269" y="168965"/>
                  </a:cubicBezTo>
                  <a:cubicBezTo>
                    <a:pt x="135658" y="164868"/>
                    <a:pt x="152400" y="162339"/>
                    <a:pt x="168965" y="159026"/>
                  </a:cubicBezTo>
                  <a:cubicBezTo>
                    <a:pt x="228768" y="166501"/>
                    <a:pt x="247302" y="152292"/>
                    <a:pt x="278296" y="198782"/>
                  </a:cubicBezTo>
                  <a:cubicBezTo>
                    <a:pt x="284108" y="207499"/>
                    <a:pt x="284922" y="218661"/>
                    <a:pt x="288235" y="228600"/>
                  </a:cubicBezTo>
                  <a:cubicBezTo>
                    <a:pt x="284922" y="258417"/>
                    <a:pt x="286190" y="289108"/>
                    <a:pt x="278296" y="318052"/>
                  </a:cubicBezTo>
                  <a:cubicBezTo>
                    <a:pt x="269582" y="350001"/>
                    <a:pt x="246541" y="335680"/>
                    <a:pt x="228600" y="327991"/>
                  </a:cubicBezTo>
                  <a:cubicBezTo>
                    <a:pt x="214981" y="322155"/>
                    <a:pt x="202095" y="314739"/>
                    <a:pt x="188843" y="308113"/>
                  </a:cubicBezTo>
                  <a:cubicBezTo>
                    <a:pt x="182217" y="301487"/>
                    <a:pt x="176282" y="294088"/>
                    <a:pt x="168965" y="288234"/>
                  </a:cubicBezTo>
                  <a:cubicBezTo>
                    <a:pt x="159637" y="280772"/>
                    <a:pt x="146610" y="277684"/>
                    <a:pt x="139148" y="268356"/>
                  </a:cubicBezTo>
                  <a:cubicBezTo>
                    <a:pt x="132603" y="260175"/>
                    <a:pt x="132522" y="248478"/>
                    <a:pt x="129209" y="238539"/>
                  </a:cubicBezTo>
                  <a:cubicBezTo>
                    <a:pt x="138043" y="141358"/>
                    <a:pt x="114185" y="145040"/>
                    <a:pt x="168965" y="99391"/>
                  </a:cubicBezTo>
                  <a:cubicBezTo>
                    <a:pt x="178142" y="91744"/>
                    <a:pt x="188844" y="86139"/>
                    <a:pt x="198783" y="79513"/>
                  </a:cubicBezTo>
                  <a:lnTo>
                    <a:pt x="258417" y="89452"/>
                  </a:lnTo>
                  <a:cubicBezTo>
                    <a:pt x="316486" y="252046"/>
                    <a:pt x="272769" y="226759"/>
                    <a:pt x="218661" y="208721"/>
                  </a:cubicBezTo>
                  <a:cubicBezTo>
                    <a:pt x="212035" y="198782"/>
                    <a:pt x="206245" y="188232"/>
                    <a:pt x="198783" y="178904"/>
                  </a:cubicBezTo>
                  <a:cubicBezTo>
                    <a:pt x="192929" y="171587"/>
                    <a:pt x="178904" y="168397"/>
                    <a:pt x="178904" y="159026"/>
                  </a:cubicBezTo>
                  <a:cubicBezTo>
                    <a:pt x="178904" y="109946"/>
                    <a:pt x="178527" y="56447"/>
                    <a:pt x="228600" y="39756"/>
                  </a:cubicBezTo>
                  <a:cubicBezTo>
                    <a:pt x="247718" y="33383"/>
                    <a:pt x="268357" y="33130"/>
                    <a:pt x="288235" y="29817"/>
                  </a:cubicBezTo>
                  <a:cubicBezTo>
                    <a:pt x="311426" y="33130"/>
                    <a:pt x="334982" y="34488"/>
                    <a:pt x="357809" y="39756"/>
                  </a:cubicBezTo>
                  <a:cubicBezTo>
                    <a:pt x="378226" y="44468"/>
                    <a:pt x="417443" y="59634"/>
                    <a:pt x="417443" y="59634"/>
                  </a:cubicBezTo>
                  <a:cubicBezTo>
                    <a:pt x="427382" y="56321"/>
                    <a:pt x="439853" y="57103"/>
                    <a:pt x="447261" y="49695"/>
                  </a:cubicBezTo>
                  <a:cubicBezTo>
                    <a:pt x="454669" y="42287"/>
                    <a:pt x="453309" y="29605"/>
                    <a:pt x="457200" y="19878"/>
                  </a:cubicBezTo>
                  <a:cubicBezTo>
                    <a:pt x="459951" y="13000"/>
                    <a:pt x="463826" y="6626"/>
                    <a:pt x="467139" y="0"/>
                  </a:cubicBezTo>
                </a:path>
              </a:pathLst>
            </a:custGeom>
            <a:noFill/>
            <a:ln w="31750">
              <a:solidFill>
                <a:srgbClr val="CC66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grpSp>
          <p:nvGrpSpPr>
            <p:cNvPr id="237" name="グループ化 236">
              <a:extLst>
                <a:ext uri="{FF2B5EF4-FFF2-40B4-BE49-F238E27FC236}">
                  <a16:creationId xmlns:a16="http://schemas.microsoft.com/office/drawing/2014/main" id="{D6A318FF-EAB2-474E-93E0-C3E3E99FDA76}"/>
                </a:ext>
              </a:extLst>
            </p:cNvPr>
            <p:cNvGrpSpPr>
              <a:grpSpLocks noChangeAspect="1"/>
            </p:cNvGrpSpPr>
            <p:nvPr/>
          </p:nvGrpSpPr>
          <p:grpSpPr>
            <a:xfrm rot="2259212">
              <a:off x="10233133" y="5410997"/>
              <a:ext cx="373706" cy="188725"/>
              <a:chOff x="4597676" y="556450"/>
              <a:chExt cx="830518" cy="419420"/>
            </a:xfrm>
          </p:grpSpPr>
          <p:sp>
            <p:nvSpPr>
              <p:cNvPr id="240" name="フリーフォーム: 図形 239">
                <a:extLst>
                  <a:ext uri="{FF2B5EF4-FFF2-40B4-BE49-F238E27FC236}">
                    <a16:creationId xmlns:a16="http://schemas.microsoft.com/office/drawing/2014/main" id="{71EFCEC8-68D8-4F18-835E-10B628B7081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631635" y="556450"/>
                <a:ext cx="796559" cy="417585"/>
              </a:xfrm>
              <a:custGeom>
                <a:avLst/>
                <a:gdLst>
                  <a:gd name="connsiteX0" fmla="*/ 0 w 1441174"/>
                  <a:gd name="connsiteY0" fmla="*/ 705820 h 755515"/>
                  <a:gd name="connsiteX1" fmla="*/ 367748 w 1441174"/>
                  <a:gd name="connsiteY1" fmla="*/ 141 h 755515"/>
                  <a:gd name="connsiteX2" fmla="*/ 735495 w 1441174"/>
                  <a:gd name="connsiteY2" fmla="*/ 755515 h 755515"/>
                  <a:gd name="connsiteX3" fmla="*/ 1103243 w 1441174"/>
                  <a:gd name="connsiteY3" fmla="*/ 141 h 755515"/>
                  <a:gd name="connsiteX4" fmla="*/ 1441174 w 1441174"/>
                  <a:gd name="connsiteY4" fmla="*/ 745576 h 7555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1174" h="755515">
                    <a:moveTo>
                      <a:pt x="0" y="705820"/>
                    </a:moveTo>
                    <a:cubicBezTo>
                      <a:pt x="122583" y="348839"/>
                      <a:pt x="245166" y="-8141"/>
                      <a:pt x="367748" y="141"/>
                    </a:cubicBezTo>
                    <a:cubicBezTo>
                      <a:pt x="490330" y="8423"/>
                      <a:pt x="612913" y="755515"/>
                      <a:pt x="735495" y="755515"/>
                    </a:cubicBezTo>
                    <a:cubicBezTo>
                      <a:pt x="858077" y="755515"/>
                      <a:pt x="985630" y="1797"/>
                      <a:pt x="1103243" y="141"/>
                    </a:cubicBezTo>
                    <a:cubicBezTo>
                      <a:pt x="1220856" y="-1515"/>
                      <a:pt x="1331015" y="372030"/>
                      <a:pt x="1441174" y="745576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241" name="フリーフォーム: 図形 240">
                <a:extLst>
                  <a:ext uri="{FF2B5EF4-FFF2-40B4-BE49-F238E27FC236}">
                    <a16:creationId xmlns:a16="http://schemas.microsoft.com/office/drawing/2014/main" id="{708F6D0F-7249-4262-B102-D3F069B4A7C6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4597676" y="558285"/>
                <a:ext cx="796560" cy="417585"/>
              </a:xfrm>
              <a:custGeom>
                <a:avLst/>
                <a:gdLst>
                  <a:gd name="connsiteX0" fmla="*/ 0 w 1441174"/>
                  <a:gd name="connsiteY0" fmla="*/ 705820 h 755515"/>
                  <a:gd name="connsiteX1" fmla="*/ 367748 w 1441174"/>
                  <a:gd name="connsiteY1" fmla="*/ 141 h 755515"/>
                  <a:gd name="connsiteX2" fmla="*/ 735495 w 1441174"/>
                  <a:gd name="connsiteY2" fmla="*/ 755515 h 755515"/>
                  <a:gd name="connsiteX3" fmla="*/ 1103243 w 1441174"/>
                  <a:gd name="connsiteY3" fmla="*/ 141 h 755515"/>
                  <a:gd name="connsiteX4" fmla="*/ 1441174 w 1441174"/>
                  <a:gd name="connsiteY4" fmla="*/ 745576 h 7555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441174" h="755515">
                    <a:moveTo>
                      <a:pt x="0" y="705820"/>
                    </a:moveTo>
                    <a:cubicBezTo>
                      <a:pt x="122583" y="348839"/>
                      <a:pt x="245166" y="-8141"/>
                      <a:pt x="367748" y="141"/>
                    </a:cubicBezTo>
                    <a:cubicBezTo>
                      <a:pt x="490330" y="8423"/>
                      <a:pt x="612913" y="755515"/>
                      <a:pt x="735495" y="755515"/>
                    </a:cubicBezTo>
                    <a:cubicBezTo>
                      <a:pt x="858077" y="755515"/>
                      <a:pt x="985630" y="1797"/>
                      <a:pt x="1103243" y="141"/>
                    </a:cubicBezTo>
                    <a:cubicBezTo>
                      <a:pt x="1220856" y="-1515"/>
                      <a:pt x="1331015" y="372030"/>
                      <a:pt x="1441174" y="745576"/>
                    </a:cubicBez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 dirty="0"/>
              </a:p>
            </p:txBody>
          </p:sp>
        </p:grpSp>
        <p:sp>
          <p:nvSpPr>
            <p:cNvPr id="238" name="涙形 237">
              <a:extLst>
                <a:ext uri="{FF2B5EF4-FFF2-40B4-BE49-F238E27FC236}">
                  <a16:creationId xmlns:a16="http://schemas.microsoft.com/office/drawing/2014/main" id="{A4E4D37E-73EB-4159-BABD-95215A4DC756}"/>
                </a:ext>
              </a:extLst>
            </p:cNvPr>
            <p:cNvSpPr/>
            <p:nvPr/>
          </p:nvSpPr>
          <p:spPr>
            <a:xfrm>
              <a:off x="10267534" y="5790606"/>
              <a:ext cx="259979" cy="221931"/>
            </a:xfrm>
            <a:prstGeom prst="teardrop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dirty="0"/>
            </a:p>
          </p:txBody>
        </p:sp>
        <p:sp>
          <p:nvSpPr>
            <p:cNvPr id="239" name="部分円 238">
              <a:extLst>
                <a:ext uri="{FF2B5EF4-FFF2-40B4-BE49-F238E27FC236}">
                  <a16:creationId xmlns:a16="http://schemas.microsoft.com/office/drawing/2014/main" id="{F23A9B3F-93CB-4783-A038-A139F3B86AC5}"/>
                </a:ext>
              </a:extLst>
            </p:cNvPr>
            <p:cNvSpPr/>
            <p:nvPr/>
          </p:nvSpPr>
          <p:spPr>
            <a:xfrm>
              <a:off x="9863557" y="5767600"/>
              <a:ext cx="233456" cy="212741"/>
            </a:xfrm>
            <a:prstGeom prst="pi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solidFill>
                  <a:schemeClr val="tx1"/>
                </a:solidFill>
              </a:endParaRPr>
            </a:p>
          </p:txBody>
        </p:sp>
      </p:grpSp>
      <p:sp>
        <p:nvSpPr>
          <p:cNvPr id="247" name="二等辺三角形 246">
            <a:extLst>
              <a:ext uri="{FF2B5EF4-FFF2-40B4-BE49-F238E27FC236}">
                <a16:creationId xmlns:a16="http://schemas.microsoft.com/office/drawing/2014/main" id="{FD5989A7-454E-42F9-A573-525DD4CA65CB}"/>
              </a:ext>
            </a:extLst>
          </p:cNvPr>
          <p:cNvSpPr/>
          <p:nvPr/>
        </p:nvSpPr>
        <p:spPr>
          <a:xfrm rot="10800000" flipH="1">
            <a:off x="4386774" y="3982039"/>
            <a:ext cx="1440000" cy="216000"/>
          </a:xfrm>
          <a:prstGeom prst="triangl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57" name="二等辺三角形 256">
            <a:extLst>
              <a:ext uri="{FF2B5EF4-FFF2-40B4-BE49-F238E27FC236}">
                <a16:creationId xmlns:a16="http://schemas.microsoft.com/office/drawing/2014/main" id="{90E04235-7093-4AEA-BC8C-EEF3CB49C9A1}"/>
              </a:ext>
            </a:extLst>
          </p:cNvPr>
          <p:cNvSpPr/>
          <p:nvPr/>
        </p:nvSpPr>
        <p:spPr>
          <a:xfrm rot="10800000" flipH="1">
            <a:off x="2709000" y="6048293"/>
            <a:ext cx="1440000" cy="216000"/>
          </a:xfrm>
          <a:prstGeom prst="triangl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 sz="2400"/>
          </a:p>
        </p:txBody>
      </p:sp>
      <p:cxnSp>
        <p:nvCxnSpPr>
          <p:cNvPr id="274" name="直線矢印コネクタ 273">
            <a:extLst>
              <a:ext uri="{FF2B5EF4-FFF2-40B4-BE49-F238E27FC236}">
                <a16:creationId xmlns:a16="http://schemas.microsoft.com/office/drawing/2014/main" id="{0059C897-BDA5-4F45-BE8E-7947CB29176B}"/>
              </a:ext>
            </a:extLst>
          </p:cNvPr>
          <p:cNvCxnSpPr/>
          <p:nvPr/>
        </p:nvCxnSpPr>
        <p:spPr>
          <a:xfrm>
            <a:off x="2694430" y="7658728"/>
            <a:ext cx="286881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矢印コネクタ 150">
            <a:extLst>
              <a:ext uri="{FF2B5EF4-FFF2-40B4-BE49-F238E27FC236}">
                <a16:creationId xmlns:a16="http://schemas.microsoft.com/office/drawing/2014/main" id="{C82269EB-A7B2-4311-B250-18AE624CF74F}"/>
              </a:ext>
            </a:extLst>
          </p:cNvPr>
          <p:cNvCxnSpPr>
            <a:cxnSpLocks/>
          </p:cNvCxnSpPr>
          <p:nvPr/>
        </p:nvCxnSpPr>
        <p:spPr>
          <a:xfrm>
            <a:off x="1751228" y="2166638"/>
            <a:ext cx="0" cy="36000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四角形: 角を丸くする 1">
            <a:extLst>
              <a:ext uri="{FF2B5EF4-FFF2-40B4-BE49-F238E27FC236}">
                <a16:creationId xmlns:a16="http://schemas.microsoft.com/office/drawing/2014/main" id="{47881AFE-76C5-4C39-BD4D-0C2F565A8A66}"/>
              </a:ext>
            </a:extLst>
          </p:cNvPr>
          <p:cNvSpPr/>
          <p:nvPr/>
        </p:nvSpPr>
        <p:spPr>
          <a:xfrm>
            <a:off x="3982592" y="1377328"/>
            <a:ext cx="2674395" cy="933718"/>
          </a:xfrm>
          <a:prstGeom prst="round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0627697C-7406-4864-B4AF-F3BB354A3456}"/>
              </a:ext>
            </a:extLst>
          </p:cNvPr>
          <p:cNvSpPr txBox="1"/>
          <p:nvPr/>
        </p:nvSpPr>
        <p:spPr>
          <a:xfrm>
            <a:off x="3984828" y="1387553"/>
            <a:ext cx="2296334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r>
              <a:rPr lang="en-US" altLang="ja-JP" sz="1200" b="1" dirty="0"/>
              <a:t>Cell-free synthesis (PURE system)</a:t>
            </a:r>
            <a:endParaRPr lang="ja-JP" altLang="en-US" sz="1200" b="1" dirty="0"/>
          </a:p>
        </p:txBody>
      </p:sp>
      <p:pic>
        <p:nvPicPr>
          <p:cNvPr id="254" name="図 253">
            <a:extLst>
              <a:ext uri="{FF2B5EF4-FFF2-40B4-BE49-F238E27FC236}">
                <a16:creationId xmlns:a16="http://schemas.microsoft.com/office/drawing/2014/main" id="{A10DFDD3-9012-4766-9DFE-39F6FAB24A2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5394675" y="5152593"/>
            <a:ext cx="1152004" cy="377170"/>
          </a:xfrm>
          <a:prstGeom prst="rect">
            <a:avLst/>
          </a:prstGeom>
        </p:spPr>
      </p:pic>
      <p:sp>
        <p:nvSpPr>
          <p:cNvPr id="255" name="楕円 254">
            <a:extLst>
              <a:ext uri="{FF2B5EF4-FFF2-40B4-BE49-F238E27FC236}">
                <a16:creationId xmlns:a16="http://schemas.microsoft.com/office/drawing/2014/main" id="{64FEC75E-679D-4AAF-A4CA-F4AB10105089}"/>
              </a:ext>
            </a:extLst>
          </p:cNvPr>
          <p:cNvSpPr/>
          <p:nvPr/>
        </p:nvSpPr>
        <p:spPr>
          <a:xfrm>
            <a:off x="6427809" y="5314414"/>
            <a:ext cx="120193" cy="111739"/>
          </a:xfrm>
          <a:prstGeom prst="ellipse">
            <a:avLst/>
          </a:prstGeom>
          <a:solidFill>
            <a:srgbClr val="00B0F0"/>
          </a:solidFill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58" name="図 257">
            <a:extLst>
              <a:ext uri="{FF2B5EF4-FFF2-40B4-BE49-F238E27FC236}">
                <a16:creationId xmlns:a16="http://schemas.microsoft.com/office/drawing/2014/main" id="{C59A0B2B-8493-435D-AC12-840ED1406B47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1182363" y="4979818"/>
            <a:ext cx="534263" cy="257161"/>
          </a:xfrm>
          <a:prstGeom prst="rect">
            <a:avLst/>
          </a:prstGeom>
        </p:spPr>
      </p:pic>
      <p:pic>
        <p:nvPicPr>
          <p:cNvPr id="262" name="図 261">
            <a:extLst>
              <a:ext uri="{FF2B5EF4-FFF2-40B4-BE49-F238E27FC236}">
                <a16:creationId xmlns:a16="http://schemas.microsoft.com/office/drawing/2014/main" id="{119A6A00-0872-4740-A06A-6AAAFECE09C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1445834" y="5202135"/>
            <a:ext cx="1152004" cy="377170"/>
          </a:xfrm>
          <a:prstGeom prst="rect">
            <a:avLst/>
          </a:prstGeom>
        </p:spPr>
      </p:pic>
      <p:pic>
        <p:nvPicPr>
          <p:cNvPr id="263" name="図 262">
            <a:extLst>
              <a:ext uri="{FF2B5EF4-FFF2-40B4-BE49-F238E27FC236}">
                <a16:creationId xmlns:a16="http://schemas.microsoft.com/office/drawing/2014/main" id="{21D46150-DCE0-439E-A54B-8EC854C0CE86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98490" y="4644465"/>
            <a:ext cx="932575" cy="31839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8FDCA57-0BB7-4C9F-B523-75381F2252C3}"/>
              </a:ext>
            </a:extLst>
          </p:cNvPr>
          <p:cNvSpPr txBox="1"/>
          <p:nvPr/>
        </p:nvSpPr>
        <p:spPr>
          <a:xfrm>
            <a:off x="1712239" y="5571317"/>
            <a:ext cx="886781" cy="261610"/>
          </a:xfrm>
          <a:prstGeom prst="rect">
            <a:avLst/>
          </a:prstGeom>
          <a:noFill/>
          <a:ln w="19050">
            <a:solidFill>
              <a:schemeClr val="accent6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Endogenous</a:t>
            </a:r>
            <a:endParaRPr kumimoji="1" lang="ja-JP" altLang="en-US" sz="1100" dirty="0"/>
          </a:p>
        </p:txBody>
      </p:sp>
      <p:sp>
        <p:nvSpPr>
          <p:cNvPr id="269" name="テキスト ボックス 268">
            <a:extLst>
              <a:ext uri="{FF2B5EF4-FFF2-40B4-BE49-F238E27FC236}">
                <a16:creationId xmlns:a16="http://schemas.microsoft.com/office/drawing/2014/main" id="{146E2325-939A-4C4D-A98B-2FD2385D49CD}"/>
              </a:ext>
            </a:extLst>
          </p:cNvPr>
          <p:cNvSpPr txBox="1"/>
          <p:nvPr/>
        </p:nvSpPr>
        <p:spPr>
          <a:xfrm>
            <a:off x="5407990" y="5571317"/>
            <a:ext cx="1181734" cy="2616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Internal Standard</a:t>
            </a:r>
            <a:endParaRPr kumimoji="1" lang="ja-JP" altLang="en-US" sz="1100" dirty="0"/>
          </a:p>
        </p:txBody>
      </p: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7B54739F-A299-4C4F-8643-0B97E666D4A5}"/>
              </a:ext>
            </a:extLst>
          </p:cNvPr>
          <p:cNvSpPr txBox="1"/>
          <p:nvPr/>
        </p:nvSpPr>
        <p:spPr>
          <a:xfrm>
            <a:off x="2980664" y="6342663"/>
            <a:ext cx="880690" cy="338554"/>
          </a:xfrm>
          <a:prstGeom prst="rect">
            <a:avLst/>
          </a:prstGeom>
          <a:solidFill>
            <a:schemeClr val="bg1"/>
          </a:solidFill>
          <a:ln w="38100">
            <a:solidFill>
              <a:schemeClr val="tx1"/>
            </a:solidFill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600" b="1" dirty="0"/>
              <a:t>Analysis</a:t>
            </a:r>
            <a:endParaRPr lang="ja-JP" altLang="en-US" sz="1600" b="1" dirty="0"/>
          </a:p>
        </p:txBody>
      </p:sp>
      <p:sp>
        <p:nvSpPr>
          <p:cNvPr id="277" name="四角形: 角を丸くする 276">
            <a:extLst>
              <a:ext uri="{FF2B5EF4-FFF2-40B4-BE49-F238E27FC236}">
                <a16:creationId xmlns:a16="http://schemas.microsoft.com/office/drawing/2014/main" id="{7F6CEB14-34BC-4CB9-977D-F2B43F49A654}"/>
              </a:ext>
            </a:extLst>
          </p:cNvPr>
          <p:cNvSpPr/>
          <p:nvPr/>
        </p:nvSpPr>
        <p:spPr>
          <a:xfrm>
            <a:off x="313522" y="6991749"/>
            <a:ext cx="2316238" cy="1531645"/>
          </a:xfrm>
          <a:prstGeom prst="round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AF693D27-1956-4667-AA85-987FA8078CE5}"/>
              </a:ext>
            </a:extLst>
          </p:cNvPr>
          <p:cNvSpPr txBox="1"/>
          <p:nvPr/>
        </p:nvSpPr>
        <p:spPr>
          <a:xfrm rot="16200000">
            <a:off x="2870404" y="7612496"/>
            <a:ext cx="638315" cy="246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Intensity</a:t>
            </a:r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4DCC389A-D693-4B63-A1CC-5C977B9F7256}"/>
              </a:ext>
            </a:extLst>
          </p:cNvPr>
          <p:cNvSpPr txBox="1"/>
          <p:nvPr/>
        </p:nvSpPr>
        <p:spPr>
          <a:xfrm>
            <a:off x="4392202" y="7020496"/>
            <a:ext cx="825868" cy="246221"/>
          </a:xfrm>
          <a:prstGeom prst="rect">
            <a:avLst/>
          </a:prstGeom>
          <a:solidFill>
            <a:schemeClr val="bg1"/>
          </a:solidFill>
          <a:ln w="19050">
            <a:solidFill>
              <a:schemeClr val="accent6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Endogenous</a:t>
            </a:r>
            <a:endParaRPr kumimoji="1" lang="ja-JP" altLang="en-US" sz="1000" dirty="0"/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8D68A285-0F22-4A48-8B7D-F6F5AF49F265}"/>
              </a:ext>
            </a:extLst>
          </p:cNvPr>
          <p:cNvSpPr txBox="1"/>
          <p:nvPr/>
        </p:nvSpPr>
        <p:spPr>
          <a:xfrm>
            <a:off x="4392202" y="7848240"/>
            <a:ext cx="1093569" cy="246221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Internal Standard</a:t>
            </a:r>
            <a:endParaRPr kumimoji="1" lang="ja-JP" altLang="en-US" sz="1000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F895CE2-28D2-45F8-8F0D-2ADD9FF5A85B}"/>
              </a:ext>
            </a:extLst>
          </p:cNvPr>
          <p:cNvSpPr txBox="1"/>
          <p:nvPr/>
        </p:nvSpPr>
        <p:spPr>
          <a:xfrm>
            <a:off x="953711" y="6859920"/>
            <a:ext cx="1035861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1200" b="1" u="sng" dirty="0">
                <a:solidFill>
                  <a:schemeClr val="tx1"/>
                </a:solidFill>
              </a:rPr>
              <a:t>Fractionation</a:t>
            </a:r>
            <a:endParaRPr lang="ja-JP" altLang="en-US" sz="1200" b="1" u="sng" dirty="0">
              <a:solidFill>
                <a:schemeClr val="tx1"/>
              </a:solidFill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E3B33387-0C4C-4CD3-85FD-78EB0E8F45F4}"/>
              </a:ext>
            </a:extLst>
          </p:cNvPr>
          <p:cNvSpPr txBox="1"/>
          <p:nvPr/>
        </p:nvSpPr>
        <p:spPr>
          <a:xfrm>
            <a:off x="62970" y="107242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/>
              <a:t>Supplementary F</a:t>
            </a:r>
            <a:r>
              <a:rPr lang="ja-JP" altLang="en-US" sz="1800" b="1" dirty="0"/>
              <a:t>ig. </a:t>
            </a:r>
            <a:r>
              <a:rPr lang="en-US" altLang="ja-JP" b="1" dirty="0"/>
              <a:t>2</a:t>
            </a:r>
            <a:endParaRPr kumimoji="1" lang="ja-JP" altLang="en-US" b="1" dirty="0"/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FDBD0309-01DC-468E-BB35-9C2331B0E370}"/>
              </a:ext>
            </a:extLst>
          </p:cNvPr>
          <p:cNvSpPr txBox="1"/>
          <p:nvPr/>
        </p:nvSpPr>
        <p:spPr>
          <a:xfrm>
            <a:off x="3538040" y="8645606"/>
            <a:ext cx="966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/>
              <a:t>Retention time</a:t>
            </a:r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31375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0</TotalTime>
  <Words>154</Words>
  <Application>Microsoft Office PowerPoint</Application>
  <PresentationFormat>A4 210 x 297 mm</PresentationFormat>
  <Paragraphs>5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鳴海 良平</dc:creator>
  <cp:lastModifiedBy>笠原　桂子</cp:lastModifiedBy>
  <cp:revision>136</cp:revision>
  <dcterms:created xsi:type="dcterms:W3CDTF">2020-12-17T08:55:34Z</dcterms:created>
  <dcterms:modified xsi:type="dcterms:W3CDTF">2022-04-26T04:30:29Z</dcterms:modified>
</cp:coreProperties>
</file>